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48" r:id="rId1"/>
  </p:sldMasterIdLst>
  <p:sldIdLst>
    <p:sldId id="257" r:id="rId2"/>
    <p:sldId id="264" r:id="rId3"/>
    <p:sldId id="262" r:id="rId4"/>
    <p:sldId id="266" r:id="rId5"/>
  </p:sldIdLst>
  <p:sldSz cx="6858000" cy="9144000" type="screen4x3"/>
  <p:notesSz cx="6858000" cy="9144000"/>
  <p:defaultTex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4381" autoAdjust="0"/>
    <p:restoredTop sz="94671" autoAdjust="0"/>
  </p:normalViewPr>
  <p:slideViewPr>
    <p:cSldViewPr>
      <p:cViewPr>
        <p:scale>
          <a:sx n="80" d="100"/>
          <a:sy n="80" d="100"/>
        </p:scale>
        <p:origin x="-708" y="360"/>
      </p:cViewPr>
      <p:guideLst>
        <p:guide orient="horz" pos="288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rivkab\Downloads\ims_data%20(2).csv" TargetMode="External"/></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Worksheet2.xlsx"/></Relationships>
</file>

<file path=ppt/charts/_rels/chart4.xml.rels><?xml version="1.0" encoding="UTF-8" standalone="yes"?>
<Relationships xmlns="http://schemas.openxmlformats.org/package/2006/relationships"><Relationship Id="rId1" Type="http://schemas.openxmlformats.org/officeDocument/2006/relationships/package" Target="../embeddings/Microsoft_Excel_Worksheet3.xlsx"/></Relationships>
</file>

<file path=ppt/charts/_rels/chart5.xml.rels><?xml version="1.0" encoding="UTF-8" standalone="yes"?>
<Relationships xmlns="http://schemas.openxmlformats.org/package/2006/relationships"><Relationship Id="rId1" Type="http://schemas.openxmlformats.org/officeDocument/2006/relationships/oleObject" Target="file:///C:\Users\rivkab\Downloads\ims_data%20(1).csv" TargetMode="External"/></Relationships>
</file>

<file path=ppt/charts/_rels/chart6.xml.rels><?xml version="1.0" encoding="UTF-8" standalone="yes"?>
<Relationships xmlns="http://schemas.openxmlformats.org/package/2006/relationships"><Relationship Id="rId1" Type="http://schemas.openxmlformats.org/officeDocument/2006/relationships/package" Target="../embeddings/Microsoft_Excel_Worksheet4.xlsx"/></Relationships>
</file>

<file path=ppt/charts/_rels/chart7.xml.rels><?xml version="1.0" encoding="UTF-8" standalone="yes"?>
<Relationships xmlns="http://schemas.openxmlformats.org/package/2006/relationships"><Relationship Id="rId1" Type="http://schemas.openxmlformats.org/officeDocument/2006/relationships/package" Target="../embeddings/Microsoft_Excel_Worksheet5.xlsx"/></Relationships>
</file>

<file path=ppt/charts/_rels/chart8.xml.rels><?xml version="1.0" encoding="UTF-8" standalone="yes"?>
<Relationships xmlns="http://schemas.openxmlformats.org/package/2006/relationships"><Relationship Id="rId1" Type="http://schemas.openxmlformats.org/officeDocument/2006/relationships/package" Target="../embeddings/Microsoft_Excel_Worksheet6.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strRef>
              <c:f>'ims_data (2)'!$D$1</c:f>
              <c:strCache>
                <c:ptCount val="1"/>
                <c:pt idx="0">
                  <c:v>Day min</c:v>
                </c:pt>
              </c:strCache>
            </c:strRef>
          </c:tx>
          <c:spPr>
            <a:ln w="12700"/>
          </c:spPr>
          <c:marker>
            <c:symbol val="diamond"/>
            <c:size val="2"/>
          </c:marker>
          <c:cat>
            <c:numRef>
              <c:f>'ims_data (2)'!$C$2:$C$63</c:f>
              <c:numCache>
                <c:formatCode>m/d/yyyy</c:formatCode>
                <c:ptCount val="62"/>
                <c:pt idx="0">
                  <c:v>40360</c:v>
                </c:pt>
                <c:pt idx="1">
                  <c:v>40361</c:v>
                </c:pt>
                <c:pt idx="2">
                  <c:v>40362</c:v>
                </c:pt>
                <c:pt idx="3">
                  <c:v>40363</c:v>
                </c:pt>
                <c:pt idx="4">
                  <c:v>40364</c:v>
                </c:pt>
                <c:pt idx="5">
                  <c:v>40365</c:v>
                </c:pt>
                <c:pt idx="6">
                  <c:v>40366</c:v>
                </c:pt>
                <c:pt idx="7">
                  <c:v>40367</c:v>
                </c:pt>
                <c:pt idx="8">
                  <c:v>40368</c:v>
                </c:pt>
                <c:pt idx="9">
                  <c:v>40369</c:v>
                </c:pt>
                <c:pt idx="10">
                  <c:v>40370</c:v>
                </c:pt>
                <c:pt idx="11">
                  <c:v>40371</c:v>
                </c:pt>
                <c:pt idx="12">
                  <c:v>40372</c:v>
                </c:pt>
                <c:pt idx="13">
                  <c:v>40373</c:v>
                </c:pt>
                <c:pt idx="14">
                  <c:v>40374</c:v>
                </c:pt>
                <c:pt idx="15">
                  <c:v>40375</c:v>
                </c:pt>
                <c:pt idx="16">
                  <c:v>40376</c:v>
                </c:pt>
                <c:pt idx="17">
                  <c:v>40377</c:v>
                </c:pt>
                <c:pt idx="18">
                  <c:v>40378</c:v>
                </c:pt>
                <c:pt idx="19">
                  <c:v>40379</c:v>
                </c:pt>
                <c:pt idx="20">
                  <c:v>40380</c:v>
                </c:pt>
                <c:pt idx="21">
                  <c:v>40381</c:v>
                </c:pt>
                <c:pt idx="22">
                  <c:v>40382</c:v>
                </c:pt>
                <c:pt idx="23">
                  <c:v>40383</c:v>
                </c:pt>
                <c:pt idx="24">
                  <c:v>40384</c:v>
                </c:pt>
                <c:pt idx="25">
                  <c:v>40385</c:v>
                </c:pt>
                <c:pt idx="26">
                  <c:v>40386</c:v>
                </c:pt>
                <c:pt idx="27">
                  <c:v>40387</c:v>
                </c:pt>
                <c:pt idx="28">
                  <c:v>40388</c:v>
                </c:pt>
                <c:pt idx="29">
                  <c:v>40389</c:v>
                </c:pt>
                <c:pt idx="30">
                  <c:v>40390</c:v>
                </c:pt>
                <c:pt idx="31">
                  <c:v>40391</c:v>
                </c:pt>
                <c:pt idx="32">
                  <c:v>40392</c:v>
                </c:pt>
                <c:pt idx="33">
                  <c:v>40393</c:v>
                </c:pt>
                <c:pt idx="34">
                  <c:v>40394</c:v>
                </c:pt>
                <c:pt idx="35">
                  <c:v>40395</c:v>
                </c:pt>
                <c:pt idx="36">
                  <c:v>40396</c:v>
                </c:pt>
                <c:pt idx="37">
                  <c:v>40397</c:v>
                </c:pt>
                <c:pt idx="38">
                  <c:v>40398</c:v>
                </c:pt>
                <c:pt idx="39">
                  <c:v>40399</c:v>
                </c:pt>
                <c:pt idx="40">
                  <c:v>40400</c:v>
                </c:pt>
                <c:pt idx="41">
                  <c:v>40401</c:v>
                </c:pt>
                <c:pt idx="42">
                  <c:v>40402</c:v>
                </c:pt>
                <c:pt idx="43">
                  <c:v>40403</c:v>
                </c:pt>
                <c:pt idx="44">
                  <c:v>40404</c:v>
                </c:pt>
                <c:pt idx="45">
                  <c:v>40405</c:v>
                </c:pt>
                <c:pt idx="46">
                  <c:v>40406</c:v>
                </c:pt>
                <c:pt idx="47">
                  <c:v>40407</c:v>
                </c:pt>
                <c:pt idx="48">
                  <c:v>40408</c:v>
                </c:pt>
                <c:pt idx="49">
                  <c:v>40409</c:v>
                </c:pt>
                <c:pt idx="50">
                  <c:v>40410</c:v>
                </c:pt>
                <c:pt idx="51">
                  <c:v>40411</c:v>
                </c:pt>
                <c:pt idx="52">
                  <c:v>40412</c:v>
                </c:pt>
                <c:pt idx="53">
                  <c:v>40413</c:v>
                </c:pt>
                <c:pt idx="54">
                  <c:v>40414</c:v>
                </c:pt>
                <c:pt idx="55">
                  <c:v>40415</c:v>
                </c:pt>
                <c:pt idx="56">
                  <c:v>40416</c:v>
                </c:pt>
                <c:pt idx="57">
                  <c:v>40417</c:v>
                </c:pt>
                <c:pt idx="58">
                  <c:v>40418</c:v>
                </c:pt>
                <c:pt idx="59">
                  <c:v>40419</c:v>
                </c:pt>
                <c:pt idx="60">
                  <c:v>40420</c:v>
                </c:pt>
                <c:pt idx="61">
                  <c:v>40421</c:v>
                </c:pt>
              </c:numCache>
            </c:numRef>
          </c:cat>
          <c:val>
            <c:numRef>
              <c:f>'ims_data (2)'!$D$2:$D$63</c:f>
              <c:numCache>
                <c:formatCode>General</c:formatCode>
                <c:ptCount val="62"/>
                <c:pt idx="0">
                  <c:v>21.3</c:v>
                </c:pt>
                <c:pt idx="1">
                  <c:v>21.8</c:v>
                </c:pt>
                <c:pt idx="2">
                  <c:v>21.4</c:v>
                </c:pt>
                <c:pt idx="3">
                  <c:v>22.3</c:v>
                </c:pt>
                <c:pt idx="4">
                  <c:v>22.7</c:v>
                </c:pt>
                <c:pt idx="5">
                  <c:v>21.9</c:v>
                </c:pt>
                <c:pt idx="6">
                  <c:v>20.2</c:v>
                </c:pt>
                <c:pt idx="7">
                  <c:v>22.5</c:v>
                </c:pt>
                <c:pt idx="8">
                  <c:v>21.6</c:v>
                </c:pt>
                <c:pt idx="9">
                  <c:v>24</c:v>
                </c:pt>
                <c:pt idx="10">
                  <c:v>25.1</c:v>
                </c:pt>
                <c:pt idx="11">
                  <c:v>25.6</c:v>
                </c:pt>
                <c:pt idx="12">
                  <c:v>23.2</c:v>
                </c:pt>
                <c:pt idx="13">
                  <c:v>22.9</c:v>
                </c:pt>
                <c:pt idx="14">
                  <c:v>24.3</c:v>
                </c:pt>
                <c:pt idx="15">
                  <c:v>23.7</c:v>
                </c:pt>
                <c:pt idx="16">
                  <c:v>22.9</c:v>
                </c:pt>
                <c:pt idx="17">
                  <c:v>23.7</c:v>
                </c:pt>
                <c:pt idx="18">
                  <c:v>23.9</c:v>
                </c:pt>
                <c:pt idx="19">
                  <c:v>23.5</c:v>
                </c:pt>
                <c:pt idx="20">
                  <c:v>23.3</c:v>
                </c:pt>
                <c:pt idx="21">
                  <c:v>23.4</c:v>
                </c:pt>
                <c:pt idx="22">
                  <c:v>23.8</c:v>
                </c:pt>
                <c:pt idx="23">
                  <c:v>24.6</c:v>
                </c:pt>
                <c:pt idx="24">
                  <c:v>23.9</c:v>
                </c:pt>
                <c:pt idx="25">
                  <c:v>24.3</c:v>
                </c:pt>
                <c:pt idx="26">
                  <c:v>22.5</c:v>
                </c:pt>
                <c:pt idx="27">
                  <c:v>25.9</c:v>
                </c:pt>
                <c:pt idx="28">
                  <c:v>24.2</c:v>
                </c:pt>
                <c:pt idx="29">
                  <c:v>23.3</c:v>
                </c:pt>
                <c:pt idx="30">
                  <c:v>27.9</c:v>
                </c:pt>
                <c:pt idx="31">
                  <c:v>27.1</c:v>
                </c:pt>
                <c:pt idx="32">
                  <c:v>27.4</c:v>
                </c:pt>
                <c:pt idx="33">
                  <c:v>26.7</c:v>
                </c:pt>
                <c:pt idx="34">
                  <c:v>25.9</c:v>
                </c:pt>
                <c:pt idx="35">
                  <c:v>24</c:v>
                </c:pt>
                <c:pt idx="36">
                  <c:v>21.7</c:v>
                </c:pt>
                <c:pt idx="37">
                  <c:v>24</c:v>
                </c:pt>
                <c:pt idx="38">
                  <c:v>26.1</c:v>
                </c:pt>
                <c:pt idx="39">
                  <c:v>24.8</c:v>
                </c:pt>
                <c:pt idx="40">
                  <c:v>23.8</c:v>
                </c:pt>
                <c:pt idx="41">
                  <c:v>24.3</c:v>
                </c:pt>
                <c:pt idx="42">
                  <c:v>25.2</c:v>
                </c:pt>
                <c:pt idx="43">
                  <c:v>24</c:v>
                </c:pt>
                <c:pt idx="44">
                  <c:v>25.1</c:v>
                </c:pt>
                <c:pt idx="45">
                  <c:v>26.2</c:v>
                </c:pt>
                <c:pt idx="46">
                  <c:v>25.9</c:v>
                </c:pt>
                <c:pt idx="47">
                  <c:v>25.7</c:v>
                </c:pt>
                <c:pt idx="48">
                  <c:v>25.3</c:v>
                </c:pt>
                <c:pt idx="49">
                  <c:v>24.8</c:v>
                </c:pt>
                <c:pt idx="50">
                  <c:v>26.3</c:v>
                </c:pt>
                <c:pt idx="51">
                  <c:v>26.1</c:v>
                </c:pt>
                <c:pt idx="52">
                  <c:v>25.3</c:v>
                </c:pt>
                <c:pt idx="53">
                  <c:v>25</c:v>
                </c:pt>
                <c:pt idx="54">
                  <c:v>25.3</c:v>
                </c:pt>
                <c:pt idx="55">
                  <c:v>26.2</c:v>
                </c:pt>
                <c:pt idx="56">
                  <c:v>25</c:v>
                </c:pt>
                <c:pt idx="57">
                  <c:v>24.5</c:v>
                </c:pt>
                <c:pt idx="58">
                  <c:v>25.4</c:v>
                </c:pt>
                <c:pt idx="59">
                  <c:v>24.2</c:v>
                </c:pt>
                <c:pt idx="60">
                  <c:v>24.6</c:v>
                </c:pt>
                <c:pt idx="61">
                  <c:v>24.6</c:v>
                </c:pt>
              </c:numCache>
            </c:numRef>
          </c:val>
          <c:smooth val="0"/>
        </c:ser>
        <c:ser>
          <c:idx val="1"/>
          <c:order val="1"/>
          <c:tx>
            <c:strRef>
              <c:f>'ims_data (2)'!$E$1</c:f>
              <c:strCache>
                <c:ptCount val="1"/>
                <c:pt idx="0">
                  <c:v>Day max</c:v>
                </c:pt>
              </c:strCache>
            </c:strRef>
          </c:tx>
          <c:spPr>
            <a:ln w="12700"/>
          </c:spPr>
          <c:marker>
            <c:symbol val="square"/>
            <c:size val="2"/>
          </c:marker>
          <c:cat>
            <c:numRef>
              <c:f>'ims_data (2)'!$C$2:$C$63</c:f>
              <c:numCache>
                <c:formatCode>m/d/yyyy</c:formatCode>
                <c:ptCount val="62"/>
                <c:pt idx="0">
                  <c:v>40360</c:v>
                </c:pt>
                <c:pt idx="1">
                  <c:v>40361</c:v>
                </c:pt>
                <c:pt idx="2">
                  <c:v>40362</c:v>
                </c:pt>
                <c:pt idx="3">
                  <c:v>40363</c:v>
                </c:pt>
                <c:pt idx="4">
                  <c:v>40364</c:v>
                </c:pt>
                <c:pt idx="5">
                  <c:v>40365</c:v>
                </c:pt>
                <c:pt idx="6">
                  <c:v>40366</c:v>
                </c:pt>
                <c:pt idx="7">
                  <c:v>40367</c:v>
                </c:pt>
                <c:pt idx="8">
                  <c:v>40368</c:v>
                </c:pt>
                <c:pt idx="9">
                  <c:v>40369</c:v>
                </c:pt>
                <c:pt idx="10">
                  <c:v>40370</c:v>
                </c:pt>
                <c:pt idx="11">
                  <c:v>40371</c:v>
                </c:pt>
                <c:pt idx="12">
                  <c:v>40372</c:v>
                </c:pt>
                <c:pt idx="13">
                  <c:v>40373</c:v>
                </c:pt>
                <c:pt idx="14">
                  <c:v>40374</c:v>
                </c:pt>
                <c:pt idx="15">
                  <c:v>40375</c:v>
                </c:pt>
                <c:pt idx="16">
                  <c:v>40376</c:v>
                </c:pt>
                <c:pt idx="17">
                  <c:v>40377</c:v>
                </c:pt>
                <c:pt idx="18">
                  <c:v>40378</c:v>
                </c:pt>
                <c:pt idx="19">
                  <c:v>40379</c:v>
                </c:pt>
                <c:pt idx="20">
                  <c:v>40380</c:v>
                </c:pt>
                <c:pt idx="21">
                  <c:v>40381</c:v>
                </c:pt>
                <c:pt idx="22">
                  <c:v>40382</c:v>
                </c:pt>
                <c:pt idx="23">
                  <c:v>40383</c:v>
                </c:pt>
                <c:pt idx="24">
                  <c:v>40384</c:v>
                </c:pt>
                <c:pt idx="25">
                  <c:v>40385</c:v>
                </c:pt>
                <c:pt idx="26">
                  <c:v>40386</c:v>
                </c:pt>
                <c:pt idx="27">
                  <c:v>40387</c:v>
                </c:pt>
                <c:pt idx="28">
                  <c:v>40388</c:v>
                </c:pt>
                <c:pt idx="29">
                  <c:v>40389</c:v>
                </c:pt>
                <c:pt idx="30">
                  <c:v>40390</c:v>
                </c:pt>
                <c:pt idx="31">
                  <c:v>40391</c:v>
                </c:pt>
                <c:pt idx="32">
                  <c:v>40392</c:v>
                </c:pt>
                <c:pt idx="33">
                  <c:v>40393</c:v>
                </c:pt>
                <c:pt idx="34">
                  <c:v>40394</c:v>
                </c:pt>
                <c:pt idx="35">
                  <c:v>40395</c:v>
                </c:pt>
                <c:pt idx="36">
                  <c:v>40396</c:v>
                </c:pt>
                <c:pt idx="37">
                  <c:v>40397</c:v>
                </c:pt>
                <c:pt idx="38">
                  <c:v>40398</c:v>
                </c:pt>
                <c:pt idx="39">
                  <c:v>40399</c:v>
                </c:pt>
                <c:pt idx="40">
                  <c:v>40400</c:v>
                </c:pt>
                <c:pt idx="41">
                  <c:v>40401</c:v>
                </c:pt>
                <c:pt idx="42">
                  <c:v>40402</c:v>
                </c:pt>
                <c:pt idx="43">
                  <c:v>40403</c:v>
                </c:pt>
                <c:pt idx="44">
                  <c:v>40404</c:v>
                </c:pt>
                <c:pt idx="45">
                  <c:v>40405</c:v>
                </c:pt>
                <c:pt idx="46">
                  <c:v>40406</c:v>
                </c:pt>
                <c:pt idx="47">
                  <c:v>40407</c:v>
                </c:pt>
                <c:pt idx="48">
                  <c:v>40408</c:v>
                </c:pt>
                <c:pt idx="49">
                  <c:v>40409</c:v>
                </c:pt>
                <c:pt idx="50">
                  <c:v>40410</c:v>
                </c:pt>
                <c:pt idx="51">
                  <c:v>40411</c:v>
                </c:pt>
                <c:pt idx="52">
                  <c:v>40412</c:v>
                </c:pt>
                <c:pt idx="53">
                  <c:v>40413</c:v>
                </c:pt>
                <c:pt idx="54">
                  <c:v>40414</c:v>
                </c:pt>
                <c:pt idx="55">
                  <c:v>40415</c:v>
                </c:pt>
                <c:pt idx="56">
                  <c:v>40416</c:v>
                </c:pt>
                <c:pt idx="57">
                  <c:v>40417</c:v>
                </c:pt>
                <c:pt idx="58">
                  <c:v>40418</c:v>
                </c:pt>
                <c:pt idx="59">
                  <c:v>40419</c:v>
                </c:pt>
                <c:pt idx="60">
                  <c:v>40420</c:v>
                </c:pt>
                <c:pt idx="61">
                  <c:v>40421</c:v>
                </c:pt>
              </c:numCache>
            </c:numRef>
          </c:cat>
          <c:val>
            <c:numRef>
              <c:f>'ims_data (2)'!$E$2:$E$63</c:f>
              <c:numCache>
                <c:formatCode>General</c:formatCode>
                <c:ptCount val="62"/>
                <c:pt idx="0">
                  <c:v>29</c:v>
                </c:pt>
                <c:pt idx="1">
                  <c:v>29.1</c:v>
                </c:pt>
                <c:pt idx="2">
                  <c:v>29.4</c:v>
                </c:pt>
                <c:pt idx="3">
                  <c:v>30.3</c:v>
                </c:pt>
                <c:pt idx="4">
                  <c:v>31</c:v>
                </c:pt>
                <c:pt idx="5">
                  <c:v>31.2</c:v>
                </c:pt>
                <c:pt idx="6">
                  <c:v>30.1</c:v>
                </c:pt>
                <c:pt idx="7">
                  <c:v>30.7</c:v>
                </c:pt>
                <c:pt idx="8">
                  <c:v>30.4</c:v>
                </c:pt>
                <c:pt idx="9">
                  <c:v>30.3</c:v>
                </c:pt>
                <c:pt idx="10">
                  <c:v>29.8</c:v>
                </c:pt>
                <c:pt idx="11">
                  <c:v>30.7</c:v>
                </c:pt>
                <c:pt idx="12">
                  <c:v>30.8</c:v>
                </c:pt>
                <c:pt idx="13">
                  <c:v>31.2</c:v>
                </c:pt>
                <c:pt idx="14">
                  <c:v>31.3</c:v>
                </c:pt>
                <c:pt idx="15">
                  <c:v>32.799999999999997</c:v>
                </c:pt>
                <c:pt idx="16">
                  <c:v>31.6</c:v>
                </c:pt>
                <c:pt idx="17">
                  <c:v>31.2</c:v>
                </c:pt>
                <c:pt idx="18">
                  <c:v>31.2</c:v>
                </c:pt>
                <c:pt idx="19">
                  <c:v>30.9</c:v>
                </c:pt>
                <c:pt idx="20">
                  <c:v>30.8</c:v>
                </c:pt>
                <c:pt idx="21">
                  <c:v>31.5</c:v>
                </c:pt>
                <c:pt idx="22">
                  <c:v>31.7</c:v>
                </c:pt>
                <c:pt idx="23">
                  <c:v>31.9</c:v>
                </c:pt>
                <c:pt idx="24">
                  <c:v>32.700000000000003</c:v>
                </c:pt>
                <c:pt idx="25">
                  <c:v>33.700000000000003</c:v>
                </c:pt>
                <c:pt idx="26">
                  <c:v>32.6</c:v>
                </c:pt>
                <c:pt idx="27">
                  <c:v>30.8</c:v>
                </c:pt>
                <c:pt idx="28">
                  <c:v>31.2</c:v>
                </c:pt>
                <c:pt idx="29">
                  <c:v>31</c:v>
                </c:pt>
                <c:pt idx="30">
                  <c:v>32.9</c:v>
                </c:pt>
                <c:pt idx="31">
                  <c:v>34.200000000000003</c:v>
                </c:pt>
                <c:pt idx="32">
                  <c:v>32.700000000000003</c:v>
                </c:pt>
                <c:pt idx="33">
                  <c:v>32.200000000000003</c:v>
                </c:pt>
                <c:pt idx="34">
                  <c:v>32.200000000000003</c:v>
                </c:pt>
                <c:pt idx="35">
                  <c:v>35.1</c:v>
                </c:pt>
                <c:pt idx="36">
                  <c:v>36.200000000000003</c:v>
                </c:pt>
                <c:pt idx="37">
                  <c:v>33.6</c:v>
                </c:pt>
                <c:pt idx="38">
                  <c:v>32.1</c:v>
                </c:pt>
                <c:pt idx="39">
                  <c:v>31.9</c:v>
                </c:pt>
                <c:pt idx="40">
                  <c:v>31.6</c:v>
                </c:pt>
                <c:pt idx="41">
                  <c:v>32.200000000000003</c:v>
                </c:pt>
                <c:pt idx="42">
                  <c:v>33</c:v>
                </c:pt>
                <c:pt idx="43">
                  <c:v>32.299999999999997</c:v>
                </c:pt>
                <c:pt idx="44">
                  <c:v>32.5</c:v>
                </c:pt>
                <c:pt idx="45">
                  <c:v>32.6</c:v>
                </c:pt>
                <c:pt idx="46">
                  <c:v>33.200000000000003</c:v>
                </c:pt>
                <c:pt idx="47">
                  <c:v>33.799999999999997</c:v>
                </c:pt>
                <c:pt idx="48">
                  <c:v>34.1</c:v>
                </c:pt>
                <c:pt idx="49">
                  <c:v>34.4</c:v>
                </c:pt>
                <c:pt idx="50">
                  <c:v>35</c:v>
                </c:pt>
                <c:pt idx="51">
                  <c:v>32.700000000000003</c:v>
                </c:pt>
                <c:pt idx="52">
                  <c:v>33.4</c:v>
                </c:pt>
                <c:pt idx="53">
                  <c:v>33.4</c:v>
                </c:pt>
                <c:pt idx="54">
                  <c:v>34.1</c:v>
                </c:pt>
                <c:pt idx="55">
                  <c:v>33.4</c:v>
                </c:pt>
                <c:pt idx="56">
                  <c:v>33</c:v>
                </c:pt>
                <c:pt idx="57">
                  <c:v>33.299999999999997</c:v>
                </c:pt>
                <c:pt idx="58">
                  <c:v>32.9</c:v>
                </c:pt>
                <c:pt idx="59">
                  <c:v>33.200000000000003</c:v>
                </c:pt>
                <c:pt idx="60">
                  <c:v>32.4</c:v>
                </c:pt>
                <c:pt idx="61">
                  <c:v>32.200000000000003</c:v>
                </c:pt>
              </c:numCache>
            </c:numRef>
          </c:val>
          <c:smooth val="0"/>
        </c:ser>
        <c:dLbls>
          <c:showLegendKey val="0"/>
          <c:showVal val="0"/>
          <c:showCatName val="0"/>
          <c:showSerName val="0"/>
          <c:showPercent val="0"/>
          <c:showBubbleSize val="0"/>
        </c:dLbls>
        <c:marker val="1"/>
        <c:smooth val="0"/>
        <c:axId val="75016448"/>
        <c:axId val="74932608"/>
      </c:lineChart>
      <c:dateAx>
        <c:axId val="75016448"/>
        <c:scaling>
          <c:orientation val="minMax"/>
        </c:scaling>
        <c:delete val="0"/>
        <c:axPos val="b"/>
        <c:title>
          <c:tx>
            <c:rich>
              <a:bodyPr/>
              <a:lstStyle/>
              <a:p>
                <a:pPr>
                  <a:defRPr/>
                </a:pPr>
                <a:r>
                  <a:rPr lang="en-US"/>
                  <a:t>Date</a:t>
                </a:r>
              </a:p>
            </c:rich>
          </c:tx>
          <c:layout/>
          <c:overlay val="0"/>
        </c:title>
        <c:numFmt formatCode="m/d/yyyy" sourceLinked="1"/>
        <c:majorTickMark val="out"/>
        <c:minorTickMark val="none"/>
        <c:tickLblPos val="nextTo"/>
        <c:txPr>
          <a:bodyPr/>
          <a:lstStyle/>
          <a:p>
            <a:pPr>
              <a:defRPr sz="900" baseline="0">
                <a:latin typeface="Calibri" panose="020F0502020204030204" pitchFamily="34" charset="0"/>
              </a:defRPr>
            </a:pPr>
            <a:endParaRPr lang="he-IL"/>
          </a:p>
        </c:txPr>
        <c:crossAx val="74932608"/>
        <c:crosses val="autoZero"/>
        <c:auto val="1"/>
        <c:lblOffset val="100"/>
        <c:baseTimeUnit val="days"/>
        <c:majorUnit val="3"/>
        <c:majorTimeUnit val="days"/>
      </c:dateAx>
      <c:valAx>
        <c:axId val="74932608"/>
        <c:scaling>
          <c:orientation val="minMax"/>
        </c:scaling>
        <c:delete val="0"/>
        <c:axPos val="l"/>
        <c:majorGridlines/>
        <c:title>
          <c:tx>
            <c:rich>
              <a:bodyPr rot="-5400000" vert="horz"/>
              <a:lstStyle/>
              <a:p>
                <a:pPr>
                  <a:defRPr b="0" i="0" baseline="0">
                    <a:latin typeface="Calibri" panose="020F0502020204030204" pitchFamily="34" charset="0"/>
                  </a:defRPr>
                </a:pPr>
                <a:r>
                  <a:rPr lang="en-US" b="0" i="0" baseline="0">
                    <a:latin typeface="Calibri" panose="020F0502020204030204" pitchFamily="34" charset="0"/>
                  </a:rPr>
                  <a:t>Temperature (</a:t>
                </a:r>
                <a:r>
                  <a:rPr lang="en-US" b="0" i="0" baseline="30000">
                    <a:latin typeface="Calibri" panose="020F0502020204030204" pitchFamily="34" charset="0"/>
                  </a:rPr>
                  <a:t>o</a:t>
                </a:r>
                <a:r>
                  <a:rPr lang="en-US" b="0" i="0" baseline="0">
                    <a:latin typeface="Calibri" panose="020F0502020204030204" pitchFamily="34" charset="0"/>
                  </a:rPr>
                  <a:t>C) </a:t>
                </a:r>
              </a:p>
            </c:rich>
          </c:tx>
          <c:layout>
            <c:manualLayout>
              <c:xMode val="edge"/>
              <c:yMode val="edge"/>
              <c:x val="0.14672384072020672"/>
              <c:y val="0.17403292030762679"/>
            </c:manualLayout>
          </c:layout>
          <c:overlay val="0"/>
        </c:title>
        <c:numFmt formatCode="General" sourceLinked="1"/>
        <c:majorTickMark val="out"/>
        <c:minorTickMark val="none"/>
        <c:tickLblPos val="nextTo"/>
        <c:crossAx val="75016448"/>
        <c:crosses val="autoZero"/>
        <c:crossBetween val="between"/>
      </c:valAx>
    </c:plotArea>
    <c:legend>
      <c:legendPos val="l"/>
      <c:layout>
        <c:manualLayout>
          <c:xMode val="edge"/>
          <c:yMode val="edge"/>
          <c:x val="0.7416666666666667"/>
          <c:y val="0.39313466025080196"/>
          <c:w val="0.14602486344612331"/>
          <c:h val="0.17314582208698118"/>
        </c:manualLayout>
      </c:layout>
      <c:overlay val="0"/>
      <c:spPr>
        <a:solidFill>
          <a:schemeClr val="bg1"/>
        </a:solidFill>
      </c:spPr>
    </c:legend>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strRef>
              <c:f>'7-9-2009 Galgul'!$X$1</c:f>
              <c:strCache>
                <c:ptCount val="1"/>
                <c:pt idx="0">
                  <c:v>Day min</c:v>
                </c:pt>
              </c:strCache>
            </c:strRef>
          </c:tx>
          <c:spPr>
            <a:ln w="12700"/>
          </c:spPr>
          <c:marker>
            <c:symbol val="diamond"/>
            <c:size val="3"/>
          </c:marker>
          <c:cat>
            <c:strRef>
              <c:f>'7-9-2009 Galgul'!$W$2:$W$73</c:f>
              <c:strCache>
                <c:ptCount val="72"/>
                <c:pt idx="0">
                  <c:v>07/07/2009</c:v>
                </c:pt>
                <c:pt idx="1">
                  <c:v>08/07/2009</c:v>
                </c:pt>
                <c:pt idx="2">
                  <c:v>09/07/2009</c:v>
                </c:pt>
                <c:pt idx="3">
                  <c:v>10/07/2009</c:v>
                </c:pt>
                <c:pt idx="4">
                  <c:v>11/07/2009</c:v>
                </c:pt>
                <c:pt idx="5">
                  <c:v>12/07/2009</c:v>
                </c:pt>
                <c:pt idx="6">
                  <c:v>13/07/2009</c:v>
                </c:pt>
                <c:pt idx="7">
                  <c:v>14/07/2009</c:v>
                </c:pt>
                <c:pt idx="8">
                  <c:v>15/07/2009</c:v>
                </c:pt>
                <c:pt idx="9">
                  <c:v>16/07/2009</c:v>
                </c:pt>
                <c:pt idx="10">
                  <c:v>17/07/2009</c:v>
                </c:pt>
                <c:pt idx="11">
                  <c:v>18/07/2009</c:v>
                </c:pt>
                <c:pt idx="12">
                  <c:v>19/07/2009</c:v>
                </c:pt>
                <c:pt idx="13">
                  <c:v>20/07/2009</c:v>
                </c:pt>
                <c:pt idx="14">
                  <c:v>21/07/2009</c:v>
                </c:pt>
                <c:pt idx="15">
                  <c:v>22/07/2009</c:v>
                </c:pt>
                <c:pt idx="16">
                  <c:v>23/07/2009</c:v>
                </c:pt>
                <c:pt idx="17">
                  <c:v>24/07/2009</c:v>
                </c:pt>
                <c:pt idx="18">
                  <c:v>25/07/2009</c:v>
                </c:pt>
                <c:pt idx="19">
                  <c:v>26/07/2009</c:v>
                </c:pt>
                <c:pt idx="20">
                  <c:v>27/07/2009</c:v>
                </c:pt>
                <c:pt idx="21">
                  <c:v>28/07/2009</c:v>
                </c:pt>
                <c:pt idx="22">
                  <c:v>29/07/2009</c:v>
                </c:pt>
                <c:pt idx="23">
                  <c:v>30/07/2009</c:v>
                </c:pt>
                <c:pt idx="24">
                  <c:v>31/07/2009</c:v>
                </c:pt>
                <c:pt idx="25">
                  <c:v>01/08/2009</c:v>
                </c:pt>
                <c:pt idx="26">
                  <c:v>02/08/2009</c:v>
                </c:pt>
                <c:pt idx="27">
                  <c:v>03/08/2009</c:v>
                </c:pt>
                <c:pt idx="28">
                  <c:v>04/08/2009</c:v>
                </c:pt>
                <c:pt idx="29">
                  <c:v>05/08/2009</c:v>
                </c:pt>
                <c:pt idx="30">
                  <c:v>06/08/2009</c:v>
                </c:pt>
                <c:pt idx="31">
                  <c:v>07/08/2009</c:v>
                </c:pt>
                <c:pt idx="32">
                  <c:v>08/08/2009</c:v>
                </c:pt>
                <c:pt idx="33">
                  <c:v>09/08/2009</c:v>
                </c:pt>
                <c:pt idx="34">
                  <c:v>10/08/2009</c:v>
                </c:pt>
                <c:pt idx="35">
                  <c:v>11/08/2009</c:v>
                </c:pt>
                <c:pt idx="36">
                  <c:v>12/08/2009</c:v>
                </c:pt>
                <c:pt idx="37">
                  <c:v>13/08/2009</c:v>
                </c:pt>
                <c:pt idx="38">
                  <c:v>14/08/2009</c:v>
                </c:pt>
                <c:pt idx="39">
                  <c:v>15/08/2009</c:v>
                </c:pt>
                <c:pt idx="40">
                  <c:v>16/08/2009</c:v>
                </c:pt>
                <c:pt idx="41">
                  <c:v>17/08/2009</c:v>
                </c:pt>
                <c:pt idx="42">
                  <c:v>18/08/2009</c:v>
                </c:pt>
                <c:pt idx="43">
                  <c:v>19/08/2009</c:v>
                </c:pt>
                <c:pt idx="44">
                  <c:v>20/08/2009</c:v>
                </c:pt>
                <c:pt idx="45">
                  <c:v>21/08/2009</c:v>
                </c:pt>
                <c:pt idx="46">
                  <c:v>22/08/2009</c:v>
                </c:pt>
                <c:pt idx="47">
                  <c:v>23/08/2009</c:v>
                </c:pt>
                <c:pt idx="48">
                  <c:v>24/08/2009</c:v>
                </c:pt>
                <c:pt idx="49">
                  <c:v>25/08/2009</c:v>
                </c:pt>
                <c:pt idx="50">
                  <c:v>26/08/2009</c:v>
                </c:pt>
                <c:pt idx="51">
                  <c:v>27/08/2009</c:v>
                </c:pt>
                <c:pt idx="52">
                  <c:v>28/08/2009</c:v>
                </c:pt>
                <c:pt idx="53">
                  <c:v>29/08/2009</c:v>
                </c:pt>
                <c:pt idx="54">
                  <c:v>30/08/2009</c:v>
                </c:pt>
                <c:pt idx="55">
                  <c:v>31/08/2009</c:v>
                </c:pt>
                <c:pt idx="56">
                  <c:v>01/09/2009</c:v>
                </c:pt>
                <c:pt idx="57">
                  <c:v>02/09/2009</c:v>
                </c:pt>
                <c:pt idx="58">
                  <c:v>03/09/2009</c:v>
                </c:pt>
                <c:pt idx="59">
                  <c:v>04/09/2009</c:v>
                </c:pt>
                <c:pt idx="60">
                  <c:v>05/09/2009</c:v>
                </c:pt>
                <c:pt idx="61">
                  <c:v>06/09/2009</c:v>
                </c:pt>
                <c:pt idx="62">
                  <c:v>07/09/2009</c:v>
                </c:pt>
                <c:pt idx="63">
                  <c:v>08/09/2009</c:v>
                </c:pt>
                <c:pt idx="64">
                  <c:v>09/09/2009</c:v>
                </c:pt>
                <c:pt idx="65">
                  <c:v>10/09/2009</c:v>
                </c:pt>
                <c:pt idx="66">
                  <c:v>11/09/2009</c:v>
                </c:pt>
                <c:pt idx="67">
                  <c:v>12/09/2009</c:v>
                </c:pt>
                <c:pt idx="68">
                  <c:v>13/09/2009</c:v>
                </c:pt>
                <c:pt idx="69">
                  <c:v>14/09/2009</c:v>
                </c:pt>
                <c:pt idx="70">
                  <c:v>15/09/2009</c:v>
                </c:pt>
                <c:pt idx="71">
                  <c:v>16/09/2009</c:v>
                </c:pt>
              </c:strCache>
            </c:strRef>
          </c:cat>
          <c:val>
            <c:numRef>
              <c:f>'7-9-2009 Galgul'!$X$2:$X$73</c:f>
              <c:numCache>
                <c:formatCode>General</c:formatCode>
                <c:ptCount val="72"/>
                <c:pt idx="0">
                  <c:v>22.6</c:v>
                </c:pt>
                <c:pt idx="1">
                  <c:v>22.9</c:v>
                </c:pt>
                <c:pt idx="2">
                  <c:v>22.6</c:v>
                </c:pt>
                <c:pt idx="3">
                  <c:v>22.9</c:v>
                </c:pt>
                <c:pt idx="4">
                  <c:v>22.7</c:v>
                </c:pt>
                <c:pt idx="5">
                  <c:v>22.9</c:v>
                </c:pt>
                <c:pt idx="6">
                  <c:v>23.8</c:v>
                </c:pt>
                <c:pt idx="7">
                  <c:v>23.5</c:v>
                </c:pt>
                <c:pt idx="8">
                  <c:v>23.4</c:v>
                </c:pt>
                <c:pt idx="9">
                  <c:v>22.4</c:v>
                </c:pt>
                <c:pt idx="10">
                  <c:v>21.8</c:v>
                </c:pt>
                <c:pt idx="11">
                  <c:v>22.5</c:v>
                </c:pt>
                <c:pt idx="12">
                  <c:v>23.6</c:v>
                </c:pt>
                <c:pt idx="13">
                  <c:v>23.4</c:v>
                </c:pt>
                <c:pt idx="14">
                  <c:v>24.1</c:v>
                </c:pt>
                <c:pt idx="15">
                  <c:v>24.2</c:v>
                </c:pt>
                <c:pt idx="16">
                  <c:v>24.3</c:v>
                </c:pt>
                <c:pt idx="17">
                  <c:v>24</c:v>
                </c:pt>
                <c:pt idx="18">
                  <c:v>23.2</c:v>
                </c:pt>
                <c:pt idx="19">
                  <c:v>23.4</c:v>
                </c:pt>
                <c:pt idx="20">
                  <c:v>23.5</c:v>
                </c:pt>
                <c:pt idx="21">
                  <c:v>23.7</c:v>
                </c:pt>
                <c:pt idx="22">
                  <c:v>24.9</c:v>
                </c:pt>
                <c:pt idx="23">
                  <c:v>23.6</c:v>
                </c:pt>
                <c:pt idx="24">
                  <c:v>23.5</c:v>
                </c:pt>
                <c:pt idx="25">
                  <c:v>23.9</c:v>
                </c:pt>
                <c:pt idx="26">
                  <c:v>22.4</c:v>
                </c:pt>
                <c:pt idx="27">
                  <c:v>22.6</c:v>
                </c:pt>
                <c:pt idx="28">
                  <c:v>23.9</c:v>
                </c:pt>
                <c:pt idx="29">
                  <c:v>23.2</c:v>
                </c:pt>
                <c:pt idx="30">
                  <c:v>23.7</c:v>
                </c:pt>
                <c:pt idx="31">
                  <c:v>21.5</c:v>
                </c:pt>
                <c:pt idx="32">
                  <c:v>23.5</c:v>
                </c:pt>
                <c:pt idx="33">
                  <c:v>23.7</c:v>
                </c:pt>
                <c:pt idx="34">
                  <c:v>23.4</c:v>
                </c:pt>
                <c:pt idx="35">
                  <c:v>24.8</c:v>
                </c:pt>
                <c:pt idx="36">
                  <c:v>23.3</c:v>
                </c:pt>
                <c:pt idx="37">
                  <c:v>22.1</c:v>
                </c:pt>
                <c:pt idx="38">
                  <c:v>23.1</c:v>
                </c:pt>
                <c:pt idx="39">
                  <c:v>23.6</c:v>
                </c:pt>
                <c:pt idx="40">
                  <c:v>24.3</c:v>
                </c:pt>
                <c:pt idx="41">
                  <c:v>24.2</c:v>
                </c:pt>
                <c:pt idx="42">
                  <c:v>23.4</c:v>
                </c:pt>
                <c:pt idx="43">
                  <c:v>21.8</c:v>
                </c:pt>
                <c:pt idx="44">
                  <c:v>23.7</c:v>
                </c:pt>
                <c:pt idx="45">
                  <c:v>24.4</c:v>
                </c:pt>
                <c:pt idx="46">
                  <c:v>24.1</c:v>
                </c:pt>
                <c:pt idx="47">
                  <c:v>23.8</c:v>
                </c:pt>
                <c:pt idx="48">
                  <c:v>22.2</c:v>
                </c:pt>
                <c:pt idx="49">
                  <c:v>23</c:v>
                </c:pt>
                <c:pt idx="50">
                  <c:v>21.9</c:v>
                </c:pt>
                <c:pt idx="51">
                  <c:v>22.1</c:v>
                </c:pt>
                <c:pt idx="52">
                  <c:v>22.7</c:v>
                </c:pt>
                <c:pt idx="53">
                  <c:v>22.2</c:v>
                </c:pt>
                <c:pt idx="54">
                  <c:v>22.6</c:v>
                </c:pt>
                <c:pt idx="55">
                  <c:v>22.8</c:v>
                </c:pt>
                <c:pt idx="56">
                  <c:v>20.9</c:v>
                </c:pt>
                <c:pt idx="57">
                  <c:v>20.5</c:v>
                </c:pt>
                <c:pt idx="58">
                  <c:v>22.8</c:v>
                </c:pt>
                <c:pt idx="59">
                  <c:v>24.2</c:v>
                </c:pt>
                <c:pt idx="60">
                  <c:v>23.7</c:v>
                </c:pt>
                <c:pt idx="61">
                  <c:v>22.9</c:v>
                </c:pt>
                <c:pt idx="62">
                  <c:v>22.4</c:v>
                </c:pt>
                <c:pt idx="63">
                  <c:v>21.7</c:v>
                </c:pt>
                <c:pt idx="64">
                  <c:v>22.2</c:v>
                </c:pt>
                <c:pt idx="65">
                  <c:v>21.4</c:v>
                </c:pt>
                <c:pt idx="66">
                  <c:v>20.399999999999999</c:v>
                </c:pt>
                <c:pt idx="67">
                  <c:v>21.9</c:v>
                </c:pt>
                <c:pt idx="68">
                  <c:v>23.2</c:v>
                </c:pt>
                <c:pt idx="69">
                  <c:v>22.1</c:v>
                </c:pt>
                <c:pt idx="70">
                  <c:v>20.8</c:v>
                </c:pt>
                <c:pt idx="71">
                  <c:v>22.7</c:v>
                </c:pt>
              </c:numCache>
            </c:numRef>
          </c:val>
          <c:smooth val="0"/>
        </c:ser>
        <c:ser>
          <c:idx val="1"/>
          <c:order val="1"/>
          <c:tx>
            <c:strRef>
              <c:f>'7-9-2009 Galgul'!$Y$1</c:f>
              <c:strCache>
                <c:ptCount val="1"/>
                <c:pt idx="0">
                  <c:v>Day max</c:v>
                </c:pt>
              </c:strCache>
            </c:strRef>
          </c:tx>
          <c:spPr>
            <a:ln w="12700"/>
          </c:spPr>
          <c:marker>
            <c:symbol val="square"/>
            <c:size val="2"/>
          </c:marker>
          <c:cat>
            <c:strRef>
              <c:f>'7-9-2009 Galgul'!$W$2:$W$73</c:f>
              <c:strCache>
                <c:ptCount val="72"/>
                <c:pt idx="0">
                  <c:v>07/07/2009</c:v>
                </c:pt>
                <c:pt idx="1">
                  <c:v>08/07/2009</c:v>
                </c:pt>
                <c:pt idx="2">
                  <c:v>09/07/2009</c:v>
                </c:pt>
                <c:pt idx="3">
                  <c:v>10/07/2009</c:v>
                </c:pt>
                <c:pt idx="4">
                  <c:v>11/07/2009</c:v>
                </c:pt>
                <c:pt idx="5">
                  <c:v>12/07/2009</c:v>
                </c:pt>
                <c:pt idx="6">
                  <c:v>13/07/2009</c:v>
                </c:pt>
                <c:pt idx="7">
                  <c:v>14/07/2009</c:v>
                </c:pt>
                <c:pt idx="8">
                  <c:v>15/07/2009</c:v>
                </c:pt>
                <c:pt idx="9">
                  <c:v>16/07/2009</c:v>
                </c:pt>
                <c:pt idx="10">
                  <c:v>17/07/2009</c:v>
                </c:pt>
                <c:pt idx="11">
                  <c:v>18/07/2009</c:v>
                </c:pt>
                <c:pt idx="12">
                  <c:v>19/07/2009</c:v>
                </c:pt>
                <c:pt idx="13">
                  <c:v>20/07/2009</c:v>
                </c:pt>
                <c:pt idx="14">
                  <c:v>21/07/2009</c:v>
                </c:pt>
                <c:pt idx="15">
                  <c:v>22/07/2009</c:v>
                </c:pt>
                <c:pt idx="16">
                  <c:v>23/07/2009</c:v>
                </c:pt>
                <c:pt idx="17">
                  <c:v>24/07/2009</c:v>
                </c:pt>
                <c:pt idx="18">
                  <c:v>25/07/2009</c:v>
                </c:pt>
                <c:pt idx="19">
                  <c:v>26/07/2009</c:v>
                </c:pt>
                <c:pt idx="20">
                  <c:v>27/07/2009</c:v>
                </c:pt>
                <c:pt idx="21">
                  <c:v>28/07/2009</c:v>
                </c:pt>
                <c:pt idx="22">
                  <c:v>29/07/2009</c:v>
                </c:pt>
                <c:pt idx="23">
                  <c:v>30/07/2009</c:v>
                </c:pt>
                <c:pt idx="24">
                  <c:v>31/07/2009</c:v>
                </c:pt>
                <c:pt idx="25">
                  <c:v>01/08/2009</c:v>
                </c:pt>
                <c:pt idx="26">
                  <c:v>02/08/2009</c:v>
                </c:pt>
                <c:pt idx="27">
                  <c:v>03/08/2009</c:v>
                </c:pt>
                <c:pt idx="28">
                  <c:v>04/08/2009</c:v>
                </c:pt>
                <c:pt idx="29">
                  <c:v>05/08/2009</c:v>
                </c:pt>
                <c:pt idx="30">
                  <c:v>06/08/2009</c:v>
                </c:pt>
                <c:pt idx="31">
                  <c:v>07/08/2009</c:v>
                </c:pt>
                <c:pt idx="32">
                  <c:v>08/08/2009</c:v>
                </c:pt>
                <c:pt idx="33">
                  <c:v>09/08/2009</c:v>
                </c:pt>
                <c:pt idx="34">
                  <c:v>10/08/2009</c:v>
                </c:pt>
                <c:pt idx="35">
                  <c:v>11/08/2009</c:v>
                </c:pt>
                <c:pt idx="36">
                  <c:v>12/08/2009</c:v>
                </c:pt>
                <c:pt idx="37">
                  <c:v>13/08/2009</c:v>
                </c:pt>
                <c:pt idx="38">
                  <c:v>14/08/2009</c:v>
                </c:pt>
                <c:pt idx="39">
                  <c:v>15/08/2009</c:v>
                </c:pt>
                <c:pt idx="40">
                  <c:v>16/08/2009</c:v>
                </c:pt>
                <c:pt idx="41">
                  <c:v>17/08/2009</c:v>
                </c:pt>
                <c:pt idx="42">
                  <c:v>18/08/2009</c:v>
                </c:pt>
                <c:pt idx="43">
                  <c:v>19/08/2009</c:v>
                </c:pt>
                <c:pt idx="44">
                  <c:v>20/08/2009</c:v>
                </c:pt>
                <c:pt idx="45">
                  <c:v>21/08/2009</c:v>
                </c:pt>
                <c:pt idx="46">
                  <c:v>22/08/2009</c:v>
                </c:pt>
                <c:pt idx="47">
                  <c:v>23/08/2009</c:v>
                </c:pt>
                <c:pt idx="48">
                  <c:v>24/08/2009</c:v>
                </c:pt>
                <c:pt idx="49">
                  <c:v>25/08/2009</c:v>
                </c:pt>
                <c:pt idx="50">
                  <c:v>26/08/2009</c:v>
                </c:pt>
                <c:pt idx="51">
                  <c:v>27/08/2009</c:v>
                </c:pt>
                <c:pt idx="52">
                  <c:v>28/08/2009</c:v>
                </c:pt>
                <c:pt idx="53">
                  <c:v>29/08/2009</c:v>
                </c:pt>
                <c:pt idx="54">
                  <c:v>30/08/2009</c:v>
                </c:pt>
                <c:pt idx="55">
                  <c:v>31/08/2009</c:v>
                </c:pt>
                <c:pt idx="56">
                  <c:v>01/09/2009</c:v>
                </c:pt>
                <c:pt idx="57">
                  <c:v>02/09/2009</c:v>
                </c:pt>
                <c:pt idx="58">
                  <c:v>03/09/2009</c:v>
                </c:pt>
                <c:pt idx="59">
                  <c:v>04/09/2009</c:v>
                </c:pt>
                <c:pt idx="60">
                  <c:v>05/09/2009</c:v>
                </c:pt>
                <c:pt idx="61">
                  <c:v>06/09/2009</c:v>
                </c:pt>
                <c:pt idx="62">
                  <c:v>07/09/2009</c:v>
                </c:pt>
                <c:pt idx="63">
                  <c:v>08/09/2009</c:v>
                </c:pt>
                <c:pt idx="64">
                  <c:v>09/09/2009</c:v>
                </c:pt>
                <c:pt idx="65">
                  <c:v>10/09/2009</c:v>
                </c:pt>
                <c:pt idx="66">
                  <c:v>11/09/2009</c:v>
                </c:pt>
                <c:pt idx="67">
                  <c:v>12/09/2009</c:v>
                </c:pt>
                <c:pt idx="68">
                  <c:v>13/09/2009</c:v>
                </c:pt>
                <c:pt idx="69">
                  <c:v>14/09/2009</c:v>
                </c:pt>
                <c:pt idx="70">
                  <c:v>15/09/2009</c:v>
                </c:pt>
                <c:pt idx="71">
                  <c:v>16/09/2009</c:v>
                </c:pt>
              </c:strCache>
            </c:strRef>
          </c:cat>
          <c:val>
            <c:numRef>
              <c:f>'7-9-2009 Galgul'!$Y$2:$Y$73</c:f>
              <c:numCache>
                <c:formatCode>General</c:formatCode>
                <c:ptCount val="72"/>
                <c:pt idx="0">
                  <c:v>31.3</c:v>
                </c:pt>
                <c:pt idx="1">
                  <c:v>31.7</c:v>
                </c:pt>
                <c:pt idx="2">
                  <c:v>32.9</c:v>
                </c:pt>
                <c:pt idx="3">
                  <c:v>33.299999999999997</c:v>
                </c:pt>
                <c:pt idx="4">
                  <c:v>34.6</c:v>
                </c:pt>
                <c:pt idx="5">
                  <c:v>35.1</c:v>
                </c:pt>
                <c:pt idx="6">
                  <c:v>33.700000000000003</c:v>
                </c:pt>
                <c:pt idx="7">
                  <c:v>29.6</c:v>
                </c:pt>
                <c:pt idx="8">
                  <c:v>30.7</c:v>
                </c:pt>
                <c:pt idx="9">
                  <c:v>32</c:v>
                </c:pt>
                <c:pt idx="10">
                  <c:v>31.9</c:v>
                </c:pt>
                <c:pt idx="11">
                  <c:v>33.299999999999997</c:v>
                </c:pt>
                <c:pt idx="12">
                  <c:v>33.200000000000003</c:v>
                </c:pt>
                <c:pt idx="13">
                  <c:v>33.299999999999997</c:v>
                </c:pt>
                <c:pt idx="14">
                  <c:v>33.299999999999997</c:v>
                </c:pt>
                <c:pt idx="15">
                  <c:v>34.200000000000003</c:v>
                </c:pt>
                <c:pt idx="16">
                  <c:v>33.9</c:v>
                </c:pt>
                <c:pt idx="17">
                  <c:v>34.200000000000003</c:v>
                </c:pt>
                <c:pt idx="18">
                  <c:v>33</c:v>
                </c:pt>
                <c:pt idx="19">
                  <c:v>33.9</c:v>
                </c:pt>
                <c:pt idx="20">
                  <c:v>35.1</c:v>
                </c:pt>
                <c:pt idx="21">
                  <c:v>34.700000000000003</c:v>
                </c:pt>
                <c:pt idx="22">
                  <c:v>33.9</c:v>
                </c:pt>
                <c:pt idx="23">
                  <c:v>32.200000000000003</c:v>
                </c:pt>
                <c:pt idx="24">
                  <c:v>32.299999999999997</c:v>
                </c:pt>
                <c:pt idx="25">
                  <c:v>33.9</c:v>
                </c:pt>
                <c:pt idx="26">
                  <c:v>34.200000000000003</c:v>
                </c:pt>
                <c:pt idx="27">
                  <c:v>33.4</c:v>
                </c:pt>
                <c:pt idx="28">
                  <c:v>34.6</c:v>
                </c:pt>
                <c:pt idx="29">
                  <c:v>34.4</c:v>
                </c:pt>
                <c:pt idx="30">
                  <c:v>33.6</c:v>
                </c:pt>
                <c:pt idx="31">
                  <c:v>32.9</c:v>
                </c:pt>
                <c:pt idx="32">
                  <c:v>32.700000000000003</c:v>
                </c:pt>
                <c:pt idx="33">
                  <c:v>32</c:v>
                </c:pt>
                <c:pt idx="34">
                  <c:v>32.6</c:v>
                </c:pt>
                <c:pt idx="35">
                  <c:v>33</c:v>
                </c:pt>
                <c:pt idx="36">
                  <c:v>33</c:v>
                </c:pt>
                <c:pt idx="37">
                  <c:v>32.4</c:v>
                </c:pt>
                <c:pt idx="38">
                  <c:v>32.4</c:v>
                </c:pt>
                <c:pt idx="39">
                  <c:v>32.9</c:v>
                </c:pt>
                <c:pt idx="40">
                  <c:v>32.9</c:v>
                </c:pt>
                <c:pt idx="41">
                  <c:v>33.200000000000003</c:v>
                </c:pt>
                <c:pt idx="42">
                  <c:v>31.9</c:v>
                </c:pt>
                <c:pt idx="43">
                  <c:v>32.5</c:v>
                </c:pt>
                <c:pt idx="44">
                  <c:v>34.1</c:v>
                </c:pt>
                <c:pt idx="45">
                  <c:v>34.200000000000003</c:v>
                </c:pt>
                <c:pt idx="46">
                  <c:v>33.6</c:v>
                </c:pt>
                <c:pt idx="47">
                  <c:v>32.799999999999997</c:v>
                </c:pt>
                <c:pt idx="48">
                  <c:v>33.4</c:v>
                </c:pt>
                <c:pt idx="49">
                  <c:v>32.700000000000003</c:v>
                </c:pt>
                <c:pt idx="50">
                  <c:v>31.8</c:v>
                </c:pt>
                <c:pt idx="51">
                  <c:v>32</c:v>
                </c:pt>
                <c:pt idx="52">
                  <c:v>31.1</c:v>
                </c:pt>
                <c:pt idx="53">
                  <c:v>31.5</c:v>
                </c:pt>
                <c:pt idx="54">
                  <c:v>31.4</c:v>
                </c:pt>
                <c:pt idx="55">
                  <c:v>32.200000000000003</c:v>
                </c:pt>
                <c:pt idx="56">
                  <c:v>30.9</c:v>
                </c:pt>
                <c:pt idx="57">
                  <c:v>31.5</c:v>
                </c:pt>
                <c:pt idx="58">
                  <c:v>31.8</c:v>
                </c:pt>
                <c:pt idx="59">
                  <c:v>32</c:v>
                </c:pt>
                <c:pt idx="60">
                  <c:v>31.5</c:v>
                </c:pt>
                <c:pt idx="61">
                  <c:v>30.4</c:v>
                </c:pt>
                <c:pt idx="62">
                  <c:v>31.2</c:v>
                </c:pt>
                <c:pt idx="63">
                  <c:v>32.4</c:v>
                </c:pt>
                <c:pt idx="64">
                  <c:v>31.6</c:v>
                </c:pt>
                <c:pt idx="65">
                  <c:v>30.1</c:v>
                </c:pt>
                <c:pt idx="66">
                  <c:v>30.7</c:v>
                </c:pt>
                <c:pt idx="67">
                  <c:v>37.200000000000003</c:v>
                </c:pt>
                <c:pt idx="68">
                  <c:v>30.3</c:v>
                </c:pt>
                <c:pt idx="69">
                  <c:v>30.8</c:v>
                </c:pt>
                <c:pt idx="70">
                  <c:v>30.8</c:v>
                </c:pt>
                <c:pt idx="71">
                  <c:v>31.2</c:v>
                </c:pt>
              </c:numCache>
            </c:numRef>
          </c:val>
          <c:smooth val="0"/>
        </c:ser>
        <c:dLbls>
          <c:showLegendKey val="0"/>
          <c:showVal val="0"/>
          <c:showCatName val="0"/>
          <c:showSerName val="0"/>
          <c:showPercent val="0"/>
          <c:showBubbleSize val="0"/>
        </c:dLbls>
        <c:marker val="1"/>
        <c:smooth val="0"/>
        <c:axId val="87394176"/>
        <c:axId val="93467008"/>
      </c:lineChart>
      <c:catAx>
        <c:axId val="87394176"/>
        <c:scaling>
          <c:orientation val="minMax"/>
        </c:scaling>
        <c:delete val="0"/>
        <c:axPos val="b"/>
        <c:title>
          <c:tx>
            <c:rich>
              <a:bodyPr/>
              <a:lstStyle/>
              <a:p>
                <a:pPr>
                  <a:defRPr b="0" i="0" baseline="0">
                    <a:latin typeface="Calibri" panose="020F0502020204030204" pitchFamily="34" charset="0"/>
                  </a:defRPr>
                </a:pPr>
                <a:r>
                  <a:rPr lang="en-US" b="0" i="0" baseline="0">
                    <a:latin typeface="Calibri" panose="020F0502020204030204" pitchFamily="34" charset="0"/>
                  </a:rPr>
                  <a:t>Date</a:t>
                </a:r>
              </a:p>
            </c:rich>
          </c:tx>
          <c:layout/>
          <c:overlay val="0"/>
        </c:title>
        <c:numFmt formatCode="General" sourceLinked="1"/>
        <c:majorTickMark val="out"/>
        <c:minorTickMark val="none"/>
        <c:tickLblPos val="nextTo"/>
        <c:txPr>
          <a:bodyPr/>
          <a:lstStyle/>
          <a:p>
            <a:pPr>
              <a:defRPr sz="900" baseline="0">
                <a:latin typeface="Calibri" panose="020F0502020204030204" pitchFamily="34" charset="0"/>
              </a:defRPr>
            </a:pPr>
            <a:endParaRPr lang="he-IL"/>
          </a:p>
        </c:txPr>
        <c:crossAx val="93467008"/>
        <c:crosses val="autoZero"/>
        <c:auto val="1"/>
        <c:lblAlgn val="ctr"/>
        <c:lblOffset val="100"/>
        <c:noMultiLvlLbl val="0"/>
      </c:catAx>
      <c:valAx>
        <c:axId val="93467008"/>
        <c:scaling>
          <c:orientation val="minMax"/>
        </c:scaling>
        <c:delete val="0"/>
        <c:axPos val="l"/>
        <c:majorGridlines/>
        <c:title>
          <c:tx>
            <c:rich>
              <a:bodyPr rot="-5400000" vert="horz"/>
              <a:lstStyle/>
              <a:p>
                <a:pPr>
                  <a:defRPr b="0" i="0" baseline="0">
                    <a:latin typeface="Calibri" panose="020F0502020204030204" pitchFamily="34" charset="0"/>
                  </a:defRPr>
                </a:pPr>
                <a:r>
                  <a:rPr lang="en-US" b="0" i="0" baseline="0">
                    <a:latin typeface="Calibri" panose="020F0502020204030204" pitchFamily="34" charset="0"/>
                  </a:rPr>
                  <a:t>Temperature (</a:t>
                </a:r>
                <a:r>
                  <a:rPr lang="en-US" b="0" i="0" baseline="30000">
                    <a:latin typeface="Calibri" panose="020F0502020204030204" pitchFamily="34" charset="0"/>
                  </a:rPr>
                  <a:t>o</a:t>
                </a:r>
                <a:r>
                  <a:rPr lang="en-US" b="0" i="0" baseline="0">
                    <a:latin typeface="Calibri" panose="020F0502020204030204" pitchFamily="34" charset="0"/>
                  </a:rPr>
                  <a:t>C)  </a:t>
                </a:r>
              </a:p>
            </c:rich>
          </c:tx>
          <c:layout>
            <c:manualLayout>
              <c:xMode val="edge"/>
              <c:yMode val="edge"/>
              <c:x val="0.14059461229454034"/>
              <c:y val="0.18679014924540238"/>
            </c:manualLayout>
          </c:layout>
          <c:overlay val="0"/>
        </c:title>
        <c:numFmt formatCode="General" sourceLinked="1"/>
        <c:majorTickMark val="out"/>
        <c:minorTickMark val="none"/>
        <c:tickLblPos val="nextTo"/>
        <c:crossAx val="87394176"/>
        <c:crosses val="autoZero"/>
        <c:crossBetween val="between"/>
      </c:valAx>
    </c:plotArea>
    <c:legend>
      <c:legendPos val="l"/>
      <c:layout>
        <c:manualLayout>
          <c:xMode val="edge"/>
          <c:yMode val="edge"/>
          <c:x val="0.71944453083400484"/>
          <c:y val="0.42554191215608539"/>
          <c:w val="0.15520057299839318"/>
          <c:h val="0.1683112163427124"/>
        </c:manualLayout>
      </c:layout>
      <c:overlay val="0"/>
      <c:spPr>
        <a:solidFill>
          <a:schemeClr val="bg1"/>
        </a:solidFill>
      </c:spPr>
    </c:legend>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strRef>
              <c:f>ims_data!$D$1</c:f>
              <c:strCache>
                <c:ptCount val="1"/>
                <c:pt idx="0">
                  <c:v>Day min</c:v>
                </c:pt>
              </c:strCache>
            </c:strRef>
          </c:tx>
          <c:spPr>
            <a:ln w="12700"/>
          </c:spPr>
          <c:marker>
            <c:symbol val="diamond"/>
            <c:size val="2"/>
          </c:marker>
          <c:cat>
            <c:numRef>
              <c:f>ims_data!$C$2:$C$60</c:f>
              <c:numCache>
                <c:formatCode>m/d/yyyy</c:formatCode>
                <c:ptCount val="59"/>
                <c:pt idx="0">
                  <c:v>40544</c:v>
                </c:pt>
                <c:pt idx="1">
                  <c:v>40545</c:v>
                </c:pt>
                <c:pt idx="2">
                  <c:v>40546</c:v>
                </c:pt>
                <c:pt idx="3">
                  <c:v>40547</c:v>
                </c:pt>
                <c:pt idx="4">
                  <c:v>40548</c:v>
                </c:pt>
                <c:pt idx="5">
                  <c:v>40549</c:v>
                </c:pt>
                <c:pt idx="6">
                  <c:v>40550</c:v>
                </c:pt>
                <c:pt idx="7">
                  <c:v>40551</c:v>
                </c:pt>
                <c:pt idx="8">
                  <c:v>40552</c:v>
                </c:pt>
                <c:pt idx="9">
                  <c:v>40553</c:v>
                </c:pt>
                <c:pt idx="10">
                  <c:v>40554</c:v>
                </c:pt>
                <c:pt idx="11">
                  <c:v>40555</c:v>
                </c:pt>
                <c:pt idx="12">
                  <c:v>40556</c:v>
                </c:pt>
                <c:pt idx="13">
                  <c:v>40557</c:v>
                </c:pt>
                <c:pt idx="14">
                  <c:v>40558</c:v>
                </c:pt>
                <c:pt idx="15">
                  <c:v>40559</c:v>
                </c:pt>
                <c:pt idx="16">
                  <c:v>40560</c:v>
                </c:pt>
                <c:pt idx="17">
                  <c:v>40561</c:v>
                </c:pt>
                <c:pt idx="18">
                  <c:v>40562</c:v>
                </c:pt>
                <c:pt idx="19">
                  <c:v>40563</c:v>
                </c:pt>
                <c:pt idx="20">
                  <c:v>40564</c:v>
                </c:pt>
                <c:pt idx="21">
                  <c:v>40565</c:v>
                </c:pt>
                <c:pt idx="22">
                  <c:v>40566</c:v>
                </c:pt>
                <c:pt idx="23">
                  <c:v>40567</c:v>
                </c:pt>
                <c:pt idx="24">
                  <c:v>40568</c:v>
                </c:pt>
                <c:pt idx="25">
                  <c:v>40569</c:v>
                </c:pt>
                <c:pt idx="26">
                  <c:v>40570</c:v>
                </c:pt>
                <c:pt idx="27">
                  <c:v>40571</c:v>
                </c:pt>
                <c:pt idx="28">
                  <c:v>40572</c:v>
                </c:pt>
                <c:pt idx="29">
                  <c:v>40573</c:v>
                </c:pt>
                <c:pt idx="30">
                  <c:v>40574</c:v>
                </c:pt>
                <c:pt idx="31">
                  <c:v>40575</c:v>
                </c:pt>
                <c:pt idx="32">
                  <c:v>40576</c:v>
                </c:pt>
                <c:pt idx="33">
                  <c:v>40577</c:v>
                </c:pt>
                <c:pt idx="34">
                  <c:v>40578</c:v>
                </c:pt>
                <c:pt idx="35">
                  <c:v>40579</c:v>
                </c:pt>
                <c:pt idx="36">
                  <c:v>40580</c:v>
                </c:pt>
                <c:pt idx="37">
                  <c:v>40581</c:v>
                </c:pt>
                <c:pt idx="38">
                  <c:v>40582</c:v>
                </c:pt>
                <c:pt idx="39">
                  <c:v>40583</c:v>
                </c:pt>
                <c:pt idx="40">
                  <c:v>40584</c:v>
                </c:pt>
                <c:pt idx="41">
                  <c:v>40585</c:v>
                </c:pt>
                <c:pt idx="42">
                  <c:v>40586</c:v>
                </c:pt>
                <c:pt idx="43">
                  <c:v>40587</c:v>
                </c:pt>
                <c:pt idx="44">
                  <c:v>40588</c:v>
                </c:pt>
                <c:pt idx="45">
                  <c:v>40589</c:v>
                </c:pt>
                <c:pt idx="46">
                  <c:v>40590</c:v>
                </c:pt>
                <c:pt idx="47">
                  <c:v>40591</c:v>
                </c:pt>
                <c:pt idx="48">
                  <c:v>40592</c:v>
                </c:pt>
                <c:pt idx="49">
                  <c:v>40593</c:v>
                </c:pt>
                <c:pt idx="50">
                  <c:v>40594</c:v>
                </c:pt>
                <c:pt idx="51">
                  <c:v>40595</c:v>
                </c:pt>
                <c:pt idx="52">
                  <c:v>40596</c:v>
                </c:pt>
                <c:pt idx="53">
                  <c:v>40597</c:v>
                </c:pt>
                <c:pt idx="54">
                  <c:v>40598</c:v>
                </c:pt>
                <c:pt idx="55">
                  <c:v>40599</c:v>
                </c:pt>
                <c:pt idx="56">
                  <c:v>40600</c:v>
                </c:pt>
                <c:pt idx="57">
                  <c:v>40601</c:v>
                </c:pt>
                <c:pt idx="58">
                  <c:v>40602</c:v>
                </c:pt>
              </c:numCache>
            </c:numRef>
          </c:cat>
          <c:val>
            <c:numRef>
              <c:f>ims_data!$D$2:$D$60</c:f>
              <c:numCache>
                <c:formatCode>General</c:formatCode>
                <c:ptCount val="59"/>
                <c:pt idx="0">
                  <c:v>13.8</c:v>
                </c:pt>
                <c:pt idx="1">
                  <c:v>12.2</c:v>
                </c:pt>
                <c:pt idx="2">
                  <c:v>9.1</c:v>
                </c:pt>
                <c:pt idx="3">
                  <c:v>11.4</c:v>
                </c:pt>
                <c:pt idx="4">
                  <c:v>12.2</c:v>
                </c:pt>
                <c:pt idx="5">
                  <c:v>11.8</c:v>
                </c:pt>
                <c:pt idx="6">
                  <c:v>8</c:v>
                </c:pt>
                <c:pt idx="7">
                  <c:v>11</c:v>
                </c:pt>
                <c:pt idx="8">
                  <c:v>10.1</c:v>
                </c:pt>
                <c:pt idx="9">
                  <c:v>10.8</c:v>
                </c:pt>
                <c:pt idx="10">
                  <c:v>9.6</c:v>
                </c:pt>
                <c:pt idx="11">
                  <c:v>9</c:v>
                </c:pt>
                <c:pt idx="12">
                  <c:v>11.6</c:v>
                </c:pt>
                <c:pt idx="13">
                  <c:v>7.8</c:v>
                </c:pt>
                <c:pt idx="14">
                  <c:v>10.5</c:v>
                </c:pt>
                <c:pt idx="15">
                  <c:v>9.5</c:v>
                </c:pt>
                <c:pt idx="16">
                  <c:v>10</c:v>
                </c:pt>
                <c:pt idx="17">
                  <c:v>12</c:v>
                </c:pt>
                <c:pt idx="18">
                  <c:v>7.1</c:v>
                </c:pt>
                <c:pt idx="19">
                  <c:v>6.6</c:v>
                </c:pt>
                <c:pt idx="20">
                  <c:v>6.6</c:v>
                </c:pt>
                <c:pt idx="21">
                  <c:v>7.2</c:v>
                </c:pt>
                <c:pt idx="22">
                  <c:v>7.5</c:v>
                </c:pt>
                <c:pt idx="23">
                  <c:v>8</c:v>
                </c:pt>
                <c:pt idx="24">
                  <c:v>6.9</c:v>
                </c:pt>
                <c:pt idx="25">
                  <c:v>9.1999999999999993</c:v>
                </c:pt>
                <c:pt idx="26">
                  <c:v>11.3</c:v>
                </c:pt>
                <c:pt idx="27">
                  <c:v>10.9</c:v>
                </c:pt>
                <c:pt idx="28">
                  <c:v>14.2</c:v>
                </c:pt>
                <c:pt idx="29">
                  <c:v>14</c:v>
                </c:pt>
                <c:pt idx="30">
                  <c:v>13.4</c:v>
                </c:pt>
                <c:pt idx="31">
                  <c:v>11</c:v>
                </c:pt>
                <c:pt idx="32">
                  <c:v>8.5</c:v>
                </c:pt>
                <c:pt idx="33">
                  <c:v>5</c:v>
                </c:pt>
                <c:pt idx="34">
                  <c:v>13.7</c:v>
                </c:pt>
                <c:pt idx="35">
                  <c:v>13.6</c:v>
                </c:pt>
                <c:pt idx="36">
                  <c:v>8.4</c:v>
                </c:pt>
                <c:pt idx="37">
                  <c:v>12</c:v>
                </c:pt>
                <c:pt idx="38">
                  <c:v>11.7</c:v>
                </c:pt>
                <c:pt idx="39">
                  <c:v>9.8000000000000007</c:v>
                </c:pt>
                <c:pt idx="40">
                  <c:v>10.4</c:v>
                </c:pt>
                <c:pt idx="41">
                  <c:v>11</c:v>
                </c:pt>
                <c:pt idx="42">
                  <c:v>6.9</c:v>
                </c:pt>
                <c:pt idx="43">
                  <c:v>10.3</c:v>
                </c:pt>
                <c:pt idx="44">
                  <c:v>8.9</c:v>
                </c:pt>
                <c:pt idx="45">
                  <c:v>11.8</c:v>
                </c:pt>
                <c:pt idx="46">
                  <c:v>14.2</c:v>
                </c:pt>
                <c:pt idx="47">
                  <c:v>12.6</c:v>
                </c:pt>
                <c:pt idx="48">
                  <c:v>8.6</c:v>
                </c:pt>
                <c:pt idx="49">
                  <c:v>8.6</c:v>
                </c:pt>
                <c:pt idx="50">
                  <c:v>13.4</c:v>
                </c:pt>
                <c:pt idx="51">
                  <c:v>13.5</c:v>
                </c:pt>
                <c:pt idx="52">
                  <c:v>9.4</c:v>
                </c:pt>
                <c:pt idx="53">
                  <c:v>9.6</c:v>
                </c:pt>
                <c:pt idx="54">
                  <c:v>11.3</c:v>
                </c:pt>
                <c:pt idx="55">
                  <c:v>12</c:v>
                </c:pt>
                <c:pt idx="56">
                  <c:v>11.8</c:v>
                </c:pt>
                <c:pt idx="57">
                  <c:v>11.2</c:v>
                </c:pt>
                <c:pt idx="58">
                  <c:v>8.4</c:v>
                </c:pt>
              </c:numCache>
            </c:numRef>
          </c:val>
          <c:smooth val="0"/>
        </c:ser>
        <c:ser>
          <c:idx val="1"/>
          <c:order val="1"/>
          <c:tx>
            <c:strRef>
              <c:f>ims_data!$E$1</c:f>
              <c:strCache>
                <c:ptCount val="1"/>
                <c:pt idx="0">
                  <c:v>Day max</c:v>
                </c:pt>
              </c:strCache>
            </c:strRef>
          </c:tx>
          <c:spPr>
            <a:ln w="12700"/>
          </c:spPr>
          <c:marker>
            <c:symbol val="square"/>
            <c:size val="2"/>
          </c:marker>
          <c:cat>
            <c:numRef>
              <c:f>ims_data!$C$2:$C$60</c:f>
              <c:numCache>
                <c:formatCode>m/d/yyyy</c:formatCode>
                <c:ptCount val="59"/>
                <c:pt idx="0">
                  <c:v>40544</c:v>
                </c:pt>
                <c:pt idx="1">
                  <c:v>40545</c:v>
                </c:pt>
                <c:pt idx="2">
                  <c:v>40546</c:v>
                </c:pt>
                <c:pt idx="3">
                  <c:v>40547</c:v>
                </c:pt>
                <c:pt idx="4">
                  <c:v>40548</c:v>
                </c:pt>
                <c:pt idx="5">
                  <c:v>40549</c:v>
                </c:pt>
                <c:pt idx="6">
                  <c:v>40550</c:v>
                </c:pt>
                <c:pt idx="7">
                  <c:v>40551</c:v>
                </c:pt>
                <c:pt idx="8">
                  <c:v>40552</c:v>
                </c:pt>
                <c:pt idx="9">
                  <c:v>40553</c:v>
                </c:pt>
                <c:pt idx="10">
                  <c:v>40554</c:v>
                </c:pt>
                <c:pt idx="11">
                  <c:v>40555</c:v>
                </c:pt>
                <c:pt idx="12">
                  <c:v>40556</c:v>
                </c:pt>
                <c:pt idx="13">
                  <c:v>40557</c:v>
                </c:pt>
                <c:pt idx="14">
                  <c:v>40558</c:v>
                </c:pt>
                <c:pt idx="15">
                  <c:v>40559</c:v>
                </c:pt>
                <c:pt idx="16">
                  <c:v>40560</c:v>
                </c:pt>
                <c:pt idx="17">
                  <c:v>40561</c:v>
                </c:pt>
                <c:pt idx="18">
                  <c:v>40562</c:v>
                </c:pt>
                <c:pt idx="19">
                  <c:v>40563</c:v>
                </c:pt>
                <c:pt idx="20">
                  <c:v>40564</c:v>
                </c:pt>
                <c:pt idx="21">
                  <c:v>40565</c:v>
                </c:pt>
                <c:pt idx="22">
                  <c:v>40566</c:v>
                </c:pt>
                <c:pt idx="23">
                  <c:v>40567</c:v>
                </c:pt>
                <c:pt idx="24">
                  <c:v>40568</c:v>
                </c:pt>
                <c:pt idx="25">
                  <c:v>40569</c:v>
                </c:pt>
                <c:pt idx="26">
                  <c:v>40570</c:v>
                </c:pt>
                <c:pt idx="27">
                  <c:v>40571</c:v>
                </c:pt>
                <c:pt idx="28">
                  <c:v>40572</c:v>
                </c:pt>
                <c:pt idx="29">
                  <c:v>40573</c:v>
                </c:pt>
                <c:pt idx="30">
                  <c:v>40574</c:v>
                </c:pt>
                <c:pt idx="31">
                  <c:v>40575</c:v>
                </c:pt>
                <c:pt idx="32">
                  <c:v>40576</c:v>
                </c:pt>
                <c:pt idx="33">
                  <c:v>40577</c:v>
                </c:pt>
                <c:pt idx="34">
                  <c:v>40578</c:v>
                </c:pt>
                <c:pt idx="35">
                  <c:v>40579</c:v>
                </c:pt>
                <c:pt idx="36">
                  <c:v>40580</c:v>
                </c:pt>
                <c:pt idx="37">
                  <c:v>40581</c:v>
                </c:pt>
                <c:pt idx="38">
                  <c:v>40582</c:v>
                </c:pt>
                <c:pt idx="39">
                  <c:v>40583</c:v>
                </c:pt>
                <c:pt idx="40">
                  <c:v>40584</c:v>
                </c:pt>
                <c:pt idx="41">
                  <c:v>40585</c:v>
                </c:pt>
                <c:pt idx="42">
                  <c:v>40586</c:v>
                </c:pt>
                <c:pt idx="43">
                  <c:v>40587</c:v>
                </c:pt>
                <c:pt idx="44">
                  <c:v>40588</c:v>
                </c:pt>
                <c:pt idx="45">
                  <c:v>40589</c:v>
                </c:pt>
                <c:pt idx="46">
                  <c:v>40590</c:v>
                </c:pt>
                <c:pt idx="47">
                  <c:v>40591</c:v>
                </c:pt>
                <c:pt idx="48">
                  <c:v>40592</c:v>
                </c:pt>
                <c:pt idx="49">
                  <c:v>40593</c:v>
                </c:pt>
                <c:pt idx="50">
                  <c:v>40594</c:v>
                </c:pt>
                <c:pt idx="51">
                  <c:v>40595</c:v>
                </c:pt>
                <c:pt idx="52">
                  <c:v>40596</c:v>
                </c:pt>
                <c:pt idx="53">
                  <c:v>40597</c:v>
                </c:pt>
                <c:pt idx="54">
                  <c:v>40598</c:v>
                </c:pt>
                <c:pt idx="55">
                  <c:v>40599</c:v>
                </c:pt>
                <c:pt idx="56">
                  <c:v>40600</c:v>
                </c:pt>
                <c:pt idx="57">
                  <c:v>40601</c:v>
                </c:pt>
                <c:pt idx="58">
                  <c:v>40602</c:v>
                </c:pt>
              </c:numCache>
            </c:numRef>
          </c:cat>
          <c:val>
            <c:numRef>
              <c:f>ims_data!$E$2:$E$60</c:f>
              <c:numCache>
                <c:formatCode>General</c:formatCode>
                <c:ptCount val="59"/>
                <c:pt idx="0">
                  <c:v>18.3</c:v>
                </c:pt>
                <c:pt idx="1">
                  <c:v>20.9</c:v>
                </c:pt>
                <c:pt idx="2">
                  <c:v>21.8</c:v>
                </c:pt>
                <c:pt idx="3">
                  <c:v>18.2</c:v>
                </c:pt>
                <c:pt idx="4">
                  <c:v>18.5</c:v>
                </c:pt>
                <c:pt idx="5">
                  <c:v>19.2</c:v>
                </c:pt>
                <c:pt idx="6">
                  <c:v>20</c:v>
                </c:pt>
                <c:pt idx="7">
                  <c:v>17.5</c:v>
                </c:pt>
                <c:pt idx="8">
                  <c:v>18</c:v>
                </c:pt>
                <c:pt idx="9">
                  <c:v>19</c:v>
                </c:pt>
                <c:pt idx="10">
                  <c:v>20.7</c:v>
                </c:pt>
                <c:pt idx="11">
                  <c:v>21.7</c:v>
                </c:pt>
                <c:pt idx="12">
                  <c:v>21.5</c:v>
                </c:pt>
                <c:pt idx="13">
                  <c:v>20.100000000000001</c:v>
                </c:pt>
                <c:pt idx="14">
                  <c:v>17.100000000000001</c:v>
                </c:pt>
                <c:pt idx="15">
                  <c:v>16.3</c:v>
                </c:pt>
                <c:pt idx="16">
                  <c:v>21.8</c:v>
                </c:pt>
                <c:pt idx="17">
                  <c:v>20.2</c:v>
                </c:pt>
                <c:pt idx="18">
                  <c:v>20.100000000000001</c:v>
                </c:pt>
                <c:pt idx="19">
                  <c:v>20</c:v>
                </c:pt>
                <c:pt idx="20">
                  <c:v>21.6</c:v>
                </c:pt>
                <c:pt idx="21">
                  <c:v>21.6</c:v>
                </c:pt>
                <c:pt idx="22">
                  <c:v>20.9</c:v>
                </c:pt>
                <c:pt idx="23">
                  <c:v>19.8</c:v>
                </c:pt>
                <c:pt idx="24">
                  <c:v>18.600000000000001</c:v>
                </c:pt>
                <c:pt idx="25">
                  <c:v>18.5</c:v>
                </c:pt>
                <c:pt idx="26">
                  <c:v>24</c:v>
                </c:pt>
                <c:pt idx="27">
                  <c:v>21.1</c:v>
                </c:pt>
                <c:pt idx="28">
                  <c:v>24.1</c:v>
                </c:pt>
                <c:pt idx="29">
                  <c:v>18.600000000000001</c:v>
                </c:pt>
                <c:pt idx="30">
                  <c:v>18</c:v>
                </c:pt>
                <c:pt idx="31">
                  <c:v>17.2</c:v>
                </c:pt>
                <c:pt idx="32">
                  <c:v>15.4</c:v>
                </c:pt>
                <c:pt idx="33">
                  <c:v>15.4</c:v>
                </c:pt>
                <c:pt idx="34">
                  <c:v>18.100000000000001</c:v>
                </c:pt>
                <c:pt idx="35">
                  <c:v>18.600000000000001</c:v>
                </c:pt>
                <c:pt idx="36">
                  <c:v>20.9</c:v>
                </c:pt>
                <c:pt idx="37">
                  <c:v>18.100000000000001</c:v>
                </c:pt>
                <c:pt idx="38">
                  <c:v>20</c:v>
                </c:pt>
                <c:pt idx="39">
                  <c:v>20</c:v>
                </c:pt>
                <c:pt idx="40">
                  <c:v>16.600000000000001</c:v>
                </c:pt>
                <c:pt idx="41">
                  <c:v>18.899999999999999</c:v>
                </c:pt>
                <c:pt idx="42">
                  <c:v>19.100000000000001</c:v>
                </c:pt>
                <c:pt idx="43">
                  <c:v>18.600000000000001</c:v>
                </c:pt>
                <c:pt idx="44">
                  <c:v>19.8</c:v>
                </c:pt>
                <c:pt idx="45">
                  <c:v>23.9</c:v>
                </c:pt>
                <c:pt idx="46">
                  <c:v>19.2</c:v>
                </c:pt>
                <c:pt idx="47">
                  <c:v>21.2</c:v>
                </c:pt>
                <c:pt idx="48">
                  <c:v>23.4</c:v>
                </c:pt>
                <c:pt idx="49">
                  <c:v>26.4</c:v>
                </c:pt>
                <c:pt idx="50">
                  <c:v>19.100000000000001</c:v>
                </c:pt>
                <c:pt idx="51">
                  <c:v>19.3</c:v>
                </c:pt>
                <c:pt idx="52">
                  <c:v>22.3</c:v>
                </c:pt>
                <c:pt idx="53">
                  <c:v>24.9</c:v>
                </c:pt>
                <c:pt idx="54">
                  <c:v>25.1</c:v>
                </c:pt>
                <c:pt idx="55">
                  <c:v>20.8</c:v>
                </c:pt>
                <c:pt idx="56">
                  <c:v>20</c:v>
                </c:pt>
                <c:pt idx="57">
                  <c:v>20.8</c:v>
                </c:pt>
                <c:pt idx="58">
                  <c:v>20.100000000000001</c:v>
                </c:pt>
              </c:numCache>
            </c:numRef>
          </c:val>
          <c:smooth val="0"/>
        </c:ser>
        <c:dLbls>
          <c:showLegendKey val="0"/>
          <c:showVal val="0"/>
          <c:showCatName val="0"/>
          <c:showSerName val="0"/>
          <c:showPercent val="0"/>
          <c:showBubbleSize val="0"/>
        </c:dLbls>
        <c:marker val="1"/>
        <c:smooth val="0"/>
        <c:axId val="198428544"/>
        <c:axId val="198430720"/>
      </c:lineChart>
      <c:dateAx>
        <c:axId val="198428544"/>
        <c:scaling>
          <c:orientation val="minMax"/>
        </c:scaling>
        <c:delete val="0"/>
        <c:axPos val="b"/>
        <c:title>
          <c:tx>
            <c:rich>
              <a:bodyPr/>
              <a:lstStyle/>
              <a:p>
                <a:pPr>
                  <a:defRPr/>
                </a:pPr>
                <a:r>
                  <a:rPr lang="en-US"/>
                  <a:t>Date</a:t>
                </a:r>
              </a:p>
            </c:rich>
          </c:tx>
          <c:layout/>
          <c:overlay val="0"/>
        </c:title>
        <c:numFmt formatCode="m/d/yyyy" sourceLinked="1"/>
        <c:majorTickMark val="out"/>
        <c:minorTickMark val="none"/>
        <c:tickLblPos val="nextTo"/>
        <c:crossAx val="198430720"/>
        <c:crosses val="autoZero"/>
        <c:auto val="1"/>
        <c:lblOffset val="100"/>
        <c:baseTimeUnit val="days"/>
        <c:majorUnit val="3"/>
        <c:majorTimeUnit val="days"/>
      </c:dateAx>
      <c:valAx>
        <c:axId val="198430720"/>
        <c:scaling>
          <c:orientation val="minMax"/>
        </c:scaling>
        <c:delete val="0"/>
        <c:axPos val="l"/>
        <c:majorGridlines/>
        <c:title>
          <c:tx>
            <c:rich>
              <a:bodyPr rot="-5400000" vert="horz"/>
              <a:lstStyle/>
              <a:p>
                <a:pPr>
                  <a:defRPr sz="1100" baseline="30000">
                    <a:latin typeface="Calibri" panose="020F0502020204030204" pitchFamily="34" charset="0"/>
                  </a:defRPr>
                </a:pPr>
                <a:r>
                  <a:rPr lang="en-US" sz="1100" baseline="30000">
                    <a:latin typeface="Calibri" panose="020F0502020204030204" pitchFamily="34" charset="0"/>
                  </a:rPr>
                  <a:t>Temperature (oC)</a:t>
                </a:r>
              </a:p>
            </c:rich>
          </c:tx>
          <c:layout/>
          <c:overlay val="0"/>
        </c:title>
        <c:numFmt formatCode="General" sourceLinked="1"/>
        <c:majorTickMark val="out"/>
        <c:minorTickMark val="none"/>
        <c:tickLblPos val="nextTo"/>
        <c:crossAx val="198428544"/>
        <c:crosses val="autoZero"/>
        <c:crossBetween val="between"/>
      </c:valAx>
    </c:plotArea>
    <c:legend>
      <c:legendPos val="l"/>
      <c:layout>
        <c:manualLayout>
          <c:xMode val="edge"/>
          <c:yMode val="edge"/>
          <c:x val="0.24612480886270729"/>
          <c:y val="5.2465995841731873E-2"/>
          <c:w val="0.16073622047244093"/>
          <c:h val="0.14506780402449693"/>
        </c:manualLayout>
      </c:layout>
      <c:overlay val="0"/>
      <c:spPr>
        <a:solidFill>
          <a:schemeClr val="bg1"/>
        </a:solidFill>
      </c:spPr>
      <c:txPr>
        <a:bodyPr/>
        <a:lstStyle/>
        <a:p>
          <a:pPr>
            <a:defRPr sz="800"/>
          </a:pPr>
          <a:endParaRPr lang="he-IL"/>
        </a:p>
      </c:txPr>
    </c:legend>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strRef>
              <c:f>'BD summer 7-9-2011'!$W$1</c:f>
              <c:strCache>
                <c:ptCount val="1"/>
                <c:pt idx="0">
                  <c:v>Day min</c:v>
                </c:pt>
              </c:strCache>
            </c:strRef>
          </c:tx>
          <c:spPr>
            <a:ln w="12700"/>
          </c:spPr>
          <c:marker>
            <c:symbol val="diamond"/>
            <c:size val="3"/>
          </c:marker>
          <c:cat>
            <c:strRef>
              <c:f>'BD summer 7-9-2011'!$V$2:$V$100</c:f>
              <c:strCache>
                <c:ptCount val="99"/>
                <c:pt idx="0">
                  <c:v>21/06/2011</c:v>
                </c:pt>
                <c:pt idx="1">
                  <c:v>22/06/2011</c:v>
                </c:pt>
                <c:pt idx="2">
                  <c:v>23/06/2011</c:v>
                </c:pt>
                <c:pt idx="3">
                  <c:v>24/06/2011</c:v>
                </c:pt>
                <c:pt idx="4">
                  <c:v>25/06/2011</c:v>
                </c:pt>
                <c:pt idx="5">
                  <c:v>26/06/2011</c:v>
                </c:pt>
                <c:pt idx="6">
                  <c:v>27/06/2011</c:v>
                </c:pt>
                <c:pt idx="7">
                  <c:v>28/06/2011</c:v>
                </c:pt>
                <c:pt idx="8">
                  <c:v>29/06/2011</c:v>
                </c:pt>
                <c:pt idx="9">
                  <c:v>30/06/2011</c:v>
                </c:pt>
                <c:pt idx="10">
                  <c:v>01/07/2011</c:v>
                </c:pt>
                <c:pt idx="11">
                  <c:v>02/07/2011</c:v>
                </c:pt>
                <c:pt idx="12">
                  <c:v>03/07/2011</c:v>
                </c:pt>
                <c:pt idx="13">
                  <c:v>04/07/2011</c:v>
                </c:pt>
                <c:pt idx="14">
                  <c:v>05/07/2011</c:v>
                </c:pt>
                <c:pt idx="15">
                  <c:v>06/07/2011</c:v>
                </c:pt>
                <c:pt idx="16">
                  <c:v>07/07/2011</c:v>
                </c:pt>
                <c:pt idx="17">
                  <c:v>08/07/2011</c:v>
                </c:pt>
                <c:pt idx="18">
                  <c:v>09/07/2011</c:v>
                </c:pt>
                <c:pt idx="19">
                  <c:v>10/07/2011</c:v>
                </c:pt>
                <c:pt idx="20">
                  <c:v>11/07/2011</c:v>
                </c:pt>
                <c:pt idx="21">
                  <c:v>12/07/2011</c:v>
                </c:pt>
                <c:pt idx="22">
                  <c:v>13/07/2011</c:v>
                </c:pt>
                <c:pt idx="23">
                  <c:v>14/07/2011</c:v>
                </c:pt>
                <c:pt idx="24">
                  <c:v>15/07/2011</c:v>
                </c:pt>
                <c:pt idx="25">
                  <c:v>16/07/2011</c:v>
                </c:pt>
                <c:pt idx="26">
                  <c:v>17/07/2011</c:v>
                </c:pt>
                <c:pt idx="27">
                  <c:v>18/07/2011</c:v>
                </c:pt>
                <c:pt idx="28">
                  <c:v>19/07/2011</c:v>
                </c:pt>
                <c:pt idx="29">
                  <c:v>20/07/2011</c:v>
                </c:pt>
                <c:pt idx="30">
                  <c:v>21/07/2011</c:v>
                </c:pt>
                <c:pt idx="31">
                  <c:v>22/07/2011</c:v>
                </c:pt>
                <c:pt idx="32">
                  <c:v>23/07/2011</c:v>
                </c:pt>
                <c:pt idx="33">
                  <c:v>24/07/2011</c:v>
                </c:pt>
                <c:pt idx="34">
                  <c:v>25/07/2011</c:v>
                </c:pt>
                <c:pt idx="35">
                  <c:v>26/07/2011</c:v>
                </c:pt>
                <c:pt idx="36">
                  <c:v>27/07/2011</c:v>
                </c:pt>
                <c:pt idx="37">
                  <c:v>28/07/2011</c:v>
                </c:pt>
                <c:pt idx="38">
                  <c:v>29/07/2011</c:v>
                </c:pt>
                <c:pt idx="39">
                  <c:v>30/07/2011</c:v>
                </c:pt>
                <c:pt idx="40">
                  <c:v>31/07/2011</c:v>
                </c:pt>
                <c:pt idx="41">
                  <c:v>01/08/2011</c:v>
                </c:pt>
                <c:pt idx="42">
                  <c:v>02/08/2011</c:v>
                </c:pt>
                <c:pt idx="43">
                  <c:v>03/08/2011</c:v>
                </c:pt>
                <c:pt idx="44">
                  <c:v>04/08/2011</c:v>
                </c:pt>
                <c:pt idx="45">
                  <c:v>05/08/2011</c:v>
                </c:pt>
                <c:pt idx="46">
                  <c:v>06/08/2011</c:v>
                </c:pt>
                <c:pt idx="47">
                  <c:v>07/08/2011</c:v>
                </c:pt>
                <c:pt idx="48">
                  <c:v>08/08/2011</c:v>
                </c:pt>
                <c:pt idx="49">
                  <c:v>09/08/2011</c:v>
                </c:pt>
                <c:pt idx="50">
                  <c:v>10/08/2011</c:v>
                </c:pt>
                <c:pt idx="51">
                  <c:v>11/08/2011</c:v>
                </c:pt>
                <c:pt idx="52">
                  <c:v>12/08/2011</c:v>
                </c:pt>
                <c:pt idx="53">
                  <c:v>13/08/2011</c:v>
                </c:pt>
                <c:pt idx="54">
                  <c:v>14/08/2011</c:v>
                </c:pt>
                <c:pt idx="55">
                  <c:v>15/08/2011</c:v>
                </c:pt>
                <c:pt idx="56">
                  <c:v>16/08/2011</c:v>
                </c:pt>
                <c:pt idx="57">
                  <c:v>17/08/2011</c:v>
                </c:pt>
                <c:pt idx="58">
                  <c:v>18/08/2011</c:v>
                </c:pt>
                <c:pt idx="59">
                  <c:v>19/08/2011</c:v>
                </c:pt>
                <c:pt idx="60">
                  <c:v>20/08/2011</c:v>
                </c:pt>
                <c:pt idx="61">
                  <c:v>21/08/2011</c:v>
                </c:pt>
                <c:pt idx="62">
                  <c:v>22/08/2011</c:v>
                </c:pt>
                <c:pt idx="63">
                  <c:v>23/08/2011</c:v>
                </c:pt>
                <c:pt idx="64">
                  <c:v>24/08/2011</c:v>
                </c:pt>
                <c:pt idx="65">
                  <c:v>25/08/2011</c:v>
                </c:pt>
                <c:pt idx="66">
                  <c:v>26/08/2011</c:v>
                </c:pt>
                <c:pt idx="67">
                  <c:v>27/08/2011</c:v>
                </c:pt>
                <c:pt idx="68">
                  <c:v>28/08/2011</c:v>
                </c:pt>
                <c:pt idx="69">
                  <c:v>29/08/2011</c:v>
                </c:pt>
                <c:pt idx="70">
                  <c:v>30/08/2011</c:v>
                </c:pt>
                <c:pt idx="71">
                  <c:v>31/08/2011</c:v>
                </c:pt>
                <c:pt idx="72">
                  <c:v>01/09/2011</c:v>
                </c:pt>
                <c:pt idx="73">
                  <c:v>02/09/2011</c:v>
                </c:pt>
                <c:pt idx="74">
                  <c:v>03/09/2011</c:v>
                </c:pt>
                <c:pt idx="75">
                  <c:v>04/09/2011</c:v>
                </c:pt>
                <c:pt idx="76">
                  <c:v>05/09/2011</c:v>
                </c:pt>
                <c:pt idx="77">
                  <c:v>06/09/2011</c:v>
                </c:pt>
                <c:pt idx="78">
                  <c:v>07/09/2011</c:v>
                </c:pt>
                <c:pt idx="79">
                  <c:v>08/09/2011</c:v>
                </c:pt>
                <c:pt idx="80">
                  <c:v>09/09/2011</c:v>
                </c:pt>
                <c:pt idx="81">
                  <c:v>10/09/2011</c:v>
                </c:pt>
                <c:pt idx="82">
                  <c:v>11/09/2011</c:v>
                </c:pt>
                <c:pt idx="83">
                  <c:v>12/09/2011</c:v>
                </c:pt>
                <c:pt idx="84">
                  <c:v>13/09/2011</c:v>
                </c:pt>
                <c:pt idx="85">
                  <c:v>14/09/2011</c:v>
                </c:pt>
                <c:pt idx="86">
                  <c:v>15/09/2011</c:v>
                </c:pt>
                <c:pt idx="87">
                  <c:v>16/09/2011</c:v>
                </c:pt>
                <c:pt idx="88">
                  <c:v>17/09/2011</c:v>
                </c:pt>
                <c:pt idx="89">
                  <c:v>18/09/2011</c:v>
                </c:pt>
                <c:pt idx="90">
                  <c:v>19/09/2011</c:v>
                </c:pt>
                <c:pt idx="91">
                  <c:v>20/09/2011</c:v>
                </c:pt>
                <c:pt idx="92">
                  <c:v>21/09/2011</c:v>
                </c:pt>
                <c:pt idx="93">
                  <c:v>22/09/2011</c:v>
                </c:pt>
                <c:pt idx="94">
                  <c:v>23/09/2011</c:v>
                </c:pt>
                <c:pt idx="95">
                  <c:v>24/09/2011</c:v>
                </c:pt>
                <c:pt idx="96">
                  <c:v>25/09/2011</c:v>
                </c:pt>
                <c:pt idx="97">
                  <c:v>26/09/2011</c:v>
                </c:pt>
                <c:pt idx="98">
                  <c:v>27/09/2011</c:v>
                </c:pt>
              </c:strCache>
            </c:strRef>
          </c:cat>
          <c:val>
            <c:numRef>
              <c:f>'BD summer 7-9-2011'!$W$2:$W$100</c:f>
              <c:numCache>
                <c:formatCode>General</c:formatCode>
                <c:ptCount val="99"/>
                <c:pt idx="0">
                  <c:v>22.3</c:v>
                </c:pt>
                <c:pt idx="1">
                  <c:v>22.2</c:v>
                </c:pt>
                <c:pt idx="2">
                  <c:v>23.1</c:v>
                </c:pt>
                <c:pt idx="3">
                  <c:v>22.7</c:v>
                </c:pt>
                <c:pt idx="4">
                  <c:v>21.7</c:v>
                </c:pt>
                <c:pt idx="5">
                  <c:v>22.1</c:v>
                </c:pt>
                <c:pt idx="6">
                  <c:v>19.600000000000001</c:v>
                </c:pt>
                <c:pt idx="7">
                  <c:v>21</c:v>
                </c:pt>
                <c:pt idx="8">
                  <c:v>22.8</c:v>
                </c:pt>
                <c:pt idx="9">
                  <c:v>20.6</c:v>
                </c:pt>
                <c:pt idx="10">
                  <c:v>20.8</c:v>
                </c:pt>
                <c:pt idx="11">
                  <c:v>20.3</c:v>
                </c:pt>
                <c:pt idx="12">
                  <c:v>20.2</c:v>
                </c:pt>
                <c:pt idx="13">
                  <c:v>21.4</c:v>
                </c:pt>
                <c:pt idx="14">
                  <c:v>20.6</c:v>
                </c:pt>
                <c:pt idx="15">
                  <c:v>20.7</c:v>
                </c:pt>
                <c:pt idx="16">
                  <c:v>22.1</c:v>
                </c:pt>
                <c:pt idx="17">
                  <c:v>22.9</c:v>
                </c:pt>
                <c:pt idx="18">
                  <c:v>23.1</c:v>
                </c:pt>
                <c:pt idx="19">
                  <c:v>22.7</c:v>
                </c:pt>
                <c:pt idx="20">
                  <c:v>21.4</c:v>
                </c:pt>
                <c:pt idx="21">
                  <c:v>23.6</c:v>
                </c:pt>
                <c:pt idx="22">
                  <c:v>23.2</c:v>
                </c:pt>
                <c:pt idx="23">
                  <c:v>21.8</c:v>
                </c:pt>
                <c:pt idx="24">
                  <c:v>21</c:v>
                </c:pt>
                <c:pt idx="25">
                  <c:v>23.9</c:v>
                </c:pt>
                <c:pt idx="26">
                  <c:v>23.9</c:v>
                </c:pt>
                <c:pt idx="27">
                  <c:v>24.6</c:v>
                </c:pt>
                <c:pt idx="28">
                  <c:v>24.3</c:v>
                </c:pt>
                <c:pt idx="29">
                  <c:v>23.2</c:v>
                </c:pt>
                <c:pt idx="30">
                  <c:v>22.8</c:v>
                </c:pt>
                <c:pt idx="31">
                  <c:v>22.4</c:v>
                </c:pt>
                <c:pt idx="32">
                  <c:v>24.3</c:v>
                </c:pt>
                <c:pt idx="33">
                  <c:v>24.3</c:v>
                </c:pt>
                <c:pt idx="34">
                  <c:v>24.2</c:v>
                </c:pt>
                <c:pt idx="35">
                  <c:v>26.2</c:v>
                </c:pt>
                <c:pt idx="36">
                  <c:v>25</c:v>
                </c:pt>
                <c:pt idx="37">
                  <c:v>25</c:v>
                </c:pt>
                <c:pt idx="38">
                  <c:v>23.6</c:v>
                </c:pt>
                <c:pt idx="39">
                  <c:v>24.4</c:v>
                </c:pt>
                <c:pt idx="40">
                  <c:v>25.9</c:v>
                </c:pt>
                <c:pt idx="41">
                  <c:v>25.4</c:v>
                </c:pt>
                <c:pt idx="42">
                  <c:v>24</c:v>
                </c:pt>
                <c:pt idx="43">
                  <c:v>24.8</c:v>
                </c:pt>
                <c:pt idx="44">
                  <c:v>24.2</c:v>
                </c:pt>
                <c:pt idx="45">
                  <c:v>24.5</c:v>
                </c:pt>
                <c:pt idx="46">
                  <c:v>24.5</c:v>
                </c:pt>
                <c:pt idx="47">
                  <c:v>24.8</c:v>
                </c:pt>
                <c:pt idx="48">
                  <c:v>24.2</c:v>
                </c:pt>
                <c:pt idx="49">
                  <c:v>24.8</c:v>
                </c:pt>
                <c:pt idx="50">
                  <c:v>25.4</c:v>
                </c:pt>
                <c:pt idx="51">
                  <c:v>24.6</c:v>
                </c:pt>
                <c:pt idx="52">
                  <c:v>24.7</c:v>
                </c:pt>
                <c:pt idx="53">
                  <c:v>24.7</c:v>
                </c:pt>
                <c:pt idx="54">
                  <c:v>24.4</c:v>
                </c:pt>
                <c:pt idx="55">
                  <c:v>22.6</c:v>
                </c:pt>
                <c:pt idx="56">
                  <c:v>22.6</c:v>
                </c:pt>
                <c:pt idx="57">
                  <c:v>23.2</c:v>
                </c:pt>
                <c:pt idx="58">
                  <c:v>23.2</c:v>
                </c:pt>
                <c:pt idx="59">
                  <c:v>22.7</c:v>
                </c:pt>
                <c:pt idx="60">
                  <c:v>22.3</c:v>
                </c:pt>
                <c:pt idx="61">
                  <c:v>23.2</c:v>
                </c:pt>
                <c:pt idx="62">
                  <c:v>23.4</c:v>
                </c:pt>
                <c:pt idx="63">
                  <c:v>22.1</c:v>
                </c:pt>
                <c:pt idx="64">
                  <c:v>23.8</c:v>
                </c:pt>
                <c:pt idx="65">
                  <c:v>23.9</c:v>
                </c:pt>
                <c:pt idx="66">
                  <c:v>22.1</c:v>
                </c:pt>
                <c:pt idx="67">
                  <c:v>23.5</c:v>
                </c:pt>
                <c:pt idx="68">
                  <c:v>23.6</c:v>
                </c:pt>
                <c:pt idx="69">
                  <c:v>22.8</c:v>
                </c:pt>
                <c:pt idx="70">
                  <c:v>21.3</c:v>
                </c:pt>
                <c:pt idx="71">
                  <c:v>22.7</c:v>
                </c:pt>
                <c:pt idx="72">
                  <c:v>23.8</c:v>
                </c:pt>
                <c:pt idx="73">
                  <c:v>22.8</c:v>
                </c:pt>
                <c:pt idx="74">
                  <c:v>21.6</c:v>
                </c:pt>
                <c:pt idx="75">
                  <c:v>18.600000000000001</c:v>
                </c:pt>
                <c:pt idx="76">
                  <c:v>21.1</c:v>
                </c:pt>
                <c:pt idx="77">
                  <c:v>24.8</c:v>
                </c:pt>
                <c:pt idx="78">
                  <c:v>23.7</c:v>
                </c:pt>
                <c:pt idx="79">
                  <c:v>21.7</c:v>
                </c:pt>
                <c:pt idx="80">
                  <c:v>21.6</c:v>
                </c:pt>
                <c:pt idx="81">
                  <c:v>22.3</c:v>
                </c:pt>
                <c:pt idx="82">
                  <c:v>22.2</c:v>
                </c:pt>
                <c:pt idx="83">
                  <c:v>23.2</c:v>
                </c:pt>
                <c:pt idx="84">
                  <c:v>23.3</c:v>
                </c:pt>
                <c:pt idx="85">
                  <c:v>22.4</c:v>
                </c:pt>
                <c:pt idx="86">
                  <c:v>22.1</c:v>
                </c:pt>
                <c:pt idx="87">
                  <c:v>21.7</c:v>
                </c:pt>
                <c:pt idx="88">
                  <c:v>21</c:v>
                </c:pt>
                <c:pt idx="89">
                  <c:v>19.8</c:v>
                </c:pt>
                <c:pt idx="90">
                  <c:v>22.7</c:v>
                </c:pt>
                <c:pt idx="91">
                  <c:v>22.4</c:v>
                </c:pt>
                <c:pt idx="92">
                  <c:v>22</c:v>
                </c:pt>
                <c:pt idx="93">
                  <c:v>21.7</c:v>
                </c:pt>
                <c:pt idx="94">
                  <c:v>21.4</c:v>
                </c:pt>
                <c:pt idx="95">
                  <c:v>22.1</c:v>
                </c:pt>
                <c:pt idx="96">
                  <c:v>21.3</c:v>
                </c:pt>
                <c:pt idx="97">
                  <c:v>20.2</c:v>
                </c:pt>
                <c:pt idx="98">
                  <c:v>20.3</c:v>
                </c:pt>
              </c:numCache>
            </c:numRef>
          </c:val>
          <c:smooth val="0"/>
        </c:ser>
        <c:ser>
          <c:idx val="1"/>
          <c:order val="1"/>
          <c:tx>
            <c:strRef>
              <c:f>'BD summer 7-9-2011'!$X$1</c:f>
              <c:strCache>
                <c:ptCount val="1"/>
                <c:pt idx="0">
                  <c:v>Day max</c:v>
                </c:pt>
              </c:strCache>
            </c:strRef>
          </c:tx>
          <c:spPr>
            <a:ln w="12700"/>
          </c:spPr>
          <c:marker>
            <c:symbol val="square"/>
            <c:size val="2"/>
          </c:marker>
          <c:cat>
            <c:strRef>
              <c:f>'BD summer 7-9-2011'!$V$2:$V$100</c:f>
              <c:strCache>
                <c:ptCount val="99"/>
                <c:pt idx="0">
                  <c:v>21/06/2011</c:v>
                </c:pt>
                <c:pt idx="1">
                  <c:v>22/06/2011</c:v>
                </c:pt>
                <c:pt idx="2">
                  <c:v>23/06/2011</c:v>
                </c:pt>
                <c:pt idx="3">
                  <c:v>24/06/2011</c:v>
                </c:pt>
                <c:pt idx="4">
                  <c:v>25/06/2011</c:v>
                </c:pt>
                <c:pt idx="5">
                  <c:v>26/06/2011</c:v>
                </c:pt>
                <c:pt idx="6">
                  <c:v>27/06/2011</c:v>
                </c:pt>
                <c:pt idx="7">
                  <c:v>28/06/2011</c:v>
                </c:pt>
                <c:pt idx="8">
                  <c:v>29/06/2011</c:v>
                </c:pt>
                <c:pt idx="9">
                  <c:v>30/06/2011</c:v>
                </c:pt>
                <c:pt idx="10">
                  <c:v>01/07/2011</c:v>
                </c:pt>
                <c:pt idx="11">
                  <c:v>02/07/2011</c:v>
                </c:pt>
                <c:pt idx="12">
                  <c:v>03/07/2011</c:v>
                </c:pt>
                <c:pt idx="13">
                  <c:v>04/07/2011</c:v>
                </c:pt>
                <c:pt idx="14">
                  <c:v>05/07/2011</c:v>
                </c:pt>
                <c:pt idx="15">
                  <c:v>06/07/2011</c:v>
                </c:pt>
                <c:pt idx="16">
                  <c:v>07/07/2011</c:v>
                </c:pt>
                <c:pt idx="17">
                  <c:v>08/07/2011</c:v>
                </c:pt>
                <c:pt idx="18">
                  <c:v>09/07/2011</c:v>
                </c:pt>
                <c:pt idx="19">
                  <c:v>10/07/2011</c:v>
                </c:pt>
                <c:pt idx="20">
                  <c:v>11/07/2011</c:v>
                </c:pt>
                <c:pt idx="21">
                  <c:v>12/07/2011</c:v>
                </c:pt>
                <c:pt idx="22">
                  <c:v>13/07/2011</c:v>
                </c:pt>
                <c:pt idx="23">
                  <c:v>14/07/2011</c:v>
                </c:pt>
                <c:pt idx="24">
                  <c:v>15/07/2011</c:v>
                </c:pt>
                <c:pt idx="25">
                  <c:v>16/07/2011</c:v>
                </c:pt>
                <c:pt idx="26">
                  <c:v>17/07/2011</c:v>
                </c:pt>
                <c:pt idx="27">
                  <c:v>18/07/2011</c:v>
                </c:pt>
                <c:pt idx="28">
                  <c:v>19/07/2011</c:v>
                </c:pt>
                <c:pt idx="29">
                  <c:v>20/07/2011</c:v>
                </c:pt>
                <c:pt idx="30">
                  <c:v>21/07/2011</c:v>
                </c:pt>
                <c:pt idx="31">
                  <c:v>22/07/2011</c:v>
                </c:pt>
                <c:pt idx="32">
                  <c:v>23/07/2011</c:v>
                </c:pt>
                <c:pt idx="33">
                  <c:v>24/07/2011</c:v>
                </c:pt>
                <c:pt idx="34">
                  <c:v>25/07/2011</c:v>
                </c:pt>
                <c:pt idx="35">
                  <c:v>26/07/2011</c:v>
                </c:pt>
                <c:pt idx="36">
                  <c:v>27/07/2011</c:v>
                </c:pt>
                <c:pt idx="37">
                  <c:v>28/07/2011</c:v>
                </c:pt>
                <c:pt idx="38">
                  <c:v>29/07/2011</c:v>
                </c:pt>
                <c:pt idx="39">
                  <c:v>30/07/2011</c:v>
                </c:pt>
                <c:pt idx="40">
                  <c:v>31/07/2011</c:v>
                </c:pt>
                <c:pt idx="41">
                  <c:v>01/08/2011</c:v>
                </c:pt>
                <c:pt idx="42">
                  <c:v>02/08/2011</c:v>
                </c:pt>
                <c:pt idx="43">
                  <c:v>03/08/2011</c:v>
                </c:pt>
                <c:pt idx="44">
                  <c:v>04/08/2011</c:v>
                </c:pt>
                <c:pt idx="45">
                  <c:v>05/08/2011</c:v>
                </c:pt>
                <c:pt idx="46">
                  <c:v>06/08/2011</c:v>
                </c:pt>
                <c:pt idx="47">
                  <c:v>07/08/2011</c:v>
                </c:pt>
                <c:pt idx="48">
                  <c:v>08/08/2011</c:v>
                </c:pt>
                <c:pt idx="49">
                  <c:v>09/08/2011</c:v>
                </c:pt>
                <c:pt idx="50">
                  <c:v>10/08/2011</c:v>
                </c:pt>
                <c:pt idx="51">
                  <c:v>11/08/2011</c:v>
                </c:pt>
                <c:pt idx="52">
                  <c:v>12/08/2011</c:v>
                </c:pt>
                <c:pt idx="53">
                  <c:v>13/08/2011</c:v>
                </c:pt>
                <c:pt idx="54">
                  <c:v>14/08/2011</c:v>
                </c:pt>
                <c:pt idx="55">
                  <c:v>15/08/2011</c:v>
                </c:pt>
                <c:pt idx="56">
                  <c:v>16/08/2011</c:v>
                </c:pt>
                <c:pt idx="57">
                  <c:v>17/08/2011</c:v>
                </c:pt>
                <c:pt idx="58">
                  <c:v>18/08/2011</c:v>
                </c:pt>
                <c:pt idx="59">
                  <c:v>19/08/2011</c:v>
                </c:pt>
                <c:pt idx="60">
                  <c:v>20/08/2011</c:v>
                </c:pt>
                <c:pt idx="61">
                  <c:v>21/08/2011</c:v>
                </c:pt>
                <c:pt idx="62">
                  <c:v>22/08/2011</c:v>
                </c:pt>
                <c:pt idx="63">
                  <c:v>23/08/2011</c:v>
                </c:pt>
                <c:pt idx="64">
                  <c:v>24/08/2011</c:v>
                </c:pt>
                <c:pt idx="65">
                  <c:v>25/08/2011</c:v>
                </c:pt>
                <c:pt idx="66">
                  <c:v>26/08/2011</c:v>
                </c:pt>
                <c:pt idx="67">
                  <c:v>27/08/2011</c:v>
                </c:pt>
                <c:pt idx="68">
                  <c:v>28/08/2011</c:v>
                </c:pt>
                <c:pt idx="69">
                  <c:v>29/08/2011</c:v>
                </c:pt>
                <c:pt idx="70">
                  <c:v>30/08/2011</c:v>
                </c:pt>
                <c:pt idx="71">
                  <c:v>31/08/2011</c:v>
                </c:pt>
                <c:pt idx="72">
                  <c:v>01/09/2011</c:v>
                </c:pt>
                <c:pt idx="73">
                  <c:v>02/09/2011</c:v>
                </c:pt>
                <c:pt idx="74">
                  <c:v>03/09/2011</c:v>
                </c:pt>
                <c:pt idx="75">
                  <c:v>04/09/2011</c:v>
                </c:pt>
                <c:pt idx="76">
                  <c:v>05/09/2011</c:v>
                </c:pt>
                <c:pt idx="77">
                  <c:v>06/09/2011</c:v>
                </c:pt>
                <c:pt idx="78">
                  <c:v>07/09/2011</c:v>
                </c:pt>
                <c:pt idx="79">
                  <c:v>08/09/2011</c:v>
                </c:pt>
                <c:pt idx="80">
                  <c:v>09/09/2011</c:v>
                </c:pt>
                <c:pt idx="81">
                  <c:v>10/09/2011</c:v>
                </c:pt>
                <c:pt idx="82">
                  <c:v>11/09/2011</c:v>
                </c:pt>
                <c:pt idx="83">
                  <c:v>12/09/2011</c:v>
                </c:pt>
                <c:pt idx="84">
                  <c:v>13/09/2011</c:v>
                </c:pt>
                <c:pt idx="85">
                  <c:v>14/09/2011</c:v>
                </c:pt>
                <c:pt idx="86">
                  <c:v>15/09/2011</c:v>
                </c:pt>
                <c:pt idx="87">
                  <c:v>16/09/2011</c:v>
                </c:pt>
                <c:pt idx="88">
                  <c:v>17/09/2011</c:v>
                </c:pt>
                <c:pt idx="89">
                  <c:v>18/09/2011</c:v>
                </c:pt>
                <c:pt idx="90">
                  <c:v>19/09/2011</c:v>
                </c:pt>
                <c:pt idx="91">
                  <c:v>20/09/2011</c:v>
                </c:pt>
                <c:pt idx="92">
                  <c:v>21/09/2011</c:v>
                </c:pt>
                <c:pt idx="93">
                  <c:v>22/09/2011</c:v>
                </c:pt>
                <c:pt idx="94">
                  <c:v>23/09/2011</c:v>
                </c:pt>
                <c:pt idx="95">
                  <c:v>24/09/2011</c:v>
                </c:pt>
                <c:pt idx="96">
                  <c:v>25/09/2011</c:v>
                </c:pt>
                <c:pt idx="97">
                  <c:v>26/09/2011</c:v>
                </c:pt>
                <c:pt idx="98">
                  <c:v>27/09/2011</c:v>
                </c:pt>
              </c:strCache>
            </c:strRef>
          </c:cat>
          <c:val>
            <c:numRef>
              <c:f>'BD summer 7-9-2011'!$X$2:$X$100</c:f>
              <c:numCache>
                <c:formatCode>General</c:formatCode>
                <c:ptCount val="99"/>
                <c:pt idx="0">
                  <c:v>30.3</c:v>
                </c:pt>
                <c:pt idx="1">
                  <c:v>30.7</c:v>
                </c:pt>
                <c:pt idx="2">
                  <c:v>31</c:v>
                </c:pt>
                <c:pt idx="3">
                  <c:v>31.2</c:v>
                </c:pt>
                <c:pt idx="4">
                  <c:v>30.8</c:v>
                </c:pt>
                <c:pt idx="5">
                  <c:v>30.4</c:v>
                </c:pt>
                <c:pt idx="6">
                  <c:v>30.6</c:v>
                </c:pt>
                <c:pt idx="7">
                  <c:v>30</c:v>
                </c:pt>
                <c:pt idx="8">
                  <c:v>29.1</c:v>
                </c:pt>
                <c:pt idx="9">
                  <c:v>29.2</c:v>
                </c:pt>
                <c:pt idx="10">
                  <c:v>29.9</c:v>
                </c:pt>
                <c:pt idx="11">
                  <c:v>29.9</c:v>
                </c:pt>
                <c:pt idx="12">
                  <c:v>30.9</c:v>
                </c:pt>
                <c:pt idx="13">
                  <c:v>31.1</c:v>
                </c:pt>
                <c:pt idx="14">
                  <c:v>30.3</c:v>
                </c:pt>
                <c:pt idx="15">
                  <c:v>31.1</c:v>
                </c:pt>
                <c:pt idx="16">
                  <c:v>31</c:v>
                </c:pt>
                <c:pt idx="17">
                  <c:v>31.7</c:v>
                </c:pt>
                <c:pt idx="18">
                  <c:v>31.4</c:v>
                </c:pt>
                <c:pt idx="19">
                  <c:v>32.4</c:v>
                </c:pt>
                <c:pt idx="20">
                  <c:v>32.6</c:v>
                </c:pt>
                <c:pt idx="21">
                  <c:v>32.200000000000003</c:v>
                </c:pt>
                <c:pt idx="22">
                  <c:v>32.1</c:v>
                </c:pt>
                <c:pt idx="23">
                  <c:v>32.4</c:v>
                </c:pt>
                <c:pt idx="24">
                  <c:v>32</c:v>
                </c:pt>
                <c:pt idx="25">
                  <c:v>31.8</c:v>
                </c:pt>
                <c:pt idx="26">
                  <c:v>32.5</c:v>
                </c:pt>
                <c:pt idx="27">
                  <c:v>32</c:v>
                </c:pt>
                <c:pt idx="28">
                  <c:v>32.6</c:v>
                </c:pt>
                <c:pt idx="29">
                  <c:v>33.5</c:v>
                </c:pt>
                <c:pt idx="30">
                  <c:v>33.4</c:v>
                </c:pt>
                <c:pt idx="31">
                  <c:v>33.200000000000003</c:v>
                </c:pt>
                <c:pt idx="32">
                  <c:v>31.6</c:v>
                </c:pt>
                <c:pt idx="33">
                  <c:v>32.4</c:v>
                </c:pt>
                <c:pt idx="34">
                  <c:v>35.799999999999997</c:v>
                </c:pt>
                <c:pt idx="35">
                  <c:v>33.4</c:v>
                </c:pt>
                <c:pt idx="36">
                  <c:v>33.200000000000003</c:v>
                </c:pt>
                <c:pt idx="37">
                  <c:v>33.4</c:v>
                </c:pt>
                <c:pt idx="38">
                  <c:v>32.9</c:v>
                </c:pt>
                <c:pt idx="39">
                  <c:v>33.200000000000003</c:v>
                </c:pt>
                <c:pt idx="40">
                  <c:v>33</c:v>
                </c:pt>
                <c:pt idx="41">
                  <c:v>33.4</c:v>
                </c:pt>
                <c:pt idx="42">
                  <c:v>33.1</c:v>
                </c:pt>
                <c:pt idx="43">
                  <c:v>33.6</c:v>
                </c:pt>
                <c:pt idx="44">
                  <c:v>32.9</c:v>
                </c:pt>
                <c:pt idx="45">
                  <c:v>32.9</c:v>
                </c:pt>
                <c:pt idx="46">
                  <c:v>32.700000000000003</c:v>
                </c:pt>
                <c:pt idx="47">
                  <c:v>32.799999999999997</c:v>
                </c:pt>
                <c:pt idx="48">
                  <c:v>32.9</c:v>
                </c:pt>
                <c:pt idx="49">
                  <c:v>32.6</c:v>
                </c:pt>
                <c:pt idx="50">
                  <c:v>33.200000000000003</c:v>
                </c:pt>
                <c:pt idx="51">
                  <c:v>32.700000000000003</c:v>
                </c:pt>
                <c:pt idx="52">
                  <c:v>32.6</c:v>
                </c:pt>
                <c:pt idx="53">
                  <c:v>31.3</c:v>
                </c:pt>
                <c:pt idx="54">
                  <c:v>32</c:v>
                </c:pt>
                <c:pt idx="55">
                  <c:v>32.200000000000003</c:v>
                </c:pt>
                <c:pt idx="56">
                  <c:v>31.9</c:v>
                </c:pt>
                <c:pt idx="57">
                  <c:v>32</c:v>
                </c:pt>
                <c:pt idx="58">
                  <c:v>32</c:v>
                </c:pt>
                <c:pt idx="59">
                  <c:v>31.6</c:v>
                </c:pt>
                <c:pt idx="60">
                  <c:v>32.5</c:v>
                </c:pt>
                <c:pt idx="61">
                  <c:v>32.700000000000003</c:v>
                </c:pt>
                <c:pt idx="62">
                  <c:v>33</c:v>
                </c:pt>
                <c:pt idx="63">
                  <c:v>33.299999999999997</c:v>
                </c:pt>
                <c:pt idx="64">
                  <c:v>32.299999999999997</c:v>
                </c:pt>
                <c:pt idx="65">
                  <c:v>32.5</c:v>
                </c:pt>
                <c:pt idx="66">
                  <c:v>32.299999999999997</c:v>
                </c:pt>
                <c:pt idx="67">
                  <c:v>32.1</c:v>
                </c:pt>
                <c:pt idx="68">
                  <c:v>31.9</c:v>
                </c:pt>
                <c:pt idx="69">
                  <c:v>31.9</c:v>
                </c:pt>
                <c:pt idx="70">
                  <c:v>31.6</c:v>
                </c:pt>
                <c:pt idx="71">
                  <c:v>31.8</c:v>
                </c:pt>
                <c:pt idx="72">
                  <c:v>32</c:v>
                </c:pt>
                <c:pt idx="73">
                  <c:v>31.7</c:v>
                </c:pt>
                <c:pt idx="74">
                  <c:v>31.8</c:v>
                </c:pt>
                <c:pt idx="75">
                  <c:v>31.9</c:v>
                </c:pt>
                <c:pt idx="76">
                  <c:v>31.9</c:v>
                </c:pt>
                <c:pt idx="77">
                  <c:v>32.4</c:v>
                </c:pt>
                <c:pt idx="78">
                  <c:v>32.1</c:v>
                </c:pt>
                <c:pt idx="79">
                  <c:v>31.8</c:v>
                </c:pt>
                <c:pt idx="80">
                  <c:v>31.3</c:v>
                </c:pt>
                <c:pt idx="81">
                  <c:v>31.3</c:v>
                </c:pt>
                <c:pt idx="82">
                  <c:v>31.8</c:v>
                </c:pt>
                <c:pt idx="83">
                  <c:v>32.299999999999997</c:v>
                </c:pt>
                <c:pt idx="84">
                  <c:v>31.8</c:v>
                </c:pt>
                <c:pt idx="85">
                  <c:v>31.5</c:v>
                </c:pt>
                <c:pt idx="86">
                  <c:v>31</c:v>
                </c:pt>
                <c:pt idx="87">
                  <c:v>30.9</c:v>
                </c:pt>
                <c:pt idx="88">
                  <c:v>31.4</c:v>
                </c:pt>
                <c:pt idx="89">
                  <c:v>31.6</c:v>
                </c:pt>
                <c:pt idx="90">
                  <c:v>32.799999999999997</c:v>
                </c:pt>
                <c:pt idx="91">
                  <c:v>31.3</c:v>
                </c:pt>
                <c:pt idx="92">
                  <c:v>30.7</c:v>
                </c:pt>
                <c:pt idx="93">
                  <c:v>30.8</c:v>
                </c:pt>
                <c:pt idx="94">
                  <c:v>31.2</c:v>
                </c:pt>
                <c:pt idx="95">
                  <c:v>29.3</c:v>
                </c:pt>
                <c:pt idx="96">
                  <c:v>30.1</c:v>
                </c:pt>
                <c:pt idx="97">
                  <c:v>30.3</c:v>
                </c:pt>
                <c:pt idx="98">
                  <c:v>30.5</c:v>
                </c:pt>
              </c:numCache>
            </c:numRef>
          </c:val>
          <c:smooth val="0"/>
        </c:ser>
        <c:dLbls>
          <c:showLegendKey val="0"/>
          <c:showVal val="0"/>
          <c:showCatName val="0"/>
          <c:showSerName val="0"/>
          <c:showPercent val="0"/>
          <c:showBubbleSize val="0"/>
        </c:dLbls>
        <c:marker val="1"/>
        <c:smooth val="0"/>
        <c:axId val="198261760"/>
        <c:axId val="198268032"/>
      </c:lineChart>
      <c:catAx>
        <c:axId val="198261760"/>
        <c:scaling>
          <c:orientation val="minMax"/>
        </c:scaling>
        <c:delete val="0"/>
        <c:axPos val="b"/>
        <c:title>
          <c:tx>
            <c:rich>
              <a:bodyPr/>
              <a:lstStyle/>
              <a:p>
                <a:pPr>
                  <a:defRPr baseline="0">
                    <a:latin typeface="Calibri" panose="020F0502020204030204" pitchFamily="34" charset="0"/>
                  </a:defRPr>
                </a:pPr>
                <a:r>
                  <a:rPr lang="en-US" baseline="0">
                    <a:latin typeface="Calibri" panose="020F0502020204030204" pitchFamily="34" charset="0"/>
                  </a:rPr>
                  <a:t>Date</a:t>
                </a:r>
              </a:p>
            </c:rich>
          </c:tx>
          <c:layout/>
          <c:overlay val="0"/>
        </c:title>
        <c:majorTickMark val="out"/>
        <c:minorTickMark val="none"/>
        <c:tickLblPos val="nextTo"/>
        <c:txPr>
          <a:bodyPr/>
          <a:lstStyle/>
          <a:p>
            <a:pPr>
              <a:defRPr sz="900" baseline="0">
                <a:latin typeface="Calibri" panose="020F0502020204030204" pitchFamily="34" charset="0"/>
              </a:defRPr>
            </a:pPr>
            <a:endParaRPr lang="he-IL"/>
          </a:p>
        </c:txPr>
        <c:crossAx val="198268032"/>
        <c:crosses val="autoZero"/>
        <c:auto val="1"/>
        <c:lblAlgn val="ctr"/>
        <c:lblOffset val="100"/>
        <c:noMultiLvlLbl val="0"/>
      </c:catAx>
      <c:valAx>
        <c:axId val="198268032"/>
        <c:scaling>
          <c:orientation val="minMax"/>
        </c:scaling>
        <c:delete val="0"/>
        <c:axPos val="l"/>
        <c:majorGridlines/>
        <c:title>
          <c:tx>
            <c:rich>
              <a:bodyPr rot="-5400000" vert="horz"/>
              <a:lstStyle/>
              <a:p>
                <a:pPr>
                  <a:defRPr b="0" i="0" baseline="0">
                    <a:latin typeface="Calibri" panose="020F0502020204030204" pitchFamily="34" charset="0"/>
                  </a:defRPr>
                </a:pPr>
                <a:r>
                  <a:rPr lang="en-US" b="0" i="0" baseline="0">
                    <a:latin typeface="Calibri" panose="020F0502020204030204" pitchFamily="34" charset="0"/>
                  </a:rPr>
                  <a:t>Temperature (</a:t>
                </a:r>
                <a:r>
                  <a:rPr lang="en-US" b="0" i="0" baseline="30000">
                    <a:latin typeface="Calibri" panose="020F0502020204030204" pitchFamily="34" charset="0"/>
                  </a:rPr>
                  <a:t>o</a:t>
                </a:r>
                <a:r>
                  <a:rPr lang="en-US" b="0" i="0" baseline="0">
                    <a:latin typeface="Calibri" panose="020F0502020204030204" pitchFamily="34" charset="0"/>
                  </a:rPr>
                  <a:t>C) </a:t>
                </a:r>
              </a:p>
            </c:rich>
          </c:tx>
          <c:layout>
            <c:manualLayout>
              <c:xMode val="edge"/>
              <c:yMode val="edge"/>
              <c:x val="0.14339343248205272"/>
              <c:y val="0.19052921568736111"/>
            </c:manualLayout>
          </c:layout>
          <c:overlay val="0"/>
        </c:title>
        <c:numFmt formatCode="General" sourceLinked="1"/>
        <c:majorTickMark val="out"/>
        <c:minorTickMark val="none"/>
        <c:tickLblPos val="nextTo"/>
        <c:crossAx val="198261760"/>
        <c:crosses val="autoZero"/>
        <c:crossBetween val="between"/>
      </c:valAx>
    </c:plotArea>
    <c:legend>
      <c:legendPos val="l"/>
      <c:layout>
        <c:manualLayout>
          <c:xMode val="edge"/>
          <c:yMode val="edge"/>
          <c:x val="0.75277777777777777"/>
          <c:y val="0.43480132691746864"/>
          <c:w val="0.18009733158355209"/>
          <c:h val="0.16743438320209975"/>
        </c:manualLayout>
      </c:layout>
      <c:overlay val="0"/>
      <c:spPr>
        <a:solidFill>
          <a:schemeClr val="bg1"/>
        </a:solidFill>
      </c:spPr>
    </c:legend>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strRef>
              <c:f>'ims_data (1)'!$D$1</c:f>
              <c:strCache>
                <c:ptCount val="1"/>
                <c:pt idx="0">
                  <c:v>Day min</c:v>
                </c:pt>
              </c:strCache>
            </c:strRef>
          </c:tx>
          <c:spPr>
            <a:ln w="12700"/>
          </c:spPr>
          <c:marker>
            <c:symbol val="diamond"/>
            <c:size val="2"/>
          </c:marker>
          <c:cat>
            <c:numRef>
              <c:f>'ims_data (1)'!$C$2:$C$63</c:f>
              <c:numCache>
                <c:formatCode>m/d/yyyy</c:formatCode>
                <c:ptCount val="62"/>
                <c:pt idx="0">
                  <c:v>41456</c:v>
                </c:pt>
                <c:pt idx="1">
                  <c:v>41457</c:v>
                </c:pt>
                <c:pt idx="2">
                  <c:v>41458</c:v>
                </c:pt>
                <c:pt idx="3">
                  <c:v>41459</c:v>
                </c:pt>
                <c:pt idx="4">
                  <c:v>41460</c:v>
                </c:pt>
                <c:pt idx="5">
                  <c:v>41461</c:v>
                </c:pt>
                <c:pt idx="6">
                  <c:v>41462</c:v>
                </c:pt>
                <c:pt idx="7">
                  <c:v>41463</c:v>
                </c:pt>
                <c:pt idx="8">
                  <c:v>41464</c:v>
                </c:pt>
                <c:pt idx="9">
                  <c:v>41465</c:v>
                </c:pt>
                <c:pt idx="10">
                  <c:v>41466</c:v>
                </c:pt>
                <c:pt idx="11">
                  <c:v>41467</c:v>
                </c:pt>
                <c:pt idx="12">
                  <c:v>41468</c:v>
                </c:pt>
                <c:pt idx="13">
                  <c:v>41469</c:v>
                </c:pt>
                <c:pt idx="14">
                  <c:v>41470</c:v>
                </c:pt>
                <c:pt idx="15">
                  <c:v>41471</c:v>
                </c:pt>
                <c:pt idx="16">
                  <c:v>41472</c:v>
                </c:pt>
                <c:pt idx="17">
                  <c:v>41473</c:v>
                </c:pt>
                <c:pt idx="18">
                  <c:v>41474</c:v>
                </c:pt>
                <c:pt idx="19">
                  <c:v>41475</c:v>
                </c:pt>
                <c:pt idx="20">
                  <c:v>41476</c:v>
                </c:pt>
                <c:pt idx="21">
                  <c:v>41477</c:v>
                </c:pt>
                <c:pt idx="22">
                  <c:v>41478</c:v>
                </c:pt>
                <c:pt idx="23">
                  <c:v>41479</c:v>
                </c:pt>
                <c:pt idx="24">
                  <c:v>41480</c:v>
                </c:pt>
                <c:pt idx="25">
                  <c:v>41481</c:v>
                </c:pt>
                <c:pt idx="26">
                  <c:v>41482</c:v>
                </c:pt>
                <c:pt idx="27">
                  <c:v>41483</c:v>
                </c:pt>
                <c:pt idx="28">
                  <c:v>41484</c:v>
                </c:pt>
                <c:pt idx="29">
                  <c:v>41485</c:v>
                </c:pt>
                <c:pt idx="30">
                  <c:v>41486</c:v>
                </c:pt>
                <c:pt idx="31">
                  <c:v>41487</c:v>
                </c:pt>
                <c:pt idx="32">
                  <c:v>41488</c:v>
                </c:pt>
                <c:pt idx="33">
                  <c:v>41489</c:v>
                </c:pt>
                <c:pt idx="34">
                  <c:v>41490</c:v>
                </c:pt>
                <c:pt idx="35">
                  <c:v>41491</c:v>
                </c:pt>
                <c:pt idx="36">
                  <c:v>41492</c:v>
                </c:pt>
                <c:pt idx="37">
                  <c:v>41493</c:v>
                </c:pt>
                <c:pt idx="38">
                  <c:v>41494</c:v>
                </c:pt>
                <c:pt idx="39">
                  <c:v>41495</c:v>
                </c:pt>
                <c:pt idx="40">
                  <c:v>41496</c:v>
                </c:pt>
                <c:pt idx="41">
                  <c:v>41497</c:v>
                </c:pt>
                <c:pt idx="42">
                  <c:v>41498</c:v>
                </c:pt>
                <c:pt idx="43">
                  <c:v>41499</c:v>
                </c:pt>
                <c:pt idx="44">
                  <c:v>41500</c:v>
                </c:pt>
                <c:pt idx="45">
                  <c:v>41501</c:v>
                </c:pt>
                <c:pt idx="46">
                  <c:v>41502</c:v>
                </c:pt>
                <c:pt idx="47">
                  <c:v>41503</c:v>
                </c:pt>
                <c:pt idx="48">
                  <c:v>41504</c:v>
                </c:pt>
                <c:pt idx="49">
                  <c:v>41505</c:v>
                </c:pt>
                <c:pt idx="50">
                  <c:v>41506</c:v>
                </c:pt>
                <c:pt idx="51">
                  <c:v>41507</c:v>
                </c:pt>
                <c:pt idx="52">
                  <c:v>41508</c:v>
                </c:pt>
                <c:pt idx="53">
                  <c:v>41509</c:v>
                </c:pt>
                <c:pt idx="54">
                  <c:v>41510</c:v>
                </c:pt>
                <c:pt idx="55">
                  <c:v>41511</c:v>
                </c:pt>
                <c:pt idx="56">
                  <c:v>41512</c:v>
                </c:pt>
                <c:pt idx="57">
                  <c:v>41513</c:v>
                </c:pt>
                <c:pt idx="58">
                  <c:v>41514</c:v>
                </c:pt>
                <c:pt idx="59">
                  <c:v>41515</c:v>
                </c:pt>
                <c:pt idx="60">
                  <c:v>41516</c:v>
                </c:pt>
                <c:pt idx="61">
                  <c:v>41517</c:v>
                </c:pt>
              </c:numCache>
            </c:numRef>
          </c:cat>
          <c:val>
            <c:numRef>
              <c:f>'ims_data (1)'!$D$2:$D$63</c:f>
              <c:numCache>
                <c:formatCode>General</c:formatCode>
                <c:ptCount val="62"/>
                <c:pt idx="0">
                  <c:v>21.5</c:v>
                </c:pt>
                <c:pt idx="1">
                  <c:v>21.5</c:v>
                </c:pt>
                <c:pt idx="2">
                  <c:v>20</c:v>
                </c:pt>
                <c:pt idx="3">
                  <c:v>19.5</c:v>
                </c:pt>
                <c:pt idx="4">
                  <c:v>18.899999999999999</c:v>
                </c:pt>
                <c:pt idx="5">
                  <c:v>20</c:v>
                </c:pt>
                <c:pt idx="6">
                  <c:v>20.9</c:v>
                </c:pt>
                <c:pt idx="7">
                  <c:v>21</c:v>
                </c:pt>
                <c:pt idx="8">
                  <c:v>22.8</c:v>
                </c:pt>
                <c:pt idx="9">
                  <c:v>21.7</c:v>
                </c:pt>
                <c:pt idx="10">
                  <c:v>23</c:v>
                </c:pt>
                <c:pt idx="11">
                  <c:v>22.3</c:v>
                </c:pt>
                <c:pt idx="12">
                  <c:v>22.7</c:v>
                </c:pt>
                <c:pt idx="13">
                  <c:v>23.8</c:v>
                </c:pt>
                <c:pt idx="14">
                  <c:v>21.6</c:v>
                </c:pt>
                <c:pt idx="15">
                  <c:v>21.1</c:v>
                </c:pt>
                <c:pt idx="16">
                  <c:v>22.3</c:v>
                </c:pt>
                <c:pt idx="17">
                  <c:v>22.6</c:v>
                </c:pt>
                <c:pt idx="18">
                  <c:v>23.1</c:v>
                </c:pt>
                <c:pt idx="19">
                  <c:v>21.7</c:v>
                </c:pt>
                <c:pt idx="20">
                  <c:v>23.2</c:v>
                </c:pt>
                <c:pt idx="21">
                  <c:v>22.2</c:v>
                </c:pt>
                <c:pt idx="22">
                  <c:v>20.3</c:v>
                </c:pt>
                <c:pt idx="23">
                  <c:v>21.7</c:v>
                </c:pt>
                <c:pt idx="24">
                  <c:v>22.6</c:v>
                </c:pt>
                <c:pt idx="25">
                  <c:v>23.5</c:v>
                </c:pt>
                <c:pt idx="26">
                  <c:v>22.7</c:v>
                </c:pt>
                <c:pt idx="27">
                  <c:v>20.5</c:v>
                </c:pt>
                <c:pt idx="28">
                  <c:v>21.1</c:v>
                </c:pt>
                <c:pt idx="29">
                  <c:v>22</c:v>
                </c:pt>
                <c:pt idx="30">
                  <c:v>21.6</c:v>
                </c:pt>
                <c:pt idx="31">
                  <c:v>20</c:v>
                </c:pt>
                <c:pt idx="32">
                  <c:v>20.9</c:v>
                </c:pt>
                <c:pt idx="33">
                  <c:v>23</c:v>
                </c:pt>
                <c:pt idx="34">
                  <c:v>23.2</c:v>
                </c:pt>
                <c:pt idx="35">
                  <c:v>22.8</c:v>
                </c:pt>
                <c:pt idx="36">
                  <c:v>22</c:v>
                </c:pt>
                <c:pt idx="37">
                  <c:v>19.399999999999999</c:v>
                </c:pt>
                <c:pt idx="38">
                  <c:v>21.7</c:v>
                </c:pt>
                <c:pt idx="39">
                  <c:v>21.8</c:v>
                </c:pt>
                <c:pt idx="40">
                  <c:v>23.2</c:v>
                </c:pt>
                <c:pt idx="41">
                  <c:v>22.7</c:v>
                </c:pt>
                <c:pt idx="42">
                  <c:v>23.5</c:v>
                </c:pt>
                <c:pt idx="43">
                  <c:v>20.3</c:v>
                </c:pt>
                <c:pt idx="53">
                  <c:v>20.6</c:v>
                </c:pt>
                <c:pt idx="54">
                  <c:v>22.4</c:v>
                </c:pt>
                <c:pt idx="55">
                  <c:v>22.1</c:v>
                </c:pt>
                <c:pt idx="56">
                  <c:v>21.4</c:v>
                </c:pt>
                <c:pt idx="57">
                  <c:v>21.7</c:v>
                </c:pt>
                <c:pt idx="58">
                  <c:v>20.6</c:v>
                </c:pt>
                <c:pt idx="59">
                  <c:v>22.8</c:v>
                </c:pt>
                <c:pt idx="60">
                  <c:v>20.399999999999999</c:v>
                </c:pt>
                <c:pt idx="61">
                  <c:v>21.6</c:v>
                </c:pt>
              </c:numCache>
            </c:numRef>
          </c:val>
          <c:smooth val="0"/>
        </c:ser>
        <c:ser>
          <c:idx val="1"/>
          <c:order val="1"/>
          <c:tx>
            <c:strRef>
              <c:f>'ims_data (1)'!$E$1</c:f>
              <c:strCache>
                <c:ptCount val="1"/>
                <c:pt idx="0">
                  <c:v>Day max</c:v>
                </c:pt>
              </c:strCache>
            </c:strRef>
          </c:tx>
          <c:spPr>
            <a:ln w="12700"/>
          </c:spPr>
          <c:marker>
            <c:symbol val="square"/>
            <c:size val="2"/>
          </c:marker>
          <c:cat>
            <c:numRef>
              <c:f>'ims_data (1)'!$C$2:$C$63</c:f>
              <c:numCache>
                <c:formatCode>m/d/yyyy</c:formatCode>
                <c:ptCount val="62"/>
                <c:pt idx="0">
                  <c:v>41456</c:v>
                </c:pt>
                <c:pt idx="1">
                  <c:v>41457</c:v>
                </c:pt>
                <c:pt idx="2">
                  <c:v>41458</c:v>
                </c:pt>
                <c:pt idx="3">
                  <c:v>41459</c:v>
                </c:pt>
                <c:pt idx="4">
                  <c:v>41460</c:v>
                </c:pt>
                <c:pt idx="5">
                  <c:v>41461</c:v>
                </c:pt>
                <c:pt idx="6">
                  <c:v>41462</c:v>
                </c:pt>
                <c:pt idx="7">
                  <c:v>41463</c:v>
                </c:pt>
                <c:pt idx="8">
                  <c:v>41464</c:v>
                </c:pt>
                <c:pt idx="9">
                  <c:v>41465</c:v>
                </c:pt>
                <c:pt idx="10">
                  <c:v>41466</c:v>
                </c:pt>
                <c:pt idx="11">
                  <c:v>41467</c:v>
                </c:pt>
                <c:pt idx="12">
                  <c:v>41468</c:v>
                </c:pt>
                <c:pt idx="13">
                  <c:v>41469</c:v>
                </c:pt>
                <c:pt idx="14">
                  <c:v>41470</c:v>
                </c:pt>
                <c:pt idx="15">
                  <c:v>41471</c:v>
                </c:pt>
                <c:pt idx="16">
                  <c:v>41472</c:v>
                </c:pt>
                <c:pt idx="17">
                  <c:v>41473</c:v>
                </c:pt>
                <c:pt idx="18">
                  <c:v>41474</c:v>
                </c:pt>
                <c:pt idx="19">
                  <c:v>41475</c:v>
                </c:pt>
                <c:pt idx="20">
                  <c:v>41476</c:v>
                </c:pt>
                <c:pt idx="21">
                  <c:v>41477</c:v>
                </c:pt>
                <c:pt idx="22">
                  <c:v>41478</c:v>
                </c:pt>
                <c:pt idx="23">
                  <c:v>41479</c:v>
                </c:pt>
                <c:pt idx="24">
                  <c:v>41480</c:v>
                </c:pt>
                <c:pt idx="25">
                  <c:v>41481</c:v>
                </c:pt>
                <c:pt idx="26">
                  <c:v>41482</c:v>
                </c:pt>
                <c:pt idx="27">
                  <c:v>41483</c:v>
                </c:pt>
                <c:pt idx="28">
                  <c:v>41484</c:v>
                </c:pt>
                <c:pt idx="29">
                  <c:v>41485</c:v>
                </c:pt>
                <c:pt idx="30">
                  <c:v>41486</c:v>
                </c:pt>
                <c:pt idx="31">
                  <c:v>41487</c:v>
                </c:pt>
                <c:pt idx="32">
                  <c:v>41488</c:v>
                </c:pt>
                <c:pt idx="33">
                  <c:v>41489</c:v>
                </c:pt>
                <c:pt idx="34">
                  <c:v>41490</c:v>
                </c:pt>
                <c:pt idx="35">
                  <c:v>41491</c:v>
                </c:pt>
                <c:pt idx="36">
                  <c:v>41492</c:v>
                </c:pt>
                <c:pt idx="37">
                  <c:v>41493</c:v>
                </c:pt>
                <c:pt idx="38">
                  <c:v>41494</c:v>
                </c:pt>
                <c:pt idx="39">
                  <c:v>41495</c:v>
                </c:pt>
                <c:pt idx="40">
                  <c:v>41496</c:v>
                </c:pt>
                <c:pt idx="41">
                  <c:v>41497</c:v>
                </c:pt>
                <c:pt idx="42">
                  <c:v>41498</c:v>
                </c:pt>
                <c:pt idx="43">
                  <c:v>41499</c:v>
                </c:pt>
                <c:pt idx="44">
                  <c:v>41500</c:v>
                </c:pt>
                <c:pt idx="45">
                  <c:v>41501</c:v>
                </c:pt>
                <c:pt idx="46">
                  <c:v>41502</c:v>
                </c:pt>
                <c:pt idx="47">
                  <c:v>41503</c:v>
                </c:pt>
                <c:pt idx="48">
                  <c:v>41504</c:v>
                </c:pt>
                <c:pt idx="49">
                  <c:v>41505</c:v>
                </c:pt>
                <c:pt idx="50">
                  <c:v>41506</c:v>
                </c:pt>
                <c:pt idx="51">
                  <c:v>41507</c:v>
                </c:pt>
                <c:pt idx="52">
                  <c:v>41508</c:v>
                </c:pt>
                <c:pt idx="53">
                  <c:v>41509</c:v>
                </c:pt>
                <c:pt idx="54">
                  <c:v>41510</c:v>
                </c:pt>
                <c:pt idx="55">
                  <c:v>41511</c:v>
                </c:pt>
                <c:pt idx="56">
                  <c:v>41512</c:v>
                </c:pt>
                <c:pt idx="57">
                  <c:v>41513</c:v>
                </c:pt>
                <c:pt idx="58">
                  <c:v>41514</c:v>
                </c:pt>
                <c:pt idx="59">
                  <c:v>41515</c:v>
                </c:pt>
                <c:pt idx="60">
                  <c:v>41516</c:v>
                </c:pt>
                <c:pt idx="61">
                  <c:v>41517</c:v>
                </c:pt>
              </c:numCache>
            </c:numRef>
          </c:cat>
          <c:val>
            <c:numRef>
              <c:f>'ims_data (1)'!$E$2:$E$63</c:f>
              <c:numCache>
                <c:formatCode>General</c:formatCode>
                <c:ptCount val="62"/>
                <c:pt idx="0">
                  <c:v>31</c:v>
                </c:pt>
                <c:pt idx="1">
                  <c:v>30.8</c:v>
                </c:pt>
                <c:pt idx="2">
                  <c:v>31.3</c:v>
                </c:pt>
                <c:pt idx="3">
                  <c:v>32.5</c:v>
                </c:pt>
                <c:pt idx="4">
                  <c:v>31.9</c:v>
                </c:pt>
                <c:pt idx="5">
                  <c:v>31</c:v>
                </c:pt>
                <c:pt idx="6">
                  <c:v>30.8</c:v>
                </c:pt>
                <c:pt idx="7">
                  <c:v>32.200000000000003</c:v>
                </c:pt>
                <c:pt idx="8">
                  <c:v>31.4</c:v>
                </c:pt>
                <c:pt idx="9">
                  <c:v>31.7</c:v>
                </c:pt>
                <c:pt idx="10">
                  <c:v>31.6</c:v>
                </c:pt>
                <c:pt idx="11">
                  <c:v>31.7</c:v>
                </c:pt>
                <c:pt idx="12">
                  <c:v>31.9</c:v>
                </c:pt>
                <c:pt idx="13">
                  <c:v>31.5</c:v>
                </c:pt>
                <c:pt idx="14">
                  <c:v>32.1</c:v>
                </c:pt>
                <c:pt idx="15">
                  <c:v>31.9</c:v>
                </c:pt>
                <c:pt idx="16">
                  <c:v>31.5</c:v>
                </c:pt>
                <c:pt idx="17">
                  <c:v>30.8</c:v>
                </c:pt>
                <c:pt idx="18">
                  <c:v>31.5</c:v>
                </c:pt>
                <c:pt idx="19">
                  <c:v>31.8</c:v>
                </c:pt>
                <c:pt idx="20">
                  <c:v>31.2</c:v>
                </c:pt>
                <c:pt idx="21">
                  <c:v>31.4</c:v>
                </c:pt>
                <c:pt idx="22">
                  <c:v>31.7</c:v>
                </c:pt>
                <c:pt idx="23">
                  <c:v>32</c:v>
                </c:pt>
                <c:pt idx="24">
                  <c:v>31.9</c:v>
                </c:pt>
                <c:pt idx="25">
                  <c:v>32.299999999999997</c:v>
                </c:pt>
                <c:pt idx="26">
                  <c:v>32</c:v>
                </c:pt>
                <c:pt idx="27">
                  <c:v>33.200000000000003</c:v>
                </c:pt>
                <c:pt idx="28">
                  <c:v>33.5</c:v>
                </c:pt>
                <c:pt idx="29">
                  <c:v>32.5</c:v>
                </c:pt>
                <c:pt idx="30">
                  <c:v>32.200000000000003</c:v>
                </c:pt>
                <c:pt idx="31">
                  <c:v>32.799999999999997</c:v>
                </c:pt>
                <c:pt idx="32">
                  <c:v>33.5</c:v>
                </c:pt>
                <c:pt idx="33">
                  <c:v>32.700000000000003</c:v>
                </c:pt>
                <c:pt idx="34">
                  <c:v>32.700000000000003</c:v>
                </c:pt>
                <c:pt idx="35">
                  <c:v>32.799999999999997</c:v>
                </c:pt>
                <c:pt idx="36">
                  <c:v>34.200000000000003</c:v>
                </c:pt>
                <c:pt idx="37">
                  <c:v>33.200000000000003</c:v>
                </c:pt>
                <c:pt idx="38">
                  <c:v>32.799999999999997</c:v>
                </c:pt>
                <c:pt idx="39">
                  <c:v>32.700000000000003</c:v>
                </c:pt>
                <c:pt idx="40">
                  <c:v>32.5</c:v>
                </c:pt>
                <c:pt idx="41">
                  <c:v>33.299999999999997</c:v>
                </c:pt>
                <c:pt idx="42">
                  <c:v>33.1</c:v>
                </c:pt>
                <c:pt idx="43">
                  <c:v>32.5</c:v>
                </c:pt>
                <c:pt idx="44">
                  <c:v>32.5</c:v>
                </c:pt>
                <c:pt idx="45">
                  <c:v>32.9</c:v>
                </c:pt>
                <c:pt idx="46">
                  <c:v>33.1</c:v>
                </c:pt>
                <c:pt idx="47">
                  <c:v>33.4</c:v>
                </c:pt>
                <c:pt idx="48">
                  <c:v>33.700000000000003</c:v>
                </c:pt>
                <c:pt idx="49">
                  <c:v>32.700000000000003</c:v>
                </c:pt>
                <c:pt idx="50">
                  <c:v>33.200000000000003</c:v>
                </c:pt>
                <c:pt idx="51">
                  <c:v>33.4</c:v>
                </c:pt>
                <c:pt idx="53">
                  <c:v>32.799999999999997</c:v>
                </c:pt>
                <c:pt idx="54">
                  <c:v>32.6</c:v>
                </c:pt>
                <c:pt idx="55">
                  <c:v>32.9</c:v>
                </c:pt>
                <c:pt idx="56">
                  <c:v>32.5</c:v>
                </c:pt>
                <c:pt idx="57">
                  <c:v>31.8</c:v>
                </c:pt>
                <c:pt idx="58">
                  <c:v>32.700000000000003</c:v>
                </c:pt>
                <c:pt idx="59">
                  <c:v>32.700000000000003</c:v>
                </c:pt>
                <c:pt idx="60">
                  <c:v>32.9</c:v>
                </c:pt>
                <c:pt idx="61">
                  <c:v>32.700000000000003</c:v>
                </c:pt>
              </c:numCache>
            </c:numRef>
          </c:val>
          <c:smooth val="0"/>
        </c:ser>
        <c:dLbls>
          <c:showLegendKey val="0"/>
          <c:showVal val="0"/>
          <c:showCatName val="0"/>
          <c:showSerName val="0"/>
          <c:showPercent val="0"/>
          <c:showBubbleSize val="0"/>
        </c:dLbls>
        <c:marker val="1"/>
        <c:smooth val="0"/>
        <c:axId val="95040256"/>
        <c:axId val="95042176"/>
      </c:lineChart>
      <c:dateAx>
        <c:axId val="95040256"/>
        <c:scaling>
          <c:orientation val="minMax"/>
        </c:scaling>
        <c:delete val="0"/>
        <c:axPos val="b"/>
        <c:title>
          <c:tx>
            <c:rich>
              <a:bodyPr/>
              <a:lstStyle/>
              <a:p>
                <a:pPr>
                  <a:defRPr/>
                </a:pPr>
                <a:r>
                  <a:rPr lang="en-US"/>
                  <a:t>Date</a:t>
                </a:r>
              </a:p>
            </c:rich>
          </c:tx>
          <c:layout/>
          <c:overlay val="0"/>
        </c:title>
        <c:numFmt formatCode="m/d/yyyy" sourceLinked="1"/>
        <c:majorTickMark val="out"/>
        <c:minorTickMark val="none"/>
        <c:tickLblPos val="nextTo"/>
        <c:txPr>
          <a:bodyPr/>
          <a:lstStyle/>
          <a:p>
            <a:pPr>
              <a:defRPr sz="900" baseline="0"/>
            </a:pPr>
            <a:endParaRPr lang="he-IL"/>
          </a:p>
        </c:txPr>
        <c:crossAx val="95042176"/>
        <c:crosses val="autoZero"/>
        <c:auto val="1"/>
        <c:lblOffset val="100"/>
        <c:baseTimeUnit val="days"/>
        <c:majorUnit val="3"/>
        <c:majorTimeUnit val="days"/>
      </c:dateAx>
      <c:valAx>
        <c:axId val="95042176"/>
        <c:scaling>
          <c:orientation val="minMax"/>
        </c:scaling>
        <c:delete val="0"/>
        <c:axPos val="l"/>
        <c:majorGridlines/>
        <c:title>
          <c:tx>
            <c:rich>
              <a:bodyPr rot="-5400000" vert="horz"/>
              <a:lstStyle/>
              <a:p>
                <a:pPr>
                  <a:defRPr b="0" i="0" baseline="0">
                    <a:latin typeface="Calibri" panose="020F0502020204030204" pitchFamily="34" charset="0"/>
                  </a:defRPr>
                </a:pPr>
                <a:r>
                  <a:rPr lang="en-US" b="0" i="0" baseline="0">
                    <a:latin typeface="Calibri" panose="020F0502020204030204" pitchFamily="34" charset="0"/>
                  </a:rPr>
                  <a:t>Temperature (</a:t>
                </a:r>
                <a:r>
                  <a:rPr lang="en-US" b="0" i="0" baseline="30000">
                    <a:latin typeface="Calibri" panose="020F0502020204030204" pitchFamily="34" charset="0"/>
                  </a:rPr>
                  <a:t>o</a:t>
                </a:r>
                <a:r>
                  <a:rPr lang="en-US" b="0" i="0" baseline="0">
                    <a:latin typeface="Calibri" panose="020F0502020204030204" pitchFamily="34" charset="0"/>
                  </a:rPr>
                  <a:t>C)</a:t>
                </a:r>
              </a:p>
            </c:rich>
          </c:tx>
          <c:layout>
            <c:manualLayout>
              <c:xMode val="edge"/>
              <c:yMode val="edge"/>
              <c:x val="0.15114266219621411"/>
              <c:y val="0.1729572135082634"/>
            </c:manualLayout>
          </c:layout>
          <c:overlay val="0"/>
        </c:title>
        <c:numFmt formatCode="General" sourceLinked="1"/>
        <c:majorTickMark val="out"/>
        <c:minorTickMark val="none"/>
        <c:tickLblPos val="nextTo"/>
        <c:crossAx val="95040256"/>
        <c:crosses val="autoZero"/>
        <c:crossBetween val="between"/>
      </c:valAx>
    </c:plotArea>
    <c:legend>
      <c:legendPos val="l"/>
      <c:layout>
        <c:manualLayout>
          <c:xMode val="edge"/>
          <c:yMode val="edge"/>
          <c:x val="0.75"/>
          <c:y val="0.39313466025080196"/>
          <c:w val="0.13943019219371774"/>
          <c:h val="0.16831103384792181"/>
        </c:manualLayout>
      </c:layout>
      <c:overlay val="0"/>
      <c:spPr>
        <a:solidFill>
          <a:schemeClr val="bg1"/>
        </a:solidFill>
      </c:spPr>
    </c:legend>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strRef>
              <c:f>'BE spring 2014 ana'!$V$2</c:f>
              <c:strCache>
                <c:ptCount val="1"/>
                <c:pt idx="0">
                  <c:v>Day min</c:v>
                </c:pt>
              </c:strCache>
            </c:strRef>
          </c:tx>
          <c:spPr>
            <a:ln w="12700"/>
          </c:spPr>
          <c:marker>
            <c:symbol val="diamond"/>
            <c:size val="3"/>
          </c:marker>
          <c:cat>
            <c:strRef>
              <c:f>'BE spring 2014 ana'!$U$3:$U$124</c:f>
              <c:strCache>
                <c:ptCount val="122"/>
                <c:pt idx="0">
                  <c:v>01/03/2014</c:v>
                </c:pt>
                <c:pt idx="1">
                  <c:v>02/03/2014</c:v>
                </c:pt>
                <c:pt idx="2">
                  <c:v>03/03/2014</c:v>
                </c:pt>
                <c:pt idx="3">
                  <c:v>04/03/2014</c:v>
                </c:pt>
                <c:pt idx="4">
                  <c:v>05/03/2014</c:v>
                </c:pt>
                <c:pt idx="5">
                  <c:v>06/03/2014</c:v>
                </c:pt>
                <c:pt idx="6">
                  <c:v>07/03/2014</c:v>
                </c:pt>
                <c:pt idx="7">
                  <c:v>08/03/2014</c:v>
                </c:pt>
                <c:pt idx="8">
                  <c:v>09/03/2014</c:v>
                </c:pt>
                <c:pt idx="9">
                  <c:v>10/03/2014</c:v>
                </c:pt>
                <c:pt idx="10">
                  <c:v>11/03/2014</c:v>
                </c:pt>
                <c:pt idx="11">
                  <c:v>12/03/2014</c:v>
                </c:pt>
                <c:pt idx="12">
                  <c:v>13/03/2014</c:v>
                </c:pt>
                <c:pt idx="13">
                  <c:v>14/03/2014</c:v>
                </c:pt>
                <c:pt idx="14">
                  <c:v>15/03/2014</c:v>
                </c:pt>
                <c:pt idx="15">
                  <c:v>16/03/2014</c:v>
                </c:pt>
                <c:pt idx="16">
                  <c:v>17/03/2014</c:v>
                </c:pt>
                <c:pt idx="17">
                  <c:v>18/03/2014</c:v>
                </c:pt>
                <c:pt idx="18">
                  <c:v>19/03/2014</c:v>
                </c:pt>
                <c:pt idx="19">
                  <c:v>20/03/2014</c:v>
                </c:pt>
                <c:pt idx="20">
                  <c:v>21/03/2014</c:v>
                </c:pt>
                <c:pt idx="21">
                  <c:v>22/03/2014</c:v>
                </c:pt>
                <c:pt idx="22">
                  <c:v>23/03/2014</c:v>
                </c:pt>
                <c:pt idx="23">
                  <c:v>24/03/2014</c:v>
                </c:pt>
                <c:pt idx="24">
                  <c:v>25/03/2014</c:v>
                </c:pt>
                <c:pt idx="25">
                  <c:v>26/03/2014</c:v>
                </c:pt>
                <c:pt idx="26">
                  <c:v>27/03/2014</c:v>
                </c:pt>
                <c:pt idx="27">
                  <c:v>28/03/2014</c:v>
                </c:pt>
                <c:pt idx="28">
                  <c:v>29/03/2014</c:v>
                </c:pt>
                <c:pt idx="29">
                  <c:v>30/03/2014</c:v>
                </c:pt>
                <c:pt idx="30">
                  <c:v>31/03/2014</c:v>
                </c:pt>
                <c:pt idx="31">
                  <c:v>01/04/2014</c:v>
                </c:pt>
                <c:pt idx="32">
                  <c:v>02/04/2014</c:v>
                </c:pt>
                <c:pt idx="33">
                  <c:v>03/04/2014</c:v>
                </c:pt>
                <c:pt idx="34">
                  <c:v>04/04/2014</c:v>
                </c:pt>
                <c:pt idx="35">
                  <c:v>05/04/2014</c:v>
                </c:pt>
                <c:pt idx="36">
                  <c:v>06/04/2014</c:v>
                </c:pt>
                <c:pt idx="37">
                  <c:v>07/04/2014</c:v>
                </c:pt>
                <c:pt idx="38">
                  <c:v>08/04/2014</c:v>
                </c:pt>
                <c:pt idx="39">
                  <c:v>09/04/2014</c:v>
                </c:pt>
                <c:pt idx="40">
                  <c:v>10/04/2014</c:v>
                </c:pt>
                <c:pt idx="41">
                  <c:v>11/04/2014</c:v>
                </c:pt>
                <c:pt idx="42">
                  <c:v>12/04/2014</c:v>
                </c:pt>
                <c:pt idx="43">
                  <c:v>13/04/2014</c:v>
                </c:pt>
                <c:pt idx="44">
                  <c:v>14/04/2014</c:v>
                </c:pt>
                <c:pt idx="45">
                  <c:v>15/04/2014</c:v>
                </c:pt>
                <c:pt idx="46">
                  <c:v>16/04/2014</c:v>
                </c:pt>
                <c:pt idx="47">
                  <c:v>17/04/2014</c:v>
                </c:pt>
                <c:pt idx="48">
                  <c:v>18/04/2014</c:v>
                </c:pt>
                <c:pt idx="49">
                  <c:v>19/04/2014</c:v>
                </c:pt>
                <c:pt idx="50">
                  <c:v>20/04/2014</c:v>
                </c:pt>
                <c:pt idx="51">
                  <c:v>21/04/2014</c:v>
                </c:pt>
                <c:pt idx="52">
                  <c:v>22/04/2014</c:v>
                </c:pt>
                <c:pt idx="53">
                  <c:v>23/04/2014</c:v>
                </c:pt>
                <c:pt idx="54">
                  <c:v>24/04/2014</c:v>
                </c:pt>
                <c:pt idx="55">
                  <c:v>25/04/2014</c:v>
                </c:pt>
                <c:pt idx="56">
                  <c:v>26/04/2014</c:v>
                </c:pt>
                <c:pt idx="57">
                  <c:v>27/04/2014</c:v>
                </c:pt>
                <c:pt idx="58">
                  <c:v>28/04/2014</c:v>
                </c:pt>
                <c:pt idx="59">
                  <c:v>29/04/2014</c:v>
                </c:pt>
                <c:pt idx="60">
                  <c:v>30/04/2014</c:v>
                </c:pt>
                <c:pt idx="61">
                  <c:v>01/05/2014</c:v>
                </c:pt>
                <c:pt idx="62">
                  <c:v>02/05/2014</c:v>
                </c:pt>
                <c:pt idx="63">
                  <c:v>03/05/2014</c:v>
                </c:pt>
                <c:pt idx="64">
                  <c:v>04/05/2014</c:v>
                </c:pt>
                <c:pt idx="65">
                  <c:v>05/05/2014</c:v>
                </c:pt>
                <c:pt idx="66">
                  <c:v>06/05/2014</c:v>
                </c:pt>
                <c:pt idx="67">
                  <c:v>07/05/2014</c:v>
                </c:pt>
                <c:pt idx="68">
                  <c:v>08/05/2014</c:v>
                </c:pt>
                <c:pt idx="69">
                  <c:v>09/05/2014</c:v>
                </c:pt>
                <c:pt idx="70">
                  <c:v>10/05/2014</c:v>
                </c:pt>
                <c:pt idx="71">
                  <c:v>11/05/2014</c:v>
                </c:pt>
                <c:pt idx="72">
                  <c:v>12/05/2014</c:v>
                </c:pt>
                <c:pt idx="73">
                  <c:v>13/05/2014</c:v>
                </c:pt>
                <c:pt idx="74">
                  <c:v>14/05/2014</c:v>
                </c:pt>
                <c:pt idx="75">
                  <c:v>15/05/2014</c:v>
                </c:pt>
                <c:pt idx="76">
                  <c:v>16/05/2014</c:v>
                </c:pt>
                <c:pt idx="77">
                  <c:v>17/05/2014</c:v>
                </c:pt>
                <c:pt idx="78">
                  <c:v>18/05/2014</c:v>
                </c:pt>
                <c:pt idx="79">
                  <c:v>19/05/2014</c:v>
                </c:pt>
                <c:pt idx="80">
                  <c:v>20/05/2014</c:v>
                </c:pt>
                <c:pt idx="81">
                  <c:v>21/05/2014</c:v>
                </c:pt>
                <c:pt idx="82">
                  <c:v>22/05/2014</c:v>
                </c:pt>
                <c:pt idx="83">
                  <c:v>23/05/2014</c:v>
                </c:pt>
                <c:pt idx="84">
                  <c:v>24/05/2014</c:v>
                </c:pt>
                <c:pt idx="85">
                  <c:v>25/05/2014</c:v>
                </c:pt>
                <c:pt idx="86">
                  <c:v>26/05/2014</c:v>
                </c:pt>
                <c:pt idx="87">
                  <c:v>27/05/2014</c:v>
                </c:pt>
                <c:pt idx="88">
                  <c:v>28/05/2014</c:v>
                </c:pt>
                <c:pt idx="89">
                  <c:v>29/05/2014</c:v>
                </c:pt>
                <c:pt idx="90">
                  <c:v>30/05/2014</c:v>
                </c:pt>
                <c:pt idx="91">
                  <c:v>31/05/2014</c:v>
                </c:pt>
                <c:pt idx="92">
                  <c:v>01/06/2014</c:v>
                </c:pt>
                <c:pt idx="93">
                  <c:v>02/06/2014</c:v>
                </c:pt>
                <c:pt idx="94">
                  <c:v>03/06/2014</c:v>
                </c:pt>
                <c:pt idx="95">
                  <c:v>04/06/2014</c:v>
                </c:pt>
                <c:pt idx="96">
                  <c:v>05/06/2014</c:v>
                </c:pt>
                <c:pt idx="97">
                  <c:v>06/06/2014</c:v>
                </c:pt>
                <c:pt idx="98">
                  <c:v>07/06/2014</c:v>
                </c:pt>
                <c:pt idx="99">
                  <c:v>08/06/2014</c:v>
                </c:pt>
                <c:pt idx="100">
                  <c:v>09/06/2014</c:v>
                </c:pt>
                <c:pt idx="101">
                  <c:v>10/06/2014</c:v>
                </c:pt>
                <c:pt idx="102">
                  <c:v>11/06/2014</c:v>
                </c:pt>
                <c:pt idx="103">
                  <c:v>12/06/2014</c:v>
                </c:pt>
                <c:pt idx="104">
                  <c:v>13/06/2014</c:v>
                </c:pt>
                <c:pt idx="105">
                  <c:v>14/06/2014</c:v>
                </c:pt>
                <c:pt idx="106">
                  <c:v>15/06/2014</c:v>
                </c:pt>
                <c:pt idx="107">
                  <c:v>16/06/2014</c:v>
                </c:pt>
                <c:pt idx="108">
                  <c:v>17/06/2014</c:v>
                </c:pt>
                <c:pt idx="109">
                  <c:v>18/06/2014</c:v>
                </c:pt>
                <c:pt idx="110">
                  <c:v>19/06/2014</c:v>
                </c:pt>
                <c:pt idx="111">
                  <c:v>20/06/2014</c:v>
                </c:pt>
                <c:pt idx="112">
                  <c:v>21/06/2014</c:v>
                </c:pt>
                <c:pt idx="113">
                  <c:v>22/06/2014</c:v>
                </c:pt>
                <c:pt idx="114">
                  <c:v>23/06/2014</c:v>
                </c:pt>
                <c:pt idx="115">
                  <c:v>24/06/2014</c:v>
                </c:pt>
                <c:pt idx="116">
                  <c:v>25/06/2014</c:v>
                </c:pt>
                <c:pt idx="117">
                  <c:v>26/06/2014</c:v>
                </c:pt>
                <c:pt idx="118">
                  <c:v>27/06/2014</c:v>
                </c:pt>
                <c:pt idx="119">
                  <c:v>28/06/2014</c:v>
                </c:pt>
                <c:pt idx="120">
                  <c:v>29/06/2014</c:v>
                </c:pt>
                <c:pt idx="121">
                  <c:v>30/06/2014</c:v>
                </c:pt>
              </c:strCache>
            </c:strRef>
          </c:cat>
          <c:val>
            <c:numRef>
              <c:f>'BE spring 2014 ana'!$V$3:$V$124</c:f>
              <c:numCache>
                <c:formatCode>General</c:formatCode>
                <c:ptCount val="122"/>
                <c:pt idx="0">
                  <c:v>5.0999999999999996</c:v>
                </c:pt>
                <c:pt idx="1">
                  <c:v>9.6</c:v>
                </c:pt>
                <c:pt idx="2">
                  <c:v>11.8</c:v>
                </c:pt>
                <c:pt idx="3">
                  <c:v>9.4</c:v>
                </c:pt>
                <c:pt idx="4">
                  <c:v>8.4</c:v>
                </c:pt>
                <c:pt idx="5">
                  <c:v>12.2</c:v>
                </c:pt>
                <c:pt idx="6">
                  <c:v>9.9</c:v>
                </c:pt>
                <c:pt idx="7">
                  <c:v>14.3</c:v>
                </c:pt>
                <c:pt idx="8">
                  <c:v>15.8</c:v>
                </c:pt>
                <c:pt idx="9">
                  <c:v>9.4</c:v>
                </c:pt>
                <c:pt idx="10">
                  <c:v>7.8</c:v>
                </c:pt>
                <c:pt idx="11">
                  <c:v>11</c:v>
                </c:pt>
                <c:pt idx="12">
                  <c:v>9.3000000000000007</c:v>
                </c:pt>
                <c:pt idx="13">
                  <c:v>9</c:v>
                </c:pt>
                <c:pt idx="14">
                  <c:v>7.9</c:v>
                </c:pt>
                <c:pt idx="15">
                  <c:v>6.1</c:v>
                </c:pt>
                <c:pt idx="16">
                  <c:v>14.2</c:v>
                </c:pt>
                <c:pt idx="17">
                  <c:v>11.3</c:v>
                </c:pt>
                <c:pt idx="18">
                  <c:v>10.7</c:v>
                </c:pt>
                <c:pt idx="19">
                  <c:v>12.1</c:v>
                </c:pt>
                <c:pt idx="20">
                  <c:v>9.9</c:v>
                </c:pt>
                <c:pt idx="21">
                  <c:v>8.1999999999999993</c:v>
                </c:pt>
                <c:pt idx="22">
                  <c:v>12.4</c:v>
                </c:pt>
                <c:pt idx="23">
                  <c:v>13.9</c:v>
                </c:pt>
                <c:pt idx="24">
                  <c:v>11.4</c:v>
                </c:pt>
                <c:pt idx="25">
                  <c:v>9.5</c:v>
                </c:pt>
                <c:pt idx="26">
                  <c:v>6.7</c:v>
                </c:pt>
                <c:pt idx="27">
                  <c:v>6</c:v>
                </c:pt>
                <c:pt idx="28">
                  <c:v>10.7</c:v>
                </c:pt>
                <c:pt idx="29">
                  <c:v>8.8000000000000007</c:v>
                </c:pt>
                <c:pt idx="30">
                  <c:v>6.1</c:v>
                </c:pt>
                <c:pt idx="31">
                  <c:v>7.4</c:v>
                </c:pt>
                <c:pt idx="32">
                  <c:v>11</c:v>
                </c:pt>
                <c:pt idx="33">
                  <c:v>8.8000000000000007</c:v>
                </c:pt>
                <c:pt idx="34">
                  <c:v>8.9</c:v>
                </c:pt>
                <c:pt idx="35">
                  <c:v>6.2</c:v>
                </c:pt>
                <c:pt idx="36">
                  <c:v>8.9</c:v>
                </c:pt>
                <c:pt idx="37">
                  <c:v>9.6</c:v>
                </c:pt>
                <c:pt idx="38">
                  <c:v>10.7</c:v>
                </c:pt>
                <c:pt idx="39">
                  <c:v>11.5</c:v>
                </c:pt>
                <c:pt idx="40">
                  <c:v>11</c:v>
                </c:pt>
                <c:pt idx="41">
                  <c:v>7.6</c:v>
                </c:pt>
                <c:pt idx="42">
                  <c:v>11.5</c:v>
                </c:pt>
                <c:pt idx="43">
                  <c:v>10</c:v>
                </c:pt>
                <c:pt idx="44">
                  <c:v>8.1999999999999993</c:v>
                </c:pt>
                <c:pt idx="45">
                  <c:v>11.4</c:v>
                </c:pt>
                <c:pt idx="46">
                  <c:v>14.2</c:v>
                </c:pt>
                <c:pt idx="47">
                  <c:v>13.1</c:v>
                </c:pt>
                <c:pt idx="48">
                  <c:v>13.2</c:v>
                </c:pt>
                <c:pt idx="49">
                  <c:v>18.399999999999999</c:v>
                </c:pt>
                <c:pt idx="50">
                  <c:v>18.2</c:v>
                </c:pt>
                <c:pt idx="51">
                  <c:v>13.6</c:v>
                </c:pt>
                <c:pt idx="52">
                  <c:v>11.9</c:v>
                </c:pt>
                <c:pt idx="53">
                  <c:v>10.8</c:v>
                </c:pt>
                <c:pt idx="54">
                  <c:v>12.1</c:v>
                </c:pt>
                <c:pt idx="55">
                  <c:v>17.600000000000001</c:v>
                </c:pt>
                <c:pt idx="56">
                  <c:v>12.4</c:v>
                </c:pt>
                <c:pt idx="57">
                  <c:v>11.7</c:v>
                </c:pt>
                <c:pt idx="58">
                  <c:v>10.3</c:v>
                </c:pt>
                <c:pt idx="59">
                  <c:v>13</c:v>
                </c:pt>
                <c:pt idx="60">
                  <c:v>12.4</c:v>
                </c:pt>
                <c:pt idx="61">
                  <c:v>11.9</c:v>
                </c:pt>
                <c:pt idx="62">
                  <c:v>13.4</c:v>
                </c:pt>
                <c:pt idx="63">
                  <c:v>12.8</c:v>
                </c:pt>
                <c:pt idx="64">
                  <c:v>15</c:v>
                </c:pt>
                <c:pt idx="65">
                  <c:v>19.100000000000001</c:v>
                </c:pt>
                <c:pt idx="66">
                  <c:v>18.399999999999999</c:v>
                </c:pt>
                <c:pt idx="67">
                  <c:v>17.600000000000001</c:v>
                </c:pt>
                <c:pt idx="68">
                  <c:v>16.600000000000001</c:v>
                </c:pt>
                <c:pt idx="69">
                  <c:v>14.7</c:v>
                </c:pt>
                <c:pt idx="70">
                  <c:v>13.3</c:v>
                </c:pt>
                <c:pt idx="71">
                  <c:v>15.8</c:v>
                </c:pt>
                <c:pt idx="72">
                  <c:v>13.7</c:v>
                </c:pt>
                <c:pt idx="73">
                  <c:v>16</c:v>
                </c:pt>
                <c:pt idx="74">
                  <c:v>13.8</c:v>
                </c:pt>
                <c:pt idx="75">
                  <c:v>11.5</c:v>
                </c:pt>
                <c:pt idx="76">
                  <c:v>12.7</c:v>
                </c:pt>
                <c:pt idx="77">
                  <c:v>15</c:v>
                </c:pt>
                <c:pt idx="78">
                  <c:v>15.6</c:v>
                </c:pt>
                <c:pt idx="79">
                  <c:v>14.1</c:v>
                </c:pt>
                <c:pt idx="80">
                  <c:v>15.6</c:v>
                </c:pt>
                <c:pt idx="81">
                  <c:v>15.7</c:v>
                </c:pt>
                <c:pt idx="82">
                  <c:v>16.8</c:v>
                </c:pt>
                <c:pt idx="83">
                  <c:v>16.7</c:v>
                </c:pt>
                <c:pt idx="84">
                  <c:v>14.3</c:v>
                </c:pt>
                <c:pt idx="85">
                  <c:v>15</c:v>
                </c:pt>
                <c:pt idx="86">
                  <c:v>14.5</c:v>
                </c:pt>
                <c:pt idx="87">
                  <c:v>16.100000000000001</c:v>
                </c:pt>
                <c:pt idx="88">
                  <c:v>19.100000000000001</c:v>
                </c:pt>
                <c:pt idx="89">
                  <c:v>18.100000000000001</c:v>
                </c:pt>
                <c:pt idx="90">
                  <c:v>14.9</c:v>
                </c:pt>
                <c:pt idx="91">
                  <c:v>19.100000000000001</c:v>
                </c:pt>
                <c:pt idx="92">
                  <c:v>16.600000000000001</c:v>
                </c:pt>
                <c:pt idx="93">
                  <c:v>17</c:v>
                </c:pt>
                <c:pt idx="94">
                  <c:v>15.3</c:v>
                </c:pt>
                <c:pt idx="95">
                  <c:v>18.8</c:v>
                </c:pt>
                <c:pt idx="96">
                  <c:v>20.5</c:v>
                </c:pt>
                <c:pt idx="97">
                  <c:v>18.8</c:v>
                </c:pt>
                <c:pt idx="98">
                  <c:v>17.2</c:v>
                </c:pt>
                <c:pt idx="99">
                  <c:v>16.899999999999999</c:v>
                </c:pt>
                <c:pt idx="100">
                  <c:v>16.3</c:v>
                </c:pt>
                <c:pt idx="101">
                  <c:v>16.899999999999999</c:v>
                </c:pt>
                <c:pt idx="102">
                  <c:v>17.899999999999999</c:v>
                </c:pt>
                <c:pt idx="103">
                  <c:v>16.3</c:v>
                </c:pt>
                <c:pt idx="104">
                  <c:v>18.100000000000001</c:v>
                </c:pt>
                <c:pt idx="105">
                  <c:v>17.8</c:v>
                </c:pt>
                <c:pt idx="106">
                  <c:v>16.399999999999999</c:v>
                </c:pt>
                <c:pt idx="107">
                  <c:v>15.2</c:v>
                </c:pt>
                <c:pt idx="108">
                  <c:v>18.2</c:v>
                </c:pt>
                <c:pt idx="109">
                  <c:v>18.7</c:v>
                </c:pt>
                <c:pt idx="110">
                  <c:v>20.3</c:v>
                </c:pt>
                <c:pt idx="111">
                  <c:v>22.1</c:v>
                </c:pt>
                <c:pt idx="112">
                  <c:v>22.2</c:v>
                </c:pt>
                <c:pt idx="113">
                  <c:v>18.7</c:v>
                </c:pt>
                <c:pt idx="114">
                  <c:v>18.5</c:v>
                </c:pt>
                <c:pt idx="115">
                  <c:v>17.7</c:v>
                </c:pt>
                <c:pt idx="116">
                  <c:v>19</c:v>
                </c:pt>
                <c:pt idx="117">
                  <c:v>18.600000000000001</c:v>
                </c:pt>
                <c:pt idx="118">
                  <c:v>17.8</c:v>
                </c:pt>
                <c:pt idx="119">
                  <c:v>18.899999999999999</c:v>
                </c:pt>
                <c:pt idx="120">
                  <c:v>20</c:v>
                </c:pt>
                <c:pt idx="121">
                  <c:v>21.4</c:v>
                </c:pt>
              </c:numCache>
            </c:numRef>
          </c:val>
          <c:smooth val="0"/>
        </c:ser>
        <c:ser>
          <c:idx val="1"/>
          <c:order val="1"/>
          <c:tx>
            <c:strRef>
              <c:f>'BE spring 2014 ana'!$W$2</c:f>
              <c:strCache>
                <c:ptCount val="1"/>
                <c:pt idx="0">
                  <c:v>Day max </c:v>
                </c:pt>
              </c:strCache>
            </c:strRef>
          </c:tx>
          <c:spPr>
            <a:ln w="12700"/>
          </c:spPr>
          <c:marker>
            <c:symbol val="square"/>
            <c:size val="2"/>
          </c:marker>
          <c:cat>
            <c:strRef>
              <c:f>'BE spring 2014 ana'!$U$3:$U$124</c:f>
              <c:strCache>
                <c:ptCount val="122"/>
                <c:pt idx="0">
                  <c:v>01/03/2014</c:v>
                </c:pt>
                <c:pt idx="1">
                  <c:v>02/03/2014</c:v>
                </c:pt>
                <c:pt idx="2">
                  <c:v>03/03/2014</c:v>
                </c:pt>
                <c:pt idx="3">
                  <c:v>04/03/2014</c:v>
                </c:pt>
                <c:pt idx="4">
                  <c:v>05/03/2014</c:v>
                </c:pt>
                <c:pt idx="5">
                  <c:v>06/03/2014</c:v>
                </c:pt>
                <c:pt idx="6">
                  <c:v>07/03/2014</c:v>
                </c:pt>
                <c:pt idx="7">
                  <c:v>08/03/2014</c:v>
                </c:pt>
                <c:pt idx="8">
                  <c:v>09/03/2014</c:v>
                </c:pt>
                <c:pt idx="9">
                  <c:v>10/03/2014</c:v>
                </c:pt>
                <c:pt idx="10">
                  <c:v>11/03/2014</c:v>
                </c:pt>
                <c:pt idx="11">
                  <c:v>12/03/2014</c:v>
                </c:pt>
                <c:pt idx="12">
                  <c:v>13/03/2014</c:v>
                </c:pt>
                <c:pt idx="13">
                  <c:v>14/03/2014</c:v>
                </c:pt>
                <c:pt idx="14">
                  <c:v>15/03/2014</c:v>
                </c:pt>
                <c:pt idx="15">
                  <c:v>16/03/2014</c:v>
                </c:pt>
                <c:pt idx="16">
                  <c:v>17/03/2014</c:v>
                </c:pt>
                <c:pt idx="17">
                  <c:v>18/03/2014</c:v>
                </c:pt>
                <c:pt idx="18">
                  <c:v>19/03/2014</c:v>
                </c:pt>
                <c:pt idx="19">
                  <c:v>20/03/2014</c:v>
                </c:pt>
                <c:pt idx="20">
                  <c:v>21/03/2014</c:v>
                </c:pt>
                <c:pt idx="21">
                  <c:v>22/03/2014</c:v>
                </c:pt>
                <c:pt idx="22">
                  <c:v>23/03/2014</c:v>
                </c:pt>
                <c:pt idx="23">
                  <c:v>24/03/2014</c:v>
                </c:pt>
                <c:pt idx="24">
                  <c:v>25/03/2014</c:v>
                </c:pt>
                <c:pt idx="25">
                  <c:v>26/03/2014</c:v>
                </c:pt>
                <c:pt idx="26">
                  <c:v>27/03/2014</c:v>
                </c:pt>
                <c:pt idx="27">
                  <c:v>28/03/2014</c:v>
                </c:pt>
                <c:pt idx="28">
                  <c:v>29/03/2014</c:v>
                </c:pt>
                <c:pt idx="29">
                  <c:v>30/03/2014</c:v>
                </c:pt>
                <c:pt idx="30">
                  <c:v>31/03/2014</c:v>
                </c:pt>
                <c:pt idx="31">
                  <c:v>01/04/2014</c:v>
                </c:pt>
                <c:pt idx="32">
                  <c:v>02/04/2014</c:v>
                </c:pt>
                <c:pt idx="33">
                  <c:v>03/04/2014</c:v>
                </c:pt>
                <c:pt idx="34">
                  <c:v>04/04/2014</c:v>
                </c:pt>
                <c:pt idx="35">
                  <c:v>05/04/2014</c:v>
                </c:pt>
                <c:pt idx="36">
                  <c:v>06/04/2014</c:v>
                </c:pt>
                <c:pt idx="37">
                  <c:v>07/04/2014</c:v>
                </c:pt>
                <c:pt idx="38">
                  <c:v>08/04/2014</c:v>
                </c:pt>
                <c:pt idx="39">
                  <c:v>09/04/2014</c:v>
                </c:pt>
                <c:pt idx="40">
                  <c:v>10/04/2014</c:v>
                </c:pt>
                <c:pt idx="41">
                  <c:v>11/04/2014</c:v>
                </c:pt>
                <c:pt idx="42">
                  <c:v>12/04/2014</c:v>
                </c:pt>
                <c:pt idx="43">
                  <c:v>13/04/2014</c:v>
                </c:pt>
                <c:pt idx="44">
                  <c:v>14/04/2014</c:v>
                </c:pt>
                <c:pt idx="45">
                  <c:v>15/04/2014</c:v>
                </c:pt>
                <c:pt idx="46">
                  <c:v>16/04/2014</c:v>
                </c:pt>
                <c:pt idx="47">
                  <c:v>17/04/2014</c:v>
                </c:pt>
                <c:pt idx="48">
                  <c:v>18/04/2014</c:v>
                </c:pt>
                <c:pt idx="49">
                  <c:v>19/04/2014</c:v>
                </c:pt>
                <c:pt idx="50">
                  <c:v>20/04/2014</c:v>
                </c:pt>
                <c:pt idx="51">
                  <c:v>21/04/2014</c:v>
                </c:pt>
                <c:pt idx="52">
                  <c:v>22/04/2014</c:v>
                </c:pt>
                <c:pt idx="53">
                  <c:v>23/04/2014</c:v>
                </c:pt>
                <c:pt idx="54">
                  <c:v>24/04/2014</c:v>
                </c:pt>
                <c:pt idx="55">
                  <c:v>25/04/2014</c:v>
                </c:pt>
                <c:pt idx="56">
                  <c:v>26/04/2014</c:v>
                </c:pt>
                <c:pt idx="57">
                  <c:v>27/04/2014</c:v>
                </c:pt>
                <c:pt idx="58">
                  <c:v>28/04/2014</c:v>
                </c:pt>
                <c:pt idx="59">
                  <c:v>29/04/2014</c:v>
                </c:pt>
                <c:pt idx="60">
                  <c:v>30/04/2014</c:v>
                </c:pt>
                <c:pt idx="61">
                  <c:v>01/05/2014</c:v>
                </c:pt>
                <c:pt idx="62">
                  <c:v>02/05/2014</c:v>
                </c:pt>
                <c:pt idx="63">
                  <c:v>03/05/2014</c:v>
                </c:pt>
                <c:pt idx="64">
                  <c:v>04/05/2014</c:v>
                </c:pt>
                <c:pt idx="65">
                  <c:v>05/05/2014</c:v>
                </c:pt>
                <c:pt idx="66">
                  <c:v>06/05/2014</c:v>
                </c:pt>
                <c:pt idx="67">
                  <c:v>07/05/2014</c:v>
                </c:pt>
                <c:pt idx="68">
                  <c:v>08/05/2014</c:v>
                </c:pt>
                <c:pt idx="69">
                  <c:v>09/05/2014</c:v>
                </c:pt>
                <c:pt idx="70">
                  <c:v>10/05/2014</c:v>
                </c:pt>
                <c:pt idx="71">
                  <c:v>11/05/2014</c:v>
                </c:pt>
                <c:pt idx="72">
                  <c:v>12/05/2014</c:v>
                </c:pt>
                <c:pt idx="73">
                  <c:v>13/05/2014</c:v>
                </c:pt>
                <c:pt idx="74">
                  <c:v>14/05/2014</c:v>
                </c:pt>
                <c:pt idx="75">
                  <c:v>15/05/2014</c:v>
                </c:pt>
                <c:pt idx="76">
                  <c:v>16/05/2014</c:v>
                </c:pt>
                <c:pt idx="77">
                  <c:v>17/05/2014</c:v>
                </c:pt>
                <c:pt idx="78">
                  <c:v>18/05/2014</c:v>
                </c:pt>
                <c:pt idx="79">
                  <c:v>19/05/2014</c:v>
                </c:pt>
                <c:pt idx="80">
                  <c:v>20/05/2014</c:v>
                </c:pt>
                <c:pt idx="81">
                  <c:v>21/05/2014</c:v>
                </c:pt>
                <c:pt idx="82">
                  <c:v>22/05/2014</c:v>
                </c:pt>
                <c:pt idx="83">
                  <c:v>23/05/2014</c:v>
                </c:pt>
                <c:pt idx="84">
                  <c:v>24/05/2014</c:v>
                </c:pt>
                <c:pt idx="85">
                  <c:v>25/05/2014</c:v>
                </c:pt>
                <c:pt idx="86">
                  <c:v>26/05/2014</c:v>
                </c:pt>
                <c:pt idx="87">
                  <c:v>27/05/2014</c:v>
                </c:pt>
                <c:pt idx="88">
                  <c:v>28/05/2014</c:v>
                </c:pt>
                <c:pt idx="89">
                  <c:v>29/05/2014</c:v>
                </c:pt>
                <c:pt idx="90">
                  <c:v>30/05/2014</c:v>
                </c:pt>
                <c:pt idx="91">
                  <c:v>31/05/2014</c:v>
                </c:pt>
                <c:pt idx="92">
                  <c:v>01/06/2014</c:v>
                </c:pt>
                <c:pt idx="93">
                  <c:v>02/06/2014</c:v>
                </c:pt>
                <c:pt idx="94">
                  <c:v>03/06/2014</c:v>
                </c:pt>
                <c:pt idx="95">
                  <c:v>04/06/2014</c:v>
                </c:pt>
                <c:pt idx="96">
                  <c:v>05/06/2014</c:v>
                </c:pt>
                <c:pt idx="97">
                  <c:v>06/06/2014</c:v>
                </c:pt>
                <c:pt idx="98">
                  <c:v>07/06/2014</c:v>
                </c:pt>
                <c:pt idx="99">
                  <c:v>08/06/2014</c:v>
                </c:pt>
                <c:pt idx="100">
                  <c:v>09/06/2014</c:v>
                </c:pt>
                <c:pt idx="101">
                  <c:v>10/06/2014</c:v>
                </c:pt>
                <c:pt idx="102">
                  <c:v>11/06/2014</c:v>
                </c:pt>
                <c:pt idx="103">
                  <c:v>12/06/2014</c:v>
                </c:pt>
                <c:pt idx="104">
                  <c:v>13/06/2014</c:v>
                </c:pt>
                <c:pt idx="105">
                  <c:v>14/06/2014</c:v>
                </c:pt>
                <c:pt idx="106">
                  <c:v>15/06/2014</c:v>
                </c:pt>
                <c:pt idx="107">
                  <c:v>16/06/2014</c:v>
                </c:pt>
                <c:pt idx="108">
                  <c:v>17/06/2014</c:v>
                </c:pt>
                <c:pt idx="109">
                  <c:v>18/06/2014</c:v>
                </c:pt>
                <c:pt idx="110">
                  <c:v>19/06/2014</c:v>
                </c:pt>
                <c:pt idx="111">
                  <c:v>20/06/2014</c:v>
                </c:pt>
                <c:pt idx="112">
                  <c:v>21/06/2014</c:v>
                </c:pt>
                <c:pt idx="113">
                  <c:v>22/06/2014</c:v>
                </c:pt>
                <c:pt idx="114">
                  <c:v>23/06/2014</c:v>
                </c:pt>
                <c:pt idx="115">
                  <c:v>24/06/2014</c:v>
                </c:pt>
                <c:pt idx="116">
                  <c:v>25/06/2014</c:v>
                </c:pt>
                <c:pt idx="117">
                  <c:v>26/06/2014</c:v>
                </c:pt>
                <c:pt idx="118">
                  <c:v>27/06/2014</c:v>
                </c:pt>
                <c:pt idx="119">
                  <c:v>28/06/2014</c:v>
                </c:pt>
                <c:pt idx="120">
                  <c:v>29/06/2014</c:v>
                </c:pt>
                <c:pt idx="121">
                  <c:v>30/06/2014</c:v>
                </c:pt>
              </c:strCache>
            </c:strRef>
          </c:cat>
          <c:val>
            <c:numRef>
              <c:f>'BE spring 2014 ana'!$W$3:$W$124</c:f>
              <c:numCache>
                <c:formatCode>General</c:formatCode>
                <c:ptCount val="122"/>
                <c:pt idx="0">
                  <c:v>24.4</c:v>
                </c:pt>
                <c:pt idx="1">
                  <c:v>26.8</c:v>
                </c:pt>
                <c:pt idx="2">
                  <c:v>22.9</c:v>
                </c:pt>
                <c:pt idx="3">
                  <c:v>22.7</c:v>
                </c:pt>
                <c:pt idx="4">
                  <c:v>27.5</c:v>
                </c:pt>
                <c:pt idx="5">
                  <c:v>23.6</c:v>
                </c:pt>
                <c:pt idx="6">
                  <c:v>29.6</c:v>
                </c:pt>
                <c:pt idx="7">
                  <c:v>30</c:v>
                </c:pt>
                <c:pt idx="8">
                  <c:v>20.2</c:v>
                </c:pt>
                <c:pt idx="9">
                  <c:v>20.100000000000001</c:v>
                </c:pt>
                <c:pt idx="10">
                  <c:v>23.1</c:v>
                </c:pt>
                <c:pt idx="11">
                  <c:v>19.7</c:v>
                </c:pt>
                <c:pt idx="12">
                  <c:v>14.9</c:v>
                </c:pt>
                <c:pt idx="13">
                  <c:v>17.8</c:v>
                </c:pt>
                <c:pt idx="14">
                  <c:v>19.399999999999999</c:v>
                </c:pt>
                <c:pt idx="15">
                  <c:v>24.4</c:v>
                </c:pt>
                <c:pt idx="16">
                  <c:v>26.7</c:v>
                </c:pt>
                <c:pt idx="17">
                  <c:v>20.6</c:v>
                </c:pt>
                <c:pt idx="18">
                  <c:v>21.1</c:v>
                </c:pt>
                <c:pt idx="19">
                  <c:v>21.6</c:v>
                </c:pt>
                <c:pt idx="20">
                  <c:v>22.6</c:v>
                </c:pt>
                <c:pt idx="21">
                  <c:v>23.2</c:v>
                </c:pt>
                <c:pt idx="22">
                  <c:v>22.5</c:v>
                </c:pt>
                <c:pt idx="23">
                  <c:v>23.7</c:v>
                </c:pt>
                <c:pt idx="24">
                  <c:v>22.4</c:v>
                </c:pt>
                <c:pt idx="25">
                  <c:v>22.4</c:v>
                </c:pt>
                <c:pt idx="26">
                  <c:v>22.7</c:v>
                </c:pt>
                <c:pt idx="27">
                  <c:v>25.3</c:v>
                </c:pt>
                <c:pt idx="28">
                  <c:v>25.9</c:v>
                </c:pt>
                <c:pt idx="29">
                  <c:v>23</c:v>
                </c:pt>
                <c:pt idx="30">
                  <c:v>19.600000000000001</c:v>
                </c:pt>
                <c:pt idx="31">
                  <c:v>24.6</c:v>
                </c:pt>
                <c:pt idx="32">
                  <c:v>22.3</c:v>
                </c:pt>
                <c:pt idx="33">
                  <c:v>22.3</c:v>
                </c:pt>
                <c:pt idx="34">
                  <c:v>22.5</c:v>
                </c:pt>
                <c:pt idx="35">
                  <c:v>27.4</c:v>
                </c:pt>
                <c:pt idx="36">
                  <c:v>28.4</c:v>
                </c:pt>
                <c:pt idx="37">
                  <c:v>30.9</c:v>
                </c:pt>
                <c:pt idx="38">
                  <c:v>28.4</c:v>
                </c:pt>
                <c:pt idx="39">
                  <c:v>23.3</c:v>
                </c:pt>
                <c:pt idx="40">
                  <c:v>23.3</c:v>
                </c:pt>
                <c:pt idx="41">
                  <c:v>23.5</c:v>
                </c:pt>
                <c:pt idx="42">
                  <c:v>23.2</c:v>
                </c:pt>
                <c:pt idx="43">
                  <c:v>24</c:v>
                </c:pt>
                <c:pt idx="44">
                  <c:v>25</c:v>
                </c:pt>
                <c:pt idx="45">
                  <c:v>30.8</c:v>
                </c:pt>
                <c:pt idx="46">
                  <c:v>26.8</c:v>
                </c:pt>
                <c:pt idx="47">
                  <c:v>25.3</c:v>
                </c:pt>
                <c:pt idx="48">
                  <c:v>32.299999999999997</c:v>
                </c:pt>
                <c:pt idx="49">
                  <c:v>33.6</c:v>
                </c:pt>
                <c:pt idx="50">
                  <c:v>24.6</c:v>
                </c:pt>
                <c:pt idx="51">
                  <c:v>23.3</c:v>
                </c:pt>
                <c:pt idx="52">
                  <c:v>24.8</c:v>
                </c:pt>
                <c:pt idx="53">
                  <c:v>25.2</c:v>
                </c:pt>
                <c:pt idx="54">
                  <c:v>31.7</c:v>
                </c:pt>
                <c:pt idx="55">
                  <c:v>28.8</c:v>
                </c:pt>
                <c:pt idx="56">
                  <c:v>25.2</c:v>
                </c:pt>
                <c:pt idx="57">
                  <c:v>25.1</c:v>
                </c:pt>
                <c:pt idx="58">
                  <c:v>29.2</c:v>
                </c:pt>
                <c:pt idx="59">
                  <c:v>27.1</c:v>
                </c:pt>
                <c:pt idx="60">
                  <c:v>26.5</c:v>
                </c:pt>
                <c:pt idx="61">
                  <c:v>29.3</c:v>
                </c:pt>
                <c:pt idx="62">
                  <c:v>25.2</c:v>
                </c:pt>
                <c:pt idx="63">
                  <c:v>35.6</c:v>
                </c:pt>
                <c:pt idx="64">
                  <c:v>39</c:v>
                </c:pt>
                <c:pt idx="65">
                  <c:v>31.5</c:v>
                </c:pt>
                <c:pt idx="66">
                  <c:v>29</c:v>
                </c:pt>
                <c:pt idx="67">
                  <c:v>24.9</c:v>
                </c:pt>
                <c:pt idx="68">
                  <c:v>22.9</c:v>
                </c:pt>
                <c:pt idx="69">
                  <c:v>25.8</c:v>
                </c:pt>
                <c:pt idx="70">
                  <c:v>28.6</c:v>
                </c:pt>
                <c:pt idx="71">
                  <c:v>25.7</c:v>
                </c:pt>
                <c:pt idx="72">
                  <c:v>25.3</c:v>
                </c:pt>
                <c:pt idx="73">
                  <c:v>25.3</c:v>
                </c:pt>
                <c:pt idx="74">
                  <c:v>26.1</c:v>
                </c:pt>
                <c:pt idx="75">
                  <c:v>29.3</c:v>
                </c:pt>
                <c:pt idx="76">
                  <c:v>28.3</c:v>
                </c:pt>
                <c:pt idx="77">
                  <c:v>26.4</c:v>
                </c:pt>
                <c:pt idx="78">
                  <c:v>25.4</c:v>
                </c:pt>
                <c:pt idx="79">
                  <c:v>25.6</c:v>
                </c:pt>
                <c:pt idx="80">
                  <c:v>26.5</c:v>
                </c:pt>
                <c:pt idx="81">
                  <c:v>32.6</c:v>
                </c:pt>
                <c:pt idx="82">
                  <c:v>27.1</c:v>
                </c:pt>
                <c:pt idx="83">
                  <c:v>27.5</c:v>
                </c:pt>
                <c:pt idx="84">
                  <c:v>27.5</c:v>
                </c:pt>
                <c:pt idx="85">
                  <c:v>27.1</c:v>
                </c:pt>
                <c:pt idx="86">
                  <c:v>28.1</c:v>
                </c:pt>
                <c:pt idx="87">
                  <c:v>32.6</c:v>
                </c:pt>
                <c:pt idx="88">
                  <c:v>27</c:v>
                </c:pt>
                <c:pt idx="89">
                  <c:v>29</c:v>
                </c:pt>
                <c:pt idx="90">
                  <c:v>35.299999999999997</c:v>
                </c:pt>
                <c:pt idx="91">
                  <c:v>31.4</c:v>
                </c:pt>
                <c:pt idx="92">
                  <c:v>27.3</c:v>
                </c:pt>
                <c:pt idx="93">
                  <c:v>27.6</c:v>
                </c:pt>
                <c:pt idx="94">
                  <c:v>30.7</c:v>
                </c:pt>
                <c:pt idx="95">
                  <c:v>40.700000000000003</c:v>
                </c:pt>
                <c:pt idx="96">
                  <c:v>28.5</c:v>
                </c:pt>
                <c:pt idx="97">
                  <c:v>27.9</c:v>
                </c:pt>
                <c:pt idx="98">
                  <c:v>28.6</c:v>
                </c:pt>
                <c:pt idx="99">
                  <c:v>28.7</c:v>
                </c:pt>
                <c:pt idx="100">
                  <c:v>27.8</c:v>
                </c:pt>
                <c:pt idx="101">
                  <c:v>28.5</c:v>
                </c:pt>
                <c:pt idx="102">
                  <c:v>28.7</c:v>
                </c:pt>
                <c:pt idx="103">
                  <c:v>29</c:v>
                </c:pt>
                <c:pt idx="104">
                  <c:v>29.5</c:v>
                </c:pt>
                <c:pt idx="105">
                  <c:v>30.5</c:v>
                </c:pt>
                <c:pt idx="106">
                  <c:v>31.8</c:v>
                </c:pt>
                <c:pt idx="107">
                  <c:v>31.9</c:v>
                </c:pt>
                <c:pt idx="108">
                  <c:v>31.4</c:v>
                </c:pt>
                <c:pt idx="109">
                  <c:v>29.9</c:v>
                </c:pt>
                <c:pt idx="110">
                  <c:v>31.5</c:v>
                </c:pt>
                <c:pt idx="111">
                  <c:v>36</c:v>
                </c:pt>
                <c:pt idx="112">
                  <c:v>30.2</c:v>
                </c:pt>
                <c:pt idx="113">
                  <c:v>30.5</c:v>
                </c:pt>
                <c:pt idx="114">
                  <c:v>29.7</c:v>
                </c:pt>
                <c:pt idx="115">
                  <c:v>30.6</c:v>
                </c:pt>
                <c:pt idx="116">
                  <c:v>31.1</c:v>
                </c:pt>
                <c:pt idx="117">
                  <c:v>31.6</c:v>
                </c:pt>
                <c:pt idx="118">
                  <c:v>32.5</c:v>
                </c:pt>
                <c:pt idx="119">
                  <c:v>34.200000000000003</c:v>
                </c:pt>
                <c:pt idx="120">
                  <c:v>34</c:v>
                </c:pt>
                <c:pt idx="121">
                  <c:v>32.200000000000003</c:v>
                </c:pt>
              </c:numCache>
            </c:numRef>
          </c:val>
          <c:smooth val="0"/>
        </c:ser>
        <c:dLbls>
          <c:showLegendKey val="0"/>
          <c:showVal val="0"/>
          <c:showCatName val="0"/>
          <c:showSerName val="0"/>
          <c:showPercent val="0"/>
          <c:showBubbleSize val="0"/>
        </c:dLbls>
        <c:marker val="1"/>
        <c:smooth val="0"/>
        <c:axId val="95055232"/>
        <c:axId val="94766592"/>
      </c:lineChart>
      <c:catAx>
        <c:axId val="95055232"/>
        <c:scaling>
          <c:orientation val="minMax"/>
        </c:scaling>
        <c:delete val="0"/>
        <c:axPos val="b"/>
        <c:title>
          <c:tx>
            <c:rich>
              <a:bodyPr/>
              <a:lstStyle/>
              <a:p>
                <a:pPr>
                  <a:defRPr b="0" i="0" baseline="0">
                    <a:latin typeface="Calibri" panose="020F0502020204030204" pitchFamily="34" charset="0"/>
                  </a:defRPr>
                </a:pPr>
                <a:r>
                  <a:rPr lang="en-US" b="0" i="0" baseline="0">
                    <a:latin typeface="Calibri" panose="020F0502020204030204" pitchFamily="34" charset="0"/>
                  </a:rPr>
                  <a:t>Date</a:t>
                </a:r>
              </a:p>
            </c:rich>
          </c:tx>
          <c:layout/>
          <c:overlay val="0"/>
        </c:title>
        <c:numFmt formatCode="General" sourceLinked="1"/>
        <c:majorTickMark val="out"/>
        <c:minorTickMark val="none"/>
        <c:tickLblPos val="nextTo"/>
        <c:txPr>
          <a:bodyPr/>
          <a:lstStyle/>
          <a:p>
            <a:pPr>
              <a:defRPr sz="900" baseline="0"/>
            </a:pPr>
            <a:endParaRPr lang="he-IL"/>
          </a:p>
        </c:txPr>
        <c:crossAx val="94766592"/>
        <c:crosses val="autoZero"/>
        <c:auto val="1"/>
        <c:lblAlgn val="ctr"/>
        <c:lblOffset val="100"/>
        <c:noMultiLvlLbl val="0"/>
      </c:catAx>
      <c:valAx>
        <c:axId val="94766592"/>
        <c:scaling>
          <c:orientation val="minMax"/>
        </c:scaling>
        <c:delete val="0"/>
        <c:axPos val="l"/>
        <c:majorGridlines/>
        <c:title>
          <c:tx>
            <c:rich>
              <a:bodyPr rot="-5400000" vert="horz"/>
              <a:lstStyle/>
              <a:p>
                <a:pPr>
                  <a:defRPr b="0" i="0"/>
                </a:pPr>
                <a:r>
                  <a:rPr lang="en-US" b="0" i="0"/>
                  <a:t>Temperature (</a:t>
                </a:r>
                <a:r>
                  <a:rPr lang="en-US" b="0" i="0" baseline="30000"/>
                  <a:t>o</a:t>
                </a:r>
                <a:r>
                  <a:rPr lang="en-US" b="0" i="0"/>
                  <a:t>C)</a:t>
                </a:r>
              </a:p>
            </c:rich>
          </c:tx>
          <c:layout>
            <c:manualLayout>
              <c:xMode val="edge"/>
              <c:yMode val="edge"/>
              <c:x val="0.13979521160711103"/>
              <c:y val="0.16075411234255277"/>
            </c:manualLayout>
          </c:layout>
          <c:overlay val="0"/>
        </c:title>
        <c:numFmt formatCode="General" sourceLinked="1"/>
        <c:majorTickMark val="out"/>
        <c:minorTickMark val="none"/>
        <c:tickLblPos val="nextTo"/>
        <c:crossAx val="95055232"/>
        <c:crosses val="autoZero"/>
        <c:crossBetween val="between"/>
      </c:valAx>
    </c:plotArea>
    <c:legend>
      <c:legendPos val="l"/>
      <c:layout>
        <c:manualLayout>
          <c:xMode val="edge"/>
          <c:yMode val="edge"/>
          <c:x val="0.28061870334794908"/>
          <c:y val="8.8788286483554357E-2"/>
          <c:w val="0.15504345693812494"/>
          <c:h val="0.16890067688907306"/>
        </c:manualLayout>
      </c:layout>
      <c:overlay val="0"/>
      <c:spPr>
        <a:solidFill>
          <a:schemeClr val="bg1"/>
        </a:solidFill>
      </c:spPr>
      <c:txPr>
        <a:bodyPr/>
        <a:lstStyle/>
        <a:p>
          <a:pPr>
            <a:defRPr sz="900"/>
          </a:pPr>
          <a:endParaRPr lang="he-IL"/>
        </a:p>
      </c:txPr>
    </c:legend>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strRef>
              <c:f>'BE winter 11-2015 to 4-2016'!$L$2</c:f>
              <c:strCache>
                <c:ptCount val="1"/>
                <c:pt idx="0">
                  <c:v>Day min</c:v>
                </c:pt>
              </c:strCache>
            </c:strRef>
          </c:tx>
          <c:spPr>
            <a:ln w="12700"/>
          </c:spPr>
          <c:marker>
            <c:symbol val="diamond"/>
            <c:size val="3"/>
            <c:spPr>
              <a:solidFill>
                <a:srgbClr val="0070C0"/>
              </a:solidFill>
            </c:spPr>
          </c:marker>
          <c:cat>
            <c:strRef>
              <c:f>'BE winter 11-2015 to 4-2016'!$K$3:$K$172</c:f>
              <c:strCache>
                <c:ptCount val="170"/>
                <c:pt idx="0">
                  <c:v>01/11/2014</c:v>
                </c:pt>
                <c:pt idx="1">
                  <c:v>02/11/2014</c:v>
                </c:pt>
                <c:pt idx="2">
                  <c:v>03/11/2014</c:v>
                </c:pt>
                <c:pt idx="3">
                  <c:v>04/11/2014</c:v>
                </c:pt>
                <c:pt idx="4">
                  <c:v>05/11/2014</c:v>
                </c:pt>
                <c:pt idx="5">
                  <c:v>06/11/2014</c:v>
                </c:pt>
                <c:pt idx="6">
                  <c:v>07/11/2014</c:v>
                </c:pt>
                <c:pt idx="7">
                  <c:v>08/11/2014</c:v>
                </c:pt>
                <c:pt idx="8">
                  <c:v>09/11/2014</c:v>
                </c:pt>
                <c:pt idx="9">
                  <c:v>10/11/2014</c:v>
                </c:pt>
                <c:pt idx="10">
                  <c:v>11/11/2014</c:v>
                </c:pt>
                <c:pt idx="11">
                  <c:v>12/11/2014</c:v>
                </c:pt>
                <c:pt idx="12">
                  <c:v>13/11/2014</c:v>
                </c:pt>
                <c:pt idx="13">
                  <c:v>14/11/2014</c:v>
                </c:pt>
                <c:pt idx="14">
                  <c:v>15/11/2014</c:v>
                </c:pt>
                <c:pt idx="15">
                  <c:v>16/11/2014</c:v>
                </c:pt>
                <c:pt idx="16">
                  <c:v>17/11/2014</c:v>
                </c:pt>
                <c:pt idx="17">
                  <c:v>18/11/2014</c:v>
                </c:pt>
                <c:pt idx="18">
                  <c:v>19/11/2014</c:v>
                </c:pt>
                <c:pt idx="19">
                  <c:v>20/11/2014</c:v>
                </c:pt>
                <c:pt idx="20">
                  <c:v>21/11/2014</c:v>
                </c:pt>
                <c:pt idx="21">
                  <c:v>22/11/2014</c:v>
                </c:pt>
                <c:pt idx="22">
                  <c:v>23/11/2014</c:v>
                </c:pt>
                <c:pt idx="23">
                  <c:v>24/11/2014</c:v>
                </c:pt>
                <c:pt idx="24">
                  <c:v>25/11/2014</c:v>
                </c:pt>
                <c:pt idx="25">
                  <c:v>26/11/2014</c:v>
                </c:pt>
                <c:pt idx="26">
                  <c:v>27/11/2014</c:v>
                </c:pt>
                <c:pt idx="27">
                  <c:v>28/11/2014</c:v>
                </c:pt>
                <c:pt idx="28">
                  <c:v>29/11/2014</c:v>
                </c:pt>
                <c:pt idx="29">
                  <c:v>30/11/2014</c:v>
                </c:pt>
                <c:pt idx="30">
                  <c:v>01/12/2014</c:v>
                </c:pt>
                <c:pt idx="31">
                  <c:v>02/12/2014</c:v>
                </c:pt>
                <c:pt idx="32">
                  <c:v>03/12/2014</c:v>
                </c:pt>
                <c:pt idx="33">
                  <c:v>04/12/2014</c:v>
                </c:pt>
                <c:pt idx="34">
                  <c:v>05/12/2014</c:v>
                </c:pt>
                <c:pt idx="35">
                  <c:v>06/12/2014</c:v>
                </c:pt>
                <c:pt idx="36">
                  <c:v>07/12/2014</c:v>
                </c:pt>
                <c:pt idx="37">
                  <c:v>08/12/2014</c:v>
                </c:pt>
                <c:pt idx="38">
                  <c:v>09/12/2014</c:v>
                </c:pt>
                <c:pt idx="39">
                  <c:v>10/12/2014</c:v>
                </c:pt>
                <c:pt idx="40">
                  <c:v>11/12/2014</c:v>
                </c:pt>
                <c:pt idx="41">
                  <c:v>12/12/2014</c:v>
                </c:pt>
                <c:pt idx="42">
                  <c:v>13/12/2014</c:v>
                </c:pt>
                <c:pt idx="43">
                  <c:v>14/12/2014</c:v>
                </c:pt>
                <c:pt idx="44">
                  <c:v>15/12/2014</c:v>
                </c:pt>
                <c:pt idx="45">
                  <c:v>16/12/2014</c:v>
                </c:pt>
                <c:pt idx="46">
                  <c:v>17/12/2014</c:v>
                </c:pt>
                <c:pt idx="47">
                  <c:v>18/12/2014</c:v>
                </c:pt>
                <c:pt idx="48">
                  <c:v>19/12/2014</c:v>
                </c:pt>
                <c:pt idx="49">
                  <c:v>20/12/2014</c:v>
                </c:pt>
                <c:pt idx="50">
                  <c:v>21/12/2014</c:v>
                </c:pt>
                <c:pt idx="51">
                  <c:v>22/12/2014</c:v>
                </c:pt>
                <c:pt idx="52">
                  <c:v>23/12/2014</c:v>
                </c:pt>
                <c:pt idx="53">
                  <c:v>24/12/2014</c:v>
                </c:pt>
                <c:pt idx="54">
                  <c:v>25/12/2014</c:v>
                </c:pt>
                <c:pt idx="55">
                  <c:v>26/12/2014</c:v>
                </c:pt>
                <c:pt idx="56">
                  <c:v>27/12/2014</c:v>
                </c:pt>
                <c:pt idx="57">
                  <c:v>28/12/2014</c:v>
                </c:pt>
                <c:pt idx="58">
                  <c:v>29/12/2014</c:v>
                </c:pt>
                <c:pt idx="59">
                  <c:v>30/12/2014</c:v>
                </c:pt>
                <c:pt idx="60">
                  <c:v>31/12/2014</c:v>
                </c:pt>
                <c:pt idx="61">
                  <c:v>01/01/2015</c:v>
                </c:pt>
                <c:pt idx="62">
                  <c:v>02/01/2015</c:v>
                </c:pt>
                <c:pt idx="63">
                  <c:v>03/01/2015</c:v>
                </c:pt>
                <c:pt idx="64">
                  <c:v>04/01/2015</c:v>
                </c:pt>
                <c:pt idx="65">
                  <c:v>05/01/2015</c:v>
                </c:pt>
                <c:pt idx="66">
                  <c:v>06/01/2015</c:v>
                </c:pt>
                <c:pt idx="67">
                  <c:v>07/01/2015</c:v>
                </c:pt>
                <c:pt idx="68">
                  <c:v>08/01/2015</c:v>
                </c:pt>
                <c:pt idx="69">
                  <c:v>09/01/2015</c:v>
                </c:pt>
                <c:pt idx="70">
                  <c:v>10/01/2015</c:v>
                </c:pt>
                <c:pt idx="71">
                  <c:v>11/01/2015</c:v>
                </c:pt>
                <c:pt idx="72">
                  <c:v>12/01/2015</c:v>
                </c:pt>
                <c:pt idx="73">
                  <c:v>13/01/2015</c:v>
                </c:pt>
                <c:pt idx="74">
                  <c:v>14/01/2015</c:v>
                </c:pt>
                <c:pt idx="75">
                  <c:v>15/01/2015</c:v>
                </c:pt>
                <c:pt idx="76">
                  <c:v>16/01/2015</c:v>
                </c:pt>
                <c:pt idx="77">
                  <c:v>17/01/2015</c:v>
                </c:pt>
                <c:pt idx="78">
                  <c:v>18/01/2015</c:v>
                </c:pt>
                <c:pt idx="79">
                  <c:v>19/01/2015</c:v>
                </c:pt>
                <c:pt idx="80">
                  <c:v>20/01/2015</c:v>
                </c:pt>
                <c:pt idx="81">
                  <c:v>21/01/2015</c:v>
                </c:pt>
                <c:pt idx="82">
                  <c:v>22/01/2015</c:v>
                </c:pt>
                <c:pt idx="83">
                  <c:v>23/01/2015</c:v>
                </c:pt>
                <c:pt idx="84">
                  <c:v>24/01/2015</c:v>
                </c:pt>
                <c:pt idx="85">
                  <c:v>25/01/2015</c:v>
                </c:pt>
                <c:pt idx="86">
                  <c:v>26/01/2015</c:v>
                </c:pt>
                <c:pt idx="87">
                  <c:v>27/01/2015</c:v>
                </c:pt>
                <c:pt idx="88">
                  <c:v>28/01/2015</c:v>
                </c:pt>
                <c:pt idx="89">
                  <c:v>29/01/2015</c:v>
                </c:pt>
                <c:pt idx="90">
                  <c:v>30/01/2015</c:v>
                </c:pt>
                <c:pt idx="91">
                  <c:v>31/01/2015</c:v>
                </c:pt>
                <c:pt idx="92">
                  <c:v>01/02/2015</c:v>
                </c:pt>
                <c:pt idx="93">
                  <c:v>02/02/2015</c:v>
                </c:pt>
                <c:pt idx="94">
                  <c:v>03/02/2015</c:v>
                </c:pt>
                <c:pt idx="95">
                  <c:v>04/02/2015</c:v>
                </c:pt>
                <c:pt idx="96">
                  <c:v>05/02/2015</c:v>
                </c:pt>
                <c:pt idx="97">
                  <c:v>06/02/2015</c:v>
                </c:pt>
                <c:pt idx="98">
                  <c:v>07/02/2015</c:v>
                </c:pt>
                <c:pt idx="99">
                  <c:v>08/02/2015</c:v>
                </c:pt>
                <c:pt idx="100">
                  <c:v>09/02/2015</c:v>
                </c:pt>
                <c:pt idx="101">
                  <c:v>10/02/2015</c:v>
                </c:pt>
                <c:pt idx="102">
                  <c:v>11/02/2015</c:v>
                </c:pt>
                <c:pt idx="103">
                  <c:v>12/02/2015</c:v>
                </c:pt>
                <c:pt idx="104">
                  <c:v>13/02/2015</c:v>
                </c:pt>
                <c:pt idx="105">
                  <c:v>14/02/2015</c:v>
                </c:pt>
                <c:pt idx="106">
                  <c:v>15/02/2015</c:v>
                </c:pt>
                <c:pt idx="107">
                  <c:v>16/02/2015</c:v>
                </c:pt>
                <c:pt idx="108">
                  <c:v>17/02/2015</c:v>
                </c:pt>
                <c:pt idx="109">
                  <c:v>18/02/2015</c:v>
                </c:pt>
                <c:pt idx="110">
                  <c:v>19/02/2015</c:v>
                </c:pt>
                <c:pt idx="111">
                  <c:v>20/02/2015</c:v>
                </c:pt>
                <c:pt idx="112">
                  <c:v>21/02/2015</c:v>
                </c:pt>
                <c:pt idx="113">
                  <c:v>22/02/2015</c:v>
                </c:pt>
                <c:pt idx="114">
                  <c:v>23/02/2015</c:v>
                </c:pt>
                <c:pt idx="115">
                  <c:v>24/02/2015</c:v>
                </c:pt>
                <c:pt idx="116">
                  <c:v>25/02/2015</c:v>
                </c:pt>
                <c:pt idx="117">
                  <c:v>26/02/2015</c:v>
                </c:pt>
                <c:pt idx="118">
                  <c:v>27/02/2015</c:v>
                </c:pt>
                <c:pt idx="119">
                  <c:v>28/02/2015</c:v>
                </c:pt>
                <c:pt idx="120">
                  <c:v>01/03/2015</c:v>
                </c:pt>
                <c:pt idx="121">
                  <c:v>02/03/2015</c:v>
                </c:pt>
                <c:pt idx="122">
                  <c:v>03/03/2015</c:v>
                </c:pt>
                <c:pt idx="123">
                  <c:v>04/03/2015</c:v>
                </c:pt>
                <c:pt idx="124">
                  <c:v>05/03/2015</c:v>
                </c:pt>
                <c:pt idx="125">
                  <c:v>06/03/2015</c:v>
                </c:pt>
                <c:pt idx="126">
                  <c:v>07/03/2015</c:v>
                </c:pt>
                <c:pt idx="127">
                  <c:v>08/03/2015</c:v>
                </c:pt>
                <c:pt idx="128">
                  <c:v>09/03/2015</c:v>
                </c:pt>
                <c:pt idx="129">
                  <c:v>10/03/2015</c:v>
                </c:pt>
                <c:pt idx="130">
                  <c:v>11/03/2015</c:v>
                </c:pt>
                <c:pt idx="131">
                  <c:v>12/03/2015</c:v>
                </c:pt>
                <c:pt idx="132">
                  <c:v>13/03/2015</c:v>
                </c:pt>
                <c:pt idx="133">
                  <c:v>14/03/2015</c:v>
                </c:pt>
                <c:pt idx="134">
                  <c:v>15/03/2015</c:v>
                </c:pt>
                <c:pt idx="135">
                  <c:v>16/03/2015</c:v>
                </c:pt>
                <c:pt idx="136">
                  <c:v>17/03/2015</c:v>
                </c:pt>
                <c:pt idx="137">
                  <c:v>18/03/2015</c:v>
                </c:pt>
                <c:pt idx="138">
                  <c:v>19/03/2015</c:v>
                </c:pt>
                <c:pt idx="139">
                  <c:v>20/03/2015</c:v>
                </c:pt>
                <c:pt idx="140">
                  <c:v>21/03/2015</c:v>
                </c:pt>
                <c:pt idx="141">
                  <c:v>22/03/2015</c:v>
                </c:pt>
                <c:pt idx="142">
                  <c:v>23/03/2015</c:v>
                </c:pt>
                <c:pt idx="143">
                  <c:v>24/03/2015</c:v>
                </c:pt>
                <c:pt idx="144">
                  <c:v>25/03/2015</c:v>
                </c:pt>
                <c:pt idx="145">
                  <c:v>26/03/2015</c:v>
                </c:pt>
                <c:pt idx="146">
                  <c:v>27/03/2015</c:v>
                </c:pt>
                <c:pt idx="147">
                  <c:v>28/03/2015</c:v>
                </c:pt>
                <c:pt idx="148">
                  <c:v>29/03/2015</c:v>
                </c:pt>
                <c:pt idx="149">
                  <c:v>30/03/2015</c:v>
                </c:pt>
                <c:pt idx="150">
                  <c:v>31/03/2015</c:v>
                </c:pt>
                <c:pt idx="151">
                  <c:v>01/04/2015</c:v>
                </c:pt>
                <c:pt idx="152">
                  <c:v>02/04/2015</c:v>
                </c:pt>
                <c:pt idx="153">
                  <c:v>03/04/2015</c:v>
                </c:pt>
                <c:pt idx="154">
                  <c:v>04/04/2015</c:v>
                </c:pt>
                <c:pt idx="155">
                  <c:v>05/04/2015</c:v>
                </c:pt>
                <c:pt idx="156">
                  <c:v>06/04/2015</c:v>
                </c:pt>
                <c:pt idx="157">
                  <c:v>07/04/2015</c:v>
                </c:pt>
                <c:pt idx="158">
                  <c:v>08/04/2015</c:v>
                </c:pt>
                <c:pt idx="159">
                  <c:v>09/04/2015</c:v>
                </c:pt>
                <c:pt idx="160">
                  <c:v>10/04/2015</c:v>
                </c:pt>
                <c:pt idx="161">
                  <c:v>11/04/2015</c:v>
                </c:pt>
                <c:pt idx="162">
                  <c:v>12/04/2015</c:v>
                </c:pt>
                <c:pt idx="163">
                  <c:v>13/04/2015</c:v>
                </c:pt>
                <c:pt idx="164">
                  <c:v>14/04/2015</c:v>
                </c:pt>
                <c:pt idx="165">
                  <c:v>15/04/2015</c:v>
                </c:pt>
                <c:pt idx="166">
                  <c:v>16/04/2015</c:v>
                </c:pt>
                <c:pt idx="167">
                  <c:v>17/04/2015</c:v>
                </c:pt>
                <c:pt idx="168">
                  <c:v>18/04/2015</c:v>
                </c:pt>
                <c:pt idx="169">
                  <c:v>19/04/2015</c:v>
                </c:pt>
              </c:strCache>
            </c:strRef>
          </c:cat>
          <c:val>
            <c:numRef>
              <c:f>'BE winter 11-2015 to 4-2016'!$L$3:$L$172</c:f>
              <c:numCache>
                <c:formatCode>General</c:formatCode>
                <c:ptCount val="170"/>
                <c:pt idx="0">
                  <c:v>16.399999999999999</c:v>
                </c:pt>
                <c:pt idx="1">
                  <c:v>16.600000000000001</c:v>
                </c:pt>
                <c:pt idx="2">
                  <c:v>16.600000000000001</c:v>
                </c:pt>
                <c:pt idx="3">
                  <c:v>16.600000000000001</c:v>
                </c:pt>
                <c:pt idx="4">
                  <c:v>14.7</c:v>
                </c:pt>
                <c:pt idx="5">
                  <c:v>12.6</c:v>
                </c:pt>
                <c:pt idx="6">
                  <c:v>10.8</c:v>
                </c:pt>
                <c:pt idx="7">
                  <c:v>10.6</c:v>
                </c:pt>
                <c:pt idx="8">
                  <c:v>11.5</c:v>
                </c:pt>
                <c:pt idx="9">
                  <c:v>12.9</c:v>
                </c:pt>
                <c:pt idx="10">
                  <c:v>15.4</c:v>
                </c:pt>
                <c:pt idx="11">
                  <c:v>13.6</c:v>
                </c:pt>
                <c:pt idx="12">
                  <c:v>13</c:v>
                </c:pt>
                <c:pt idx="13">
                  <c:v>13.1</c:v>
                </c:pt>
                <c:pt idx="14">
                  <c:v>13</c:v>
                </c:pt>
                <c:pt idx="15">
                  <c:v>13.4</c:v>
                </c:pt>
                <c:pt idx="16">
                  <c:v>15.8</c:v>
                </c:pt>
                <c:pt idx="17">
                  <c:v>13.8</c:v>
                </c:pt>
                <c:pt idx="18">
                  <c:v>11.8</c:v>
                </c:pt>
                <c:pt idx="19">
                  <c:v>12.1</c:v>
                </c:pt>
                <c:pt idx="20">
                  <c:v>13.7</c:v>
                </c:pt>
                <c:pt idx="21">
                  <c:v>18</c:v>
                </c:pt>
                <c:pt idx="22">
                  <c:v>13.3</c:v>
                </c:pt>
                <c:pt idx="23">
                  <c:v>12.4</c:v>
                </c:pt>
                <c:pt idx="24">
                  <c:v>11.8</c:v>
                </c:pt>
                <c:pt idx="25">
                  <c:v>12.5</c:v>
                </c:pt>
                <c:pt idx="26">
                  <c:v>11.9</c:v>
                </c:pt>
                <c:pt idx="27">
                  <c:v>12.2</c:v>
                </c:pt>
                <c:pt idx="28">
                  <c:v>10.6</c:v>
                </c:pt>
                <c:pt idx="29">
                  <c:v>10.6</c:v>
                </c:pt>
                <c:pt idx="30">
                  <c:v>10.8</c:v>
                </c:pt>
                <c:pt idx="31">
                  <c:v>11.2</c:v>
                </c:pt>
                <c:pt idx="32">
                  <c:v>11.4</c:v>
                </c:pt>
                <c:pt idx="33">
                  <c:v>11.6</c:v>
                </c:pt>
                <c:pt idx="34">
                  <c:v>11.6</c:v>
                </c:pt>
                <c:pt idx="35">
                  <c:v>10.1</c:v>
                </c:pt>
                <c:pt idx="36">
                  <c:v>10.3</c:v>
                </c:pt>
                <c:pt idx="37">
                  <c:v>12.3</c:v>
                </c:pt>
                <c:pt idx="38">
                  <c:v>14</c:v>
                </c:pt>
                <c:pt idx="39">
                  <c:v>10.8</c:v>
                </c:pt>
                <c:pt idx="40">
                  <c:v>8.5</c:v>
                </c:pt>
                <c:pt idx="41">
                  <c:v>13.2</c:v>
                </c:pt>
                <c:pt idx="42">
                  <c:v>9.8000000000000007</c:v>
                </c:pt>
                <c:pt idx="43">
                  <c:v>11.4</c:v>
                </c:pt>
                <c:pt idx="44">
                  <c:v>10.199999999999999</c:v>
                </c:pt>
                <c:pt idx="45">
                  <c:v>9.4</c:v>
                </c:pt>
                <c:pt idx="46">
                  <c:v>9</c:v>
                </c:pt>
                <c:pt idx="47">
                  <c:v>10</c:v>
                </c:pt>
                <c:pt idx="48">
                  <c:v>11.4</c:v>
                </c:pt>
                <c:pt idx="49">
                  <c:v>10.199999999999999</c:v>
                </c:pt>
                <c:pt idx="50">
                  <c:v>10.9</c:v>
                </c:pt>
                <c:pt idx="51">
                  <c:v>10.1</c:v>
                </c:pt>
                <c:pt idx="52">
                  <c:v>12.2</c:v>
                </c:pt>
                <c:pt idx="53">
                  <c:v>9.1999999999999993</c:v>
                </c:pt>
                <c:pt idx="54">
                  <c:v>7.3</c:v>
                </c:pt>
                <c:pt idx="55">
                  <c:v>6.4</c:v>
                </c:pt>
                <c:pt idx="56">
                  <c:v>9.3000000000000007</c:v>
                </c:pt>
                <c:pt idx="57">
                  <c:v>10</c:v>
                </c:pt>
                <c:pt idx="58">
                  <c:v>6.8</c:v>
                </c:pt>
                <c:pt idx="59">
                  <c:v>6.8</c:v>
                </c:pt>
                <c:pt idx="60">
                  <c:v>6</c:v>
                </c:pt>
                <c:pt idx="61">
                  <c:v>9.5</c:v>
                </c:pt>
                <c:pt idx="62">
                  <c:v>7.4</c:v>
                </c:pt>
                <c:pt idx="63">
                  <c:v>8.1</c:v>
                </c:pt>
                <c:pt idx="64">
                  <c:v>7.8</c:v>
                </c:pt>
                <c:pt idx="65">
                  <c:v>8.5</c:v>
                </c:pt>
                <c:pt idx="66">
                  <c:v>11.5</c:v>
                </c:pt>
                <c:pt idx="67">
                  <c:v>6.9</c:v>
                </c:pt>
                <c:pt idx="68">
                  <c:v>8.1999999999999993</c:v>
                </c:pt>
                <c:pt idx="69">
                  <c:v>3.6</c:v>
                </c:pt>
                <c:pt idx="70">
                  <c:v>3.1</c:v>
                </c:pt>
                <c:pt idx="71">
                  <c:v>5.7</c:v>
                </c:pt>
                <c:pt idx="72">
                  <c:v>4.5</c:v>
                </c:pt>
                <c:pt idx="73">
                  <c:v>3.4</c:v>
                </c:pt>
                <c:pt idx="74">
                  <c:v>4.9000000000000004</c:v>
                </c:pt>
                <c:pt idx="75">
                  <c:v>8.1999999999999993</c:v>
                </c:pt>
                <c:pt idx="76">
                  <c:v>8.1999999999999993</c:v>
                </c:pt>
                <c:pt idx="77">
                  <c:v>7.7</c:v>
                </c:pt>
                <c:pt idx="78">
                  <c:v>5.3</c:v>
                </c:pt>
                <c:pt idx="79">
                  <c:v>6.8</c:v>
                </c:pt>
                <c:pt idx="80">
                  <c:v>4.4000000000000004</c:v>
                </c:pt>
                <c:pt idx="81">
                  <c:v>5.3</c:v>
                </c:pt>
                <c:pt idx="82">
                  <c:v>4</c:v>
                </c:pt>
                <c:pt idx="83">
                  <c:v>7</c:v>
                </c:pt>
                <c:pt idx="84">
                  <c:v>7.8</c:v>
                </c:pt>
                <c:pt idx="85">
                  <c:v>9.6</c:v>
                </c:pt>
                <c:pt idx="86">
                  <c:v>10.9</c:v>
                </c:pt>
                <c:pt idx="87">
                  <c:v>8.4</c:v>
                </c:pt>
                <c:pt idx="88">
                  <c:v>9.8000000000000007</c:v>
                </c:pt>
                <c:pt idx="89">
                  <c:v>8.1999999999999993</c:v>
                </c:pt>
                <c:pt idx="90">
                  <c:v>6.6</c:v>
                </c:pt>
                <c:pt idx="91">
                  <c:v>4.5999999999999996</c:v>
                </c:pt>
                <c:pt idx="92">
                  <c:v>4.5999999999999996</c:v>
                </c:pt>
                <c:pt idx="93">
                  <c:v>2.8</c:v>
                </c:pt>
                <c:pt idx="94">
                  <c:v>4.3</c:v>
                </c:pt>
                <c:pt idx="95">
                  <c:v>6.1</c:v>
                </c:pt>
                <c:pt idx="96">
                  <c:v>5.6</c:v>
                </c:pt>
                <c:pt idx="97">
                  <c:v>5.6</c:v>
                </c:pt>
                <c:pt idx="98">
                  <c:v>10.3</c:v>
                </c:pt>
                <c:pt idx="99">
                  <c:v>9.5</c:v>
                </c:pt>
                <c:pt idx="100">
                  <c:v>7.2</c:v>
                </c:pt>
                <c:pt idx="101">
                  <c:v>6.4</c:v>
                </c:pt>
                <c:pt idx="102">
                  <c:v>9.6999999999999993</c:v>
                </c:pt>
                <c:pt idx="103">
                  <c:v>8</c:v>
                </c:pt>
                <c:pt idx="104">
                  <c:v>8.5</c:v>
                </c:pt>
                <c:pt idx="105">
                  <c:v>7.3</c:v>
                </c:pt>
                <c:pt idx="106">
                  <c:v>5.8</c:v>
                </c:pt>
                <c:pt idx="107">
                  <c:v>8.1</c:v>
                </c:pt>
                <c:pt idx="108">
                  <c:v>6.1</c:v>
                </c:pt>
                <c:pt idx="109">
                  <c:v>9</c:v>
                </c:pt>
                <c:pt idx="110">
                  <c:v>4.9000000000000004</c:v>
                </c:pt>
                <c:pt idx="111">
                  <c:v>4.5999999999999996</c:v>
                </c:pt>
                <c:pt idx="112">
                  <c:v>6.3</c:v>
                </c:pt>
                <c:pt idx="113">
                  <c:v>6.1</c:v>
                </c:pt>
                <c:pt idx="114">
                  <c:v>5.7</c:v>
                </c:pt>
                <c:pt idx="115">
                  <c:v>10.199999999999999</c:v>
                </c:pt>
                <c:pt idx="116">
                  <c:v>9</c:v>
                </c:pt>
                <c:pt idx="117">
                  <c:v>6.2</c:v>
                </c:pt>
                <c:pt idx="118">
                  <c:v>8.4</c:v>
                </c:pt>
                <c:pt idx="119">
                  <c:v>9.9</c:v>
                </c:pt>
                <c:pt idx="120">
                  <c:v>7.4</c:v>
                </c:pt>
                <c:pt idx="121">
                  <c:v>9.3000000000000007</c:v>
                </c:pt>
                <c:pt idx="122">
                  <c:v>6.8</c:v>
                </c:pt>
                <c:pt idx="123">
                  <c:v>9.3000000000000007</c:v>
                </c:pt>
                <c:pt idx="124">
                  <c:v>7.2</c:v>
                </c:pt>
                <c:pt idx="125">
                  <c:v>6.6</c:v>
                </c:pt>
                <c:pt idx="126">
                  <c:v>13.9</c:v>
                </c:pt>
                <c:pt idx="127">
                  <c:v>10.8</c:v>
                </c:pt>
                <c:pt idx="128">
                  <c:v>9.9</c:v>
                </c:pt>
                <c:pt idx="129">
                  <c:v>14.9</c:v>
                </c:pt>
                <c:pt idx="130">
                  <c:v>13.9</c:v>
                </c:pt>
                <c:pt idx="131">
                  <c:v>10</c:v>
                </c:pt>
                <c:pt idx="132">
                  <c:v>7.3</c:v>
                </c:pt>
                <c:pt idx="133">
                  <c:v>6.5</c:v>
                </c:pt>
                <c:pt idx="134">
                  <c:v>7.9</c:v>
                </c:pt>
                <c:pt idx="135">
                  <c:v>7.7</c:v>
                </c:pt>
                <c:pt idx="136">
                  <c:v>6.6</c:v>
                </c:pt>
                <c:pt idx="137">
                  <c:v>6</c:v>
                </c:pt>
                <c:pt idx="138">
                  <c:v>9.3000000000000007</c:v>
                </c:pt>
                <c:pt idx="139">
                  <c:v>8.1999999999999993</c:v>
                </c:pt>
                <c:pt idx="140">
                  <c:v>6.8</c:v>
                </c:pt>
                <c:pt idx="141">
                  <c:v>9.1999999999999993</c:v>
                </c:pt>
                <c:pt idx="142">
                  <c:v>5.8</c:v>
                </c:pt>
                <c:pt idx="143">
                  <c:v>9.5</c:v>
                </c:pt>
                <c:pt idx="144">
                  <c:v>7.9</c:v>
                </c:pt>
                <c:pt idx="145">
                  <c:v>7.8</c:v>
                </c:pt>
                <c:pt idx="146">
                  <c:v>12.3</c:v>
                </c:pt>
                <c:pt idx="147">
                  <c:v>16.399999999999999</c:v>
                </c:pt>
                <c:pt idx="148">
                  <c:v>13.1</c:v>
                </c:pt>
                <c:pt idx="149">
                  <c:v>11</c:v>
                </c:pt>
                <c:pt idx="150">
                  <c:v>10.3</c:v>
                </c:pt>
                <c:pt idx="151">
                  <c:v>13.7</c:v>
                </c:pt>
                <c:pt idx="152">
                  <c:v>12.3</c:v>
                </c:pt>
                <c:pt idx="153">
                  <c:v>13.2</c:v>
                </c:pt>
                <c:pt idx="154">
                  <c:v>11</c:v>
                </c:pt>
                <c:pt idx="155">
                  <c:v>9.1999999999999993</c:v>
                </c:pt>
                <c:pt idx="156">
                  <c:v>8.1999999999999993</c:v>
                </c:pt>
                <c:pt idx="157">
                  <c:v>11.1</c:v>
                </c:pt>
                <c:pt idx="158">
                  <c:v>11.6</c:v>
                </c:pt>
                <c:pt idx="159">
                  <c:v>13.8</c:v>
                </c:pt>
                <c:pt idx="160">
                  <c:v>10.199999999999999</c:v>
                </c:pt>
                <c:pt idx="161">
                  <c:v>9.4</c:v>
                </c:pt>
                <c:pt idx="162">
                  <c:v>10.1</c:v>
                </c:pt>
                <c:pt idx="163">
                  <c:v>10.7</c:v>
                </c:pt>
                <c:pt idx="164">
                  <c:v>10.3</c:v>
                </c:pt>
                <c:pt idx="165">
                  <c:v>7.8</c:v>
                </c:pt>
                <c:pt idx="166">
                  <c:v>12.8</c:v>
                </c:pt>
                <c:pt idx="167">
                  <c:v>11.5</c:v>
                </c:pt>
                <c:pt idx="168">
                  <c:v>10.4</c:v>
                </c:pt>
                <c:pt idx="169">
                  <c:v>8.5</c:v>
                </c:pt>
              </c:numCache>
            </c:numRef>
          </c:val>
          <c:smooth val="0"/>
        </c:ser>
        <c:ser>
          <c:idx val="1"/>
          <c:order val="1"/>
          <c:tx>
            <c:strRef>
              <c:f>'BE winter 11-2015 to 4-2016'!$M$2</c:f>
              <c:strCache>
                <c:ptCount val="1"/>
                <c:pt idx="0">
                  <c:v>Day max</c:v>
                </c:pt>
              </c:strCache>
            </c:strRef>
          </c:tx>
          <c:spPr>
            <a:ln w="15875"/>
          </c:spPr>
          <c:marker>
            <c:symbol val="square"/>
            <c:size val="2"/>
          </c:marker>
          <c:cat>
            <c:strRef>
              <c:f>'BE winter 11-2015 to 4-2016'!$K$3:$K$172</c:f>
              <c:strCache>
                <c:ptCount val="170"/>
                <c:pt idx="0">
                  <c:v>01/11/2014</c:v>
                </c:pt>
                <c:pt idx="1">
                  <c:v>02/11/2014</c:v>
                </c:pt>
                <c:pt idx="2">
                  <c:v>03/11/2014</c:v>
                </c:pt>
                <c:pt idx="3">
                  <c:v>04/11/2014</c:v>
                </c:pt>
                <c:pt idx="4">
                  <c:v>05/11/2014</c:v>
                </c:pt>
                <c:pt idx="5">
                  <c:v>06/11/2014</c:v>
                </c:pt>
                <c:pt idx="6">
                  <c:v>07/11/2014</c:v>
                </c:pt>
                <c:pt idx="7">
                  <c:v>08/11/2014</c:v>
                </c:pt>
                <c:pt idx="8">
                  <c:v>09/11/2014</c:v>
                </c:pt>
                <c:pt idx="9">
                  <c:v>10/11/2014</c:v>
                </c:pt>
                <c:pt idx="10">
                  <c:v>11/11/2014</c:v>
                </c:pt>
                <c:pt idx="11">
                  <c:v>12/11/2014</c:v>
                </c:pt>
                <c:pt idx="12">
                  <c:v>13/11/2014</c:v>
                </c:pt>
                <c:pt idx="13">
                  <c:v>14/11/2014</c:v>
                </c:pt>
                <c:pt idx="14">
                  <c:v>15/11/2014</c:v>
                </c:pt>
                <c:pt idx="15">
                  <c:v>16/11/2014</c:v>
                </c:pt>
                <c:pt idx="16">
                  <c:v>17/11/2014</c:v>
                </c:pt>
                <c:pt idx="17">
                  <c:v>18/11/2014</c:v>
                </c:pt>
                <c:pt idx="18">
                  <c:v>19/11/2014</c:v>
                </c:pt>
                <c:pt idx="19">
                  <c:v>20/11/2014</c:v>
                </c:pt>
                <c:pt idx="20">
                  <c:v>21/11/2014</c:v>
                </c:pt>
                <c:pt idx="21">
                  <c:v>22/11/2014</c:v>
                </c:pt>
                <c:pt idx="22">
                  <c:v>23/11/2014</c:v>
                </c:pt>
                <c:pt idx="23">
                  <c:v>24/11/2014</c:v>
                </c:pt>
                <c:pt idx="24">
                  <c:v>25/11/2014</c:v>
                </c:pt>
                <c:pt idx="25">
                  <c:v>26/11/2014</c:v>
                </c:pt>
                <c:pt idx="26">
                  <c:v>27/11/2014</c:v>
                </c:pt>
                <c:pt idx="27">
                  <c:v>28/11/2014</c:v>
                </c:pt>
                <c:pt idx="28">
                  <c:v>29/11/2014</c:v>
                </c:pt>
                <c:pt idx="29">
                  <c:v>30/11/2014</c:v>
                </c:pt>
                <c:pt idx="30">
                  <c:v>01/12/2014</c:v>
                </c:pt>
                <c:pt idx="31">
                  <c:v>02/12/2014</c:v>
                </c:pt>
                <c:pt idx="32">
                  <c:v>03/12/2014</c:v>
                </c:pt>
                <c:pt idx="33">
                  <c:v>04/12/2014</c:v>
                </c:pt>
                <c:pt idx="34">
                  <c:v>05/12/2014</c:v>
                </c:pt>
                <c:pt idx="35">
                  <c:v>06/12/2014</c:v>
                </c:pt>
                <c:pt idx="36">
                  <c:v>07/12/2014</c:v>
                </c:pt>
                <c:pt idx="37">
                  <c:v>08/12/2014</c:v>
                </c:pt>
                <c:pt idx="38">
                  <c:v>09/12/2014</c:v>
                </c:pt>
                <c:pt idx="39">
                  <c:v>10/12/2014</c:v>
                </c:pt>
                <c:pt idx="40">
                  <c:v>11/12/2014</c:v>
                </c:pt>
                <c:pt idx="41">
                  <c:v>12/12/2014</c:v>
                </c:pt>
                <c:pt idx="42">
                  <c:v>13/12/2014</c:v>
                </c:pt>
                <c:pt idx="43">
                  <c:v>14/12/2014</c:v>
                </c:pt>
                <c:pt idx="44">
                  <c:v>15/12/2014</c:v>
                </c:pt>
                <c:pt idx="45">
                  <c:v>16/12/2014</c:v>
                </c:pt>
                <c:pt idx="46">
                  <c:v>17/12/2014</c:v>
                </c:pt>
                <c:pt idx="47">
                  <c:v>18/12/2014</c:v>
                </c:pt>
                <c:pt idx="48">
                  <c:v>19/12/2014</c:v>
                </c:pt>
                <c:pt idx="49">
                  <c:v>20/12/2014</c:v>
                </c:pt>
                <c:pt idx="50">
                  <c:v>21/12/2014</c:v>
                </c:pt>
                <c:pt idx="51">
                  <c:v>22/12/2014</c:v>
                </c:pt>
                <c:pt idx="52">
                  <c:v>23/12/2014</c:v>
                </c:pt>
                <c:pt idx="53">
                  <c:v>24/12/2014</c:v>
                </c:pt>
                <c:pt idx="54">
                  <c:v>25/12/2014</c:v>
                </c:pt>
                <c:pt idx="55">
                  <c:v>26/12/2014</c:v>
                </c:pt>
                <c:pt idx="56">
                  <c:v>27/12/2014</c:v>
                </c:pt>
                <c:pt idx="57">
                  <c:v>28/12/2014</c:v>
                </c:pt>
                <c:pt idx="58">
                  <c:v>29/12/2014</c:v>
                </c:pt>
                <c:pt idx="59">
                  <c:v>30/12/2014</c:v>
                </c:pt>
                <c:pt idx="60">
                  <c:v>31/12/2014</c:v>
                </c:pt>
                <c:pt idx="61">
                  <c:v>01/01/2015</c:v>
                </c:pt>
                <c:pt idx="62">
                  <c:v>02/01/2015</c:v>
                </c:pt>
                <c:pt idx="63">
                  <c:v>03/01/2015</c:v>
                </c:pt>
                <c:pt idx="64">
                  <c:v>04/01/2015</c:v>
                </c:pt>
                <c:pt idx="65">
                  <c:v>05/01/2015</c:v>
                </c:pt>
                <c:pt idx="66">
                  <c:v>06/01/2015</c:v>
                </c:pt>
                <c:pt idx="67">
                  <c:v>07/01/2015</c:v>
                </c:pt>
                <c:pt idx="68">
                  <c:v>08/01/2015</c:v>
                </c:pt>
                <c:pt idx="69">
                  <c:v>09/01/2015</c:v>
                </c:pt>
                <c:pt idx="70">
                  <c:v>10/01/2015</c:v>
                </c:pt>
                <c:pt idx="71">
                  <c:v>11/01/2015</c:v>
                </c:pt>
                <c:pt idx="72">
                  <c:v>12/01/2015</c:v>
                </c:pt>
                <c:pt idx="73">
                  <c:v>13/01/2015</c:v>
                </c:pt>
                <c:pt idx="74">
                  <c:v>14/01/2015</c:v>
                </c:pt>
                <c:pt idx="75">
                  <c:v>15/01/2015</c:v>
                </c:pt>
                <c:pt idx="76">
                  <c:v>16/01/2015</c:v>
                </c:pt>
                <c:pt idx="77">
                  <c:v>17/01/2015</c:v>
                </c:pt>
                <c:pt idx="78">
                  <c:v>18/01/2015</c:v>
                </c:pt>
                <c:pt idx="79">
                  <c:v>19/01/2015</c:v>
                </c:pt>
                <c:pt idx="80">
                  <c:v>20/01/2015</c:v>
                </c:pt>
                <c:pt idx="81">
                  <c:v>21/01/2015</c:v>
                </c:pt>
                <c:pt idx="82">
                  <c:v>22/01/2015</c:v>
                </c:pt>
                <c:pt idx="83">
                  <c:v>23/01/2015</c:v>
                </c:pt>
                <c:pt idx="84">
                  <c:v>24/01/2015</c:v>
                </c:pt>
                <c:pt idx="85">
                  <c:v>25/01/2015</c:v>
                </c:pt>
                <c:pt idx="86">
                  <c:v>26/01/2015</c:v>
                </c:pt>
                <c:pt idx="87">
                  <c:v>27/01/2015</c:v>
                </c:pt>
                <c:pt idx="88">
                  <c:v>28/01/2015</c:v>
                </c:pt>
                <c:pt idx="89">
                  <c:v>29/01/2015</c:v>
                </c:pt>
                <c:pt idx="90">
                  <c:v>30/01/2015</c:v>
                </c:pt>
                <c:pt idx="91">
                  <c:v>31/01/2015</c:v>
                </c:pt>
                <c:pt idx="92">
                  <c:v>01/02/2015</c:v>
                </c:pt>
                <c:pt idx="93">
                  <c:v>02/02/2015</c:v>
                </c:pt>
                <c:pt idx="94">
                  <c:v>03/02/2015</c:v>
                </c:pt>
                <c:pt idx="95">
                  <c:v>04/02/2015</c:v>
                </c:pt>
                <c:pt idx="96">
                  <c:v>05/02/2015</c:v>
                </c:pt>
                <c:pt idx="97">
                  <c:v>06/02/2015</c:v>
                </c:pt>
                <c:pt idx="98">
                  <c:v>07/02/2015</c:v>
                </c:pt>
                <c:pt idx="99">
                  <c:v>08/02/2015</c:v>
                </c:pt>
                <c:pt idx="100">
                  <c:v>09/02/2015</c:v>
                </c:pt>
                <c:pt idx="101">
                  <c:v>10/02/2015</c:v>
                </c:pt>
                <c:pt idx="102">
                  <c:v>11/02/2015</c:v>
                </c:pt>
                <c:pt idx="103">
                  <c:v>12/02/2015</c:v>
                </c:pt>
                <c:pt idx="104">
                  <c:v>13/02/2015</c:v>
                </c:pt>
                <c:pt idx="105">
                  <c:v>14/02/2015</c:v>
                </c:pt>
                <c:pt idx="106">
                  <c:v>15/02/2015</c:v>
                </c:pt>
                <c:pt idx="107">
                  <c:v>16/02/2015</c:v>
                </c:pt>
                <c:pt idx="108">
                  <c:v>17/02/2015</c:v>
                </c:pt>
                <c:pt idx="109">
                  <c:v>18/02/2015</c:v>
                </c:pt>
                <c:pt idx="110">
                  <c:v>19/02/2015</c:v>
                </c:pt>
                <c:pt idx="111">
                  <c:v>20/02/2015</c:v>
                </c:pt>
                <c:pt idx="112">
                  <c:v>21/02/2015</c:v>
                </c:pt>
                <c:pt idx="113">
                  <c:v>22/02/2015</c:v>
                </c:pt>
                <c:pt idx="114">
                  <c:v>23/02/2015</c:v>
                </c:pt>
                <c:pt idx="115">
                  <c:v>24/02/2015</c:v>
                </c:pt>
                <c:pt idx="116">
                  <c:v>25/02/2015</c:v>
                </c:pt>
                <c:pt idx="117">
                  <c:v>26/02/2015</c:v>
                </c:pt>
                <c:pt idx="118">
                  <c:v>27/02/2015</c:v>
                </c:pt>
                <c:pt idx="119">
                  <c:v>28/02/2015</c:v>
                </c:pt>
                <c:pt idx="120">
                  <c:v>01/03/2015</c:v>
                </c:pt>
                <c:pt idx="121">
                  <c:v>02/03/2015</c:v>
                </c:pt>
                <c:pt idx="122">
                  <c:v>03/03/2015</c:v>
                </c:pt>
                <c:pt idx="123">
                  <c:v>04/03/2015</c:v>
                </c:pt>
                <c:pt idx="124">
                  <c:v>05/03/2015</c:v>
                </c:pt>
                <c:pt idx="125">
                  <c:v>06/03/2015</c:v>
                </c:pt>
                <c:pt idx="126">
                  <c:v>07/03/2015</c:v>
                </c:pt>
                <c:pt idx="127">
                  <c:v>08/03/2015</c:v>
                </c:pt>
                <c:pt idx="128">
                  <c:v>09/03/2015</c:v>
                </c:pt>
                <c:pt idx="129">
                  <c:v>10/03/2015</c:v>
                </c:pt>
                <c:pt idx="130">
                  <c:v>11/03/2015</c:v>
                </c:pt>
                <c:pt idx="131">
                  <c:v>12/03/2015</c:v>
                </c:pt>
                <c:pt idx="132">
                  <c:v>13/03/2015</c:v>
                </c:pt>
                <c:pt idx="133">
                  <c:v>14/03/2015</c:v>
                </c:pt>
                <c:pt idx="134">
                  <c:v>15/03/2015</c:v>
                </c:pt>
                <c:pt idx="135">
                  <c:v>16/03/2015</c:v>
                </c:pt>
                <c:pt idx="136">
                  <c:v>17/03/2015</c:v>
                </c:pt>
                <c:pt idx="137">
                  <c:v>18/03/2015</c:v>
                </c:pt>
                <c:pt idx="138">
                  <c:v>19/03/2015</c:v>
                </c:pt>
                <c:pt idx="139">
                  <c:v>20/03/2015</c:v>
                </c:pt>
                <c:pt idx="140">
                  <c:v>21/03/2015</c:v>
                </c:pt>
                <c:pt idx="141">
                  <c:v>22/03/2015</c:v>
                </c:pt>
                <c:pt idx="142">
                  <c:v>23/03/2015</c:v>
                </c:pt>
                <c:pt idx="143">
                  <c:v>24/03/2015</c:v>
                </c:pt>
                <c:pt idx="144">
                  <c:v>25/03/2015</c:v>
                </c:pt>
                <c:pt idx="145">
                  <c:v>26/03/2015</c:v>
                </c:pt>
                <c:pt idx="146">
                  <c:v>27/03/2015</c:v>
                </c:pt>
                <c:pt idx="147">
                  <c:v>28/03/2015</c:v>
                </c:pt>
                <c:pt idx="148">
                  <c:v>29/03/2015</c:v>
                </c:pt>
                <c:pt idx="149">
                  <c:v>30/03/2015</c:v>
                </c:pt>
                <c:pt idx="150">
                  <c:v>31/03/2015</c:v>
                </c:pt>
                <c:pt idx="151">
                  <c:v>01/04/2015</c:v>
                </c:pt>
                <c:pt idx="152">
                  <c:v>02/04/2015</c:v>
                </c:pt>
                <c:pt idx="153">
                  <c:v>03/04/2015</c:v>
                </c:pt>
                <c:pt idx="154">
                  <c:v>04/04/2015</c:v>
                </c:pt>
                <c:pt idx="155">
                  <c:v>05/04/2015</c:v>
                </c:pt>
                <c:pt idx="156">
                  <c:v>06/04/2015</c:v>
                </c:pt>
                <c:pt idx="157">
                  <c:v>07/04/2015</c:v>
                </c:pt>
                <c:pt idx="158">
                  <c:v>08/04/2015</c:v>
                </c:pt>
                <c:pt idx="159">
                  <c:v>09/04/2015</c:v>
                </c:pt>
                <c:pt idx="160">
                  <c:v>10/04/2015</c:v>
                </c:pt>
                <c:pt idx="161">
                  <c:v>11/04/2015</c:v>
                </c:pt>
                <c:pt idx="162">
                  <c:v>12/04/2015</c:v>
                </c:pt>
                <c:pt idx="163">
                  <c:v>13/04/2015</c:v>
                </c:pt>
                <c:pt idx="164">
                  <c:v>14/04/2015</c:v>
                </c:pt>
                <c:pt idx="165">
                  <c:v>15/04/2015</c:v>
                </c:pt>
                <c:pt idx="166">
                  <c:v>16/04/2015</c:v>
                </c:pt>
                <c:pt idx="167">
                  <c:v>17/04/2015</c:v>
                </c:pt>
                <c:pt idx="168">
                  <c:v>18/04/2015</c:v>
                </c:pt>
                <c:pt idx="169">
                  <c:v>19/04/2015</c:v>
                </c:pt>
              </c:strCache>
            </c:strRef>
          </c:cat>
          <c:val>
            <c:numRef>
              <c:f>'BE winter 11-2015 to 4-2016'!$M$3:$M$172</c:f>
              <c:numCache>
                <c:formatCode>General</c:formatCode>
                <c:ptCount val="170"/>
                <c:pt idx="0">
                  <c:v>25.4</c:v>
                </c:pt>
                <c:pt idx="1">
                  <c:v>30.9</c:v>
                </c:pt>
                <c:pt idx="2">
                  <c:v>27.4</c:v>
                </c:pt>
                <c:pt idx="3">
                  <c:v>25.1</c:v>
                </c:pt>
                <c:pt idx="4">
                  <c:v>25.1</c:v>
                </c:pt>
                <c:pt idx="5">
                  <c:v>26.2</c:v>
                </c:pt>
                <c:pt idx="6">
                  <c:v>27.5</c:v>
                </c:pt>
                <c:pt idx="7">
                  <c:v>31.1</c:v>
                </c:pt>
                <c:pt idx="8">
                  <c:v>29.5</c:v>
                </c:pt>
                <c:pt idx="9">
                  <c:v>26.1</c:v>
                </c:pt>
                <c:pt idx="10">
                  <c:v>25.5</c:v>
                </c:pt>
                <c:pt idx="11">
                  <c:v>25.2</c:v>
                </c:pt>
                <c:pt idx="12">
                  <c:v>25.9</c:v>
                </c:pt>
                <c:pt idx="13">
                  <c:v>25.9</c:v>
                </c:pt>
                <c:pt idx="14">
                  <c:v>25.3</c:v>
                </c:pt>
                <c:pt idx="15">
                  <c:v>21.7</c:v>
                </c:pt>
                <c:pt idx="16">
                  <c:v>24.2</c:v>
                </c:pt>
                <c:pt idx="17">
                  <c:v>23.8</c:v>
                </c:pt>
                <c:pt idx="18">
                  <c:v>27.6</c:v>
                </c:pt>
                <c:pt idx="19">
                  <c:v>26</c:v>
                </c:pt>
                <c:pt idx="20">
                  <c:v>24.2</c:v>
                </c:pt>
                <c:pt idx="21">
                  <c:v>23.3</c:v>
                </c:pt>
                <c:pt idx="22">
                  <c:v>20.100000000000001</c:v>
                </c:pt>
                <c:pt idx="23">
                  <c:v>17.5</c:v>
                </c:pt>
                <c:pt idx="24">
                  <c:v>19.5</c:v>
                </c:pt>
                <c:pt idx="25">
                  <c:v>18.5</c:v>
                </c:pt>
                <c:pt idx="26">
                  <c:v>20.100000000000001</c:v>
                </c:pt>
                <c:pt idx="27">
                  <c:v>21.7</c:v>
                </c:pt>
                <c:pt idx="28">
                  <c:v>21.5</c:v>
                </c:pt>
                <c:pt idx="29">
                  <c:v>22.3</c:v>
                </c:pt>
                <c:pt idx="30">
                  <c:v>22.7</c:v>
                </c:pt>
                <c:pt idx="31">
                  <c:v>23.7</c:v>
                </c:pt>
                <c:pt idx="32">
                  <c:v>26.4</c:v>
                </c:pt>
                <c:pt idx="33">
                  <c:v>27.5</c:v>
                </c:pt>
                <c:pt idx="34">
                  <c:v>26</c:v>
                </c:pt>
                <c:pt idx="35">
                  <c:v>24.3</c:v>
                </c:pt>
                <c:pt idx="36">
                  <c:v>23.1</c:v>
                </c:pt>
                <c:pt idx="37">
                  <c:v>23.9</c:v>
                </c:pt>
                <c:pt idx="38">
                  <c:v>22.7</c:v>
                </c:pt>
                <c:pt idx="39">
                  <c:v>22.6</c:v>
                </c:pt>
                <c:pt idx="40">
                  <c:v>25</c:v>
                </c:pt>
                <c:pt idx="41">
                  <c:v>23.6</c:v>
                </c:pt>
                <c:pt idx="42">
                  <c:v>20.6</c:v>
                </c:pt>
                <c:pt idx="43">
                  <c:v>20.3</c:v>
                </c:pt>
                <c:pt idx="44">
                  <c:v>21.2</c:v>
                </c:pt>
                <c:pt idx="45">
                  <c:v>22</c:v>
                </c:pt>
                <c:pt idx="46">
                  <c:v>23</c:v>
                </c:pt>
                <c:pt idx="47">
                  <c:v>21.8</c:v>
                </c:pt>
                <c:pt idx="48">
                  <c:v>18.899999999999999</c:v>
                </c:pt>
                <c:pt idx="49">
                  <c:v>22.5</c:v>
                </c:pt>
                <c:pt idx="50">
                  <c:v>20.6</c:v>
                </c:pt>
                <c:pt idx="51">
                  <c:v>18.5</c:v>
                </c:pt>
                <c:pt idx="52">
                  <c:v>20.399999999999999</c:v>
                </c:pt>
                <c:pt idx="53">
                  <c:v>21.1</c:v>
                </c:pt>
                <c:pt idx="54">
                  <c:v>21.5</c:v>
                </c:pt>
                <c:pt idx="55">
                  <c:v>21.1</c:v>
                </c:pt>
                <c:pt idx="56">
                  <c:v>20.7</c:v>
                </c:pt>
                <c:pt idx="57">
                  <c:v>20.2</c:v>
                </c:pt>
                <c:pt idx="58">
                  <c:v>20.9</c:v>
                </c:pt>
                <c:pt idx="59">
                  <c:v>20.5</c:v>
                </c:pt>
                <c:pt idx="60">
                  <c:v>21.6</c:v>
                </c:pt>
                <c:pt idx="61">
                  <c:v>21.2</c:v>
                </c:pt>
                <c:pt idx="62">
                  <c:v>17.600000000000001</c:v>
                </c:pt>
                <c:pt idx="63">
                  <c:v>17</c:v>
                </c:pt>
                <c:pt idx="64">
                  <c:v>15.5</c:v>
                </c:pt>
                <c:pt idx="65">
                  <c:v>18.600000000000001</c:v>
                </c:pt>
                <c:pt idx="66">
                  <c:v>17</c:v>
                </c:pt>
                <c:pt idx="67">
                  <c:v>12.7</c:v>
                </c:pt>
                <c:pt idx="68">
                  <c:v>15</c:v>
                </c:pt>
                <c:pt idx="69">
                  <c:v>10.8</c:v>
                </c:pt>
                <c:pt idx="70">
                  <c:v>12.2</c:v>
                </c:pt>
                <c:pt idx="71">
                  <c:v>16.8</c:v>
                </c:pt>
                <c:pt idx="72">
                  <c:v>18.100000000000001</c:v>
                </c:pt>
                <c:pt idx="73">
                  <c:v>19.5</c:v>
                </c:pt>
                <c:pt idx="74">
                  <c:v>16.2</c:v>
                </c:pt>
                <c:pt idx="75">
                  <c:v>14.6</c:v>
                </c:pt>
                <c:pt idx="76">
                  <c:v>17.7</c:v>
                </c:pt>
                <c:pt idx="77">
                  <c:v>17</c:v>
                </c:pt>
                <c:pt idx="78">
                  <c:v>18.5</c:v>
                </c:pt>
                <c:pt idx="79">
                  <c:v>17.899999999999999</c:v>
                </c:pt>
                <c:pt idx="80">
                  <c:v>19.100000000000001</c:v>
                </c:pt>
                <c:pt idx="81">
                  <c:v>24.3</c:v>
                </c:pt>
                <c:pt idx="82">
                  <c:v>22.7</c:v>
                </c:pt>
                <c:pt idx="83">
                  <c:v>23.1</c:v>
                </c:pt>
                <c:pt idx="84">
                  <c:v>23.7</c:v>
                </c:pt>
                <c:pt idx="85">
                  <c:v>21</c:v>
                </c:pt>
                <c:pt idx="86">
                  <c:v>20</c:v>
                </c:pt>
                <c:pt idx="87">
                  <c:v>20.2</c:v>
                </c:pt>
                <c:pt idx="88">
                  <c:v>21.2</c:v>
                </c:pt>
                <c:pt idx="89">
                  <c:v>19.7</c:v>
                </c:pt>
                <c:pt idx="90">
                  <c:v>18.5</c:v>
                </c:pt>
                <c:pt idx="91">
                  <c:v>20.8</c:v>
                </c:pt>
                <c:pt idx="92">
                  <c:v>21.6</c:v>
                </c:pt>
                <c:pt idx="93">
                  <c:v>21.4</c:v>
                </c:pt>
                <c:pt idx="94">
                  <c:v>20.9</c:v>
                </c:pt>
                <c:pt idx="95">
                  <c:v>21</c:v>
                </c:pt>
                <c:pt idx="96">
                  <c:v>21.3</c:v>
                </c:pt>
                <c:pt idx="97">
                  <c:v>27.4</c:v>
                </c:pt>
                <c:pt idx="98">
                  <c:v>26.8</c:v>
                </c:pt>
                <c:pt idx="99">
                  <c:v>19.8</c:v>
                </c:pt>
                <c:pt idx="100">
                  <c:v>19.600000000000001</c:v>
                </c:pt>
                <c:pt idx="101">
                  <c:v>19.899999999999999</c:v>
                </c:pt>
                <c:pt idx="102">
                  <c:v>15.8</c:v>
                </c:pt>
                <c:pt idx="103">
                  <c:v>15.3</c:v>
                </c:pt>
                <c:pt idx="104">
                  <c:v>16.100000000000001</c:v>
                </c:pt>
                <c:pt idx="105">
                  <c:v>18</c:v>
                </c:pt>
                <c:pt idx="106">
                  <c:v>16.100000000000001</c:v>
                </c:pt>
                <c:pt idx="107">
                  <c:v>17.100000000000001</c:v>
                </c:pt>
                <c:pt idx="108">
                  <c:v>19.600000000000001</c:v>
                </c:pt>
                <c:pt idx="109">
                  <c:v>17.8</c:v>
                </c:pt>
                <c:pt idx="110">
                  <c:v>12.8</c:v>
                </c:pt>
                <c:pt idx="111">
                  <c:v>14.8</c:v>
                </c:pt>
                <c:pt idx="112">
                  <c:v>15.9</c:v>
                </c:pt>
                <c:pt idx="113">
                  <c:v>18.399999999999999</c:v>
                </c:pt>
                <c:pt idx="114">
                  <c:v>19.2</c:v>
                </c:pt>
                <c:pt idx="115">
                  <c:v>20.399999999999999</c:v>
                </c:pt>
                <c:pt idx="116">
                  <c:v>20.7</c:v>
                </c:pt>
                <c:pt idx="117">
                  <c:v>25.3</c:v>
                </c:pt>
                <c:pt idx="118">
                  <c:v>29.1</c:v>
                </c:pt>
                <c:pt idx="119">
                  <c:v>20.8</c:v>
                </c:pt>
                <c:pt idx="120">
                  <c:v>20.2</c:v>
                </c:pt>
                <c:pt idx="121">
                  <c:v>20.2</c:v>
                </c:pt>
                <c:pt idx="122">
                  <c:v>20.8</c:v>
                </c:pt>
                <c:pt idx="123">
                  <c:v>20.7</c:v>
                </c:pt>
                <c:pt idx="124">
                  <c:v>19.7</c:v>
                </c:pt>
                <c:pt idx="125">
                  <c:v>28.2</c:v>
                </c:pt>
                <c:pt idx="126">
                  <c:v>29.9</c:v>
                </c:pt>
                <c:pt idx="127">
                  <c:v>25.8</c:v>
                </c:pt>
                <c:pt idx="128">
                  <c:v>28.2</c:v>
                </c:pt>
                <c:pt idx="129">
                  <c:v>23.9</c:v>
                </c:pt>
                <c:pt idx="130">
                  <c:v>21.9</c:v>
                </c:pt>
                <c:pt idx="131">
                  <c:v>20.3</c:v>
                </c:pt>
                <c:pt idx="132">
                  <c:v>22.3</c:v>
                </c:pt>
                <c:pt idx="133">
                  <c:v>21.3</c:v>
                </c:pt>
                <c:pt idx="134">
                  <c:v>21.5</c:v>
                </c:pt>
                <c:pt idx="135">
                  <c:v>20.2</c:v>
                </c:pt>
                <c:pt idx="136">
                  <c:v>21.2</c:v>
                </c:pt>
                <c:pt idx="137">
                  <c:v>21.5</c:v>
                </c:pt>
                <c:pt idx="138">
                  <c:v>20.7</c:v>
                </c:pt>
                <c:pt idx="139">
                  <c:v>19.899999999999999</c:v>
                </c:pt>
                <c:pt idx="140">
                  <c:v>20.5</c:v>
                </c:pt>
                <c:pt idx="141">
                  <c:v>20.3</c:v>
                </c:pt>
                <c:pt idx="142">
                  <c:v>21.7</c:v>
                </c:pt>
                <c:pt idx="143">
                  <c:v>23.1</c:v>
                </c:pt>
                <c:pt idx="144">
                  <c:v>24</c:v>
                </c:pt>
                <c:pt idx="145">
                  <c:v>25.8</c:v>
                </c:pt>
                <c:pt idx="146">
                  <c:v>33.700000000000003</c:v>
                </c:pt>
                <c:pt idx="147">
                  <c:v>27.9</c:v>
                </c:pt>
                <c:pt idx="148">
                  <c:v>24.6</c:v>
                </c:pt>
                <c:pt idx="149">
                  <c:v>22.8</c:v>
                </c:pt>
                <c:pt idx="150">
                  <c:v>23.8</c:v>
                </c:pt>
                <c:pt idx="151">
                  <c:v>21.6</c:v>
                </c:pt>
                <c:pt idx="152">
                  <c:v>23.9</c:v>
                </c:pt>
                <c:pt idx="153">
                  <c:v>24.8</c:v>
                </c:pt>
                <c:pt idx="154">
                  <c:v>22.4</c:v>
                </c:pt>
                <c:pt idx="155">
                  <c:v>22.7</c:v>
                </c:pt>
                <c:pt idx="156">
                  <c:v>22.2</c:v>
                </c:pt>
                <c:pt idx="157">
                  <c:v>28.9</c:v>
                </c:pt>
                <c:pt idx="158">
                  <c:v>38.4</c:v>
                </c:pt>
                <c:pt idx="159">
                  <c:v>28</c:v>
                </c:pt>
                <c:pt idx="160">
                  <c:v>20.100000000000001</c:v>
                </c:pt>
                <c:pt idx="161">
                  <c:v>18.3</c:v>
                </c:pt>
                <c:pt idx="162">
                  <c:v>16.7</c:v>
                </c:pt>
                <c:pt idx="163">
                  <c:v>19.899999999999999</c:v>
                </c:pt>
                <c:pt idx="164">
                  <c:v>21.8</c:v>
                </c:pt>
                <c:pt idx="165">
                  <c:v>24.5</c:v>
                </c:pt>
                <c:pt idx="166">
                  <c:v>22.5</c:v>
                </c:pt>
                <c:pt idx="167">
                  <c:v>23.1</c:v>
                </c:pt>
                <c:pt idx="168">
                  <c:v>23.2</c:v>
                </c:pt>
                <c:pt idx="169">
                  <c:v>23.7</c:v>
                </c:pt>
              </c:numCache>
            </c:numRef>
          </c:val>
          <c:smooth val="0"/>
        </c:ser>
        <c:dLbls>
          <c:showLegendKey val="0"/>
          <c:showVal val="0"/>
          <c:showCatName val="0"/>
          <c:showSerName val="0"/>
          <c:showPercent val="0"/>
          <c:showBubbleSize val="0"/>
        </c:dLbls>
        <c:marker val="1"/>
        <c:smooth val="0"/>
        <c:axId val="198578944"/>
        <c:axId val="198580864"/>
      </c:lineChart>
      <c:catAx>
        <c:axId val="198578944"/>
        <c:scaling>
          <c:orientation val="minMax"/>
        </c:scaling>
        <c:delete val="0"/>
        <c:axPos val="b"/>
        <c:title>
          <c:tx>
            <c:rich>
              <a:bodyPr/>
              <a:lstStyle/>
              <a:p>
                <a:pPr>
                  <a:defRPr/>
                </a:pPr>
                <a:r>
                  <a:rPr lang="en-US"/>
                  <a:t>Date</a:t>
                </a:r>
              </a:p>
            </c:rich>
          </c:tx>
          <c:layout/>
          <c:overlay val="0"/>
        </c:title>
        <c:numFmt formatCode="General" sourceLinked="1"/>
        <c:majorTickMark val="out"/>
        <c:minorTickMark val="none"/>
        <c:tickLblPos val="nextTo"/>
        <c:txPr>
          <a:bodyPr/>
          <a:lstStyle/>
          <a:p>
            <a:pPr>
              <a:defRPr sz="900"/>
            </a:pPr>
            <a:endParaRPr lang="he-IL"/>
          </a:p>
        </c:txPr>
        <c:crossAx val="198580864"/>
        <c:crosses val="autoZero"/>
        <c:auto val="1"/>
        <c:lblAlgn val="ctr"/>
        <c:lblOffset val="100"/>
        <c:noMultiLvlLbl val="0"/>
      </c:catAx>
      <c:valAx>
        <c:axId val="198580864"/>
        <c:scaling>
          <c:orientation val="minMax"/>
        </c:scaling>
        <c:delete val="0"/>
        <c:axPos val="l"/>
        <c:majorGridlines>
          <c:spPr>
            <a:ln>
              <a:gradFill>
                <a:gsLst>
                  <a:gs pos="0">
                    <a:schemeClr val="accent1">
                      <a:tint val="66000"/>
                      <a:satMod val="160000"/>
                    </a:schemeClr>
                  </a:gs>
                  <a:gs pos="50000">
                    <a:schemeClr val="accent1">
                      <a:tint val="44500"/>
                      <a:satMod val="160000"/>
                    </a:schemeClr>
                  </a:gs>
                  <a:gs pos="100000">
                    <a:schemeClr val="accent1">
                      <a:tint val="23500"/>
                      <a:satMod val="160000"/>
                    </a:schemeClr>
                  </a:gs>
                </a:gsLst>
                <a:lin ang="5400000" scaled="0"/>
              </a:gradFill>
            </a:ln>
          </c:spPr>
        </c:majorGridlines>
        <c:title>
          <c:tx>
            <c:rich>
              <a:bodyPr rot="-5400000" vert="horz"/>
              <a:lstStyle/>
              <a:p>
                <a:pPr>
                  <a:defRPr b="0" i="0">
                    <a:latin typeface="Calibri" panose="020F0502020204030204" pitchFamily="34" charset="0"/>
                  </a:defRPr>
                </a:pPr>
                <a:r>
                  <a:rPr lang="en-US" b="0" i="0">
                    <a:latin typeface="Calibri" panose="020F0502020204030204" pitchFamily="34" charset="0"/>
                  </a:rPr>
                  <a:t>Temperature (</a:t>
                </a:r>
                <a:r>
                  <a:rPr lang="en-US" b="0" i="0" baseline="30000">
                    <a:latin typeface="Calibri" panose="020F0502020204030204" pitchFamily="34" charset="0"/>
                  </a:rPr>
                  <a:t>o</a:t>
                </a:r>
                <a:r>
                  <a:rPr lang="en-US" b="0" i="0">
                    <a:latin typeface="Calibri" panose="020F0502020204030204" pitchFamily="34" charset="0"/>
                  </a:rPr>
                  <a:t>C)</a:t>
                </a:r>
              </a:p>
            </c:rich>
          </c:tx>
          <c:layout>
            <c:manualLayout>
              <c:xMode val="edge"/>
              <c:yMode val="edge"/>
              <c:x val="0.1379268004307298"/>
              <c:y val="0.18151512009170059"/>
            </c:manualLayout>
          </c:layout>
          <c:overlay val="0"/>
        </c:title>
        <c:numFmt formatCode="General" sourceLinked="1"/>
        <c:majorTickMark val="out"/>
        <c:minorTickMark val="none"/>
        <c:tickLblPos val="nextTo"/>
        <c:txPr>
          <a:bodyPr/>
          <a:lstStyle/>
          <a:p>
            <a:pPr>
              <a:defRPr b="1"/>
            </a:pPr>
            <a:endParaRPr lang="he-IL"/>
          </a:p>
        </c:txPr>
        <c:crossAx val="198578944"/>
        <c:crosses val="autoZero"/>
        <c:crossBetween val="between"/>
      </c:valAx>
    </c:plotArea>
    <c:legend>
      <c:legendPos val="l"/>
      <c:layout>
        <c:manualLayout>
          <c:xMode val="edge"/>
          <c:yMode val="edge"/>
          <c:x val="0.49111757702791531"/>
          <c:y val="6.4360804899387572E-2"/>
          <c:w val="0.15166080597193304"/>
          <c:h val="0.16046964129483815"/>
        </c:manualLayout>
      </c:layout>
      <c:overlay val="0"/>
      <c:spPr>
        <a:solidFill>
          <a:schemeClr val="bg1"/>
        </a:solidFill>
      </c:spPr>
      <c:txPr>
        <a:bodyPr/>
        <a:lstStyle/>
        <a:p>
          <a:pPr>
            <a:defRPr b="0" baseline="0">
              <a:ln>
                <a:noFill/>
              </a:ln>
              <a:latin typeface="Calibri" panose="020F0502020204030204" pitchFamily="34" charset="0"/>
            </a:defRPr>
          </a:pPr>
          <a:endParaRPr lang="he-IL"/>
        </a:p>
      </c:txPr>
    </c:legend>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he-IL"/>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ndard"/>
        <c:varyColors val="0"/>
        <c:ser>
          <c:idx val="0"/>
          <c:order val="0"/>
          <c:tx>
            <c:strRef>
              <c:f>'BE summer 5- 6-2016'!$C$1</c:f>
              <c:strCache>
                <c:ptCount val="1"/>
                <c:pt idx="0">
                  <c:v>Day max</c:v>
                </c:pt>
              </c:strCache>
            </c:strRef>
          </c:tx>
          <c:spPr>
            <a:ln w="15875">
              <a:solidFill>
                <a:srgbClr val="FF0000"/>
              </a:solidFill>
            </a:ln>
          </c:spPr>
          <c:marker>
            <c:symbol val="diamond"/>
            <c:size val="3"/>
            <c:spPr>
              <a:solidFill>
                <a:srgbClr val="FF0000"/>
              </a:solidFill>
              <a:ln>
                <a:solidFill>
                  <a:srgbClr val="FF0000"/>
                </a:solidFill>
              </a:ln>
            </c:spPr>
          </c:marker>
          <c:cat>
            <c:strRef>
              <c:f>'BE summer 5- 6-2016'!$A$2:$A$58</c:f>
              <c:strCache>
                <c:ptCount val="57"/>
                <c:pt idx="0">
                  <c:v>01/05/2016</c:v>
                </c:pt>
                <c:pt idx="1">
                  <c:v>02/05/2016</c:v>
                </c:pt>
                <c:pt idx="2">
                  <c:v>03/05/2016</c:v>
                </c:pt>
                <c:pt idx="3">
                  <c:v>04/05/2016</c:v>
                </c:pt>
                <c:pt idx="4">
                  <c:v>05/05/2016</c:v>
                </c:pt>
                <c:pt idx="5">
                  <c:v>06/05/2016</c:v>
                </c:pt>
                <c:pt idx="6">
                  <c:v>07/05/2016</c:v>
                </c:pt>
                <c:pt idx="7">
                  <c:v>08/05/2016</c:v>
                </c:pt>
                <c:pt idx="8">
                  <c:v>09/05/2016</c:v>
                </c:pt>
                <c:pt idx="9">
                  <c:v>10/05/2016</c:v>
                </c:pt>
                <c:pt idx="10">
                  <c:v>11/05/2016</c:v>
                </c:pt>
                <c:pt idx="11">
                  <c:v>12/05/2016</c:v>
                </c:pt>
                <c:pt idx="12">
                  <c:v>13/05/2016</c:v>
                </c:pt>
                <c:pt idx="13">
                  <c:v>14/05/2016</c:v>
                </c:pt>
                <c:pt idx="14">
                  <c:v>15/05/2016</c:v>
                </c:pt>
                <c:pt idx="15">
                  <c:v>16/05/2016</c:v>
                </c:pt>
                <c:pt idx="16">
                  <c:v>17/05/2016</c:v>
                </c:pt>
                <c:pt idx="17">
                  <c:v>18/05/2016</c:v>
                </c:pt>
                <c:pt idx="18">
                  <c:v>19/05/2016</c:v>
                </c:pt>
                <c:pt idx="19">
                  <c:v>20/05/2016</c:v>
                </c:pt>
                <c:pt idx="20">
                  <c:v>21/05/2016</c:v>
                </c:pt>
                <c:pt idx="21">
                  <c:v>22/05/2016</c:v>
                </c:pt>
                <c:pt idx="22">
                  <c:v>23/05/2016</c:v>
                </c:pt>
                <c:pt idx="23">
                  <c:v>24/05/2016</c:v>
                </c:pt>
                <c:pt idx="24">
                  <c:v>25/05/2016</c:v>
                </c:pt>
                <c:pt idx="25">
                  <c:v>26/05/2016</c:v>
                </c:pt>
                <c:pt idx="26">
                  <c:v>27/05/2016</c:v>
                </c:pt>
                <c:pt idx="27">
                  <c:v>28/05/2016</c:v>
                </c:pt>
                <c:pt idx="28">
                  <c:v>29/05/2016</c:v>
                </c:pt>
                <c:pt idx="29">
                  <c:v>30/05/2016</c:v>
                </c:pt>
                <c:pt idx="30">
                  <c:v>31/05/2016</c:v>
                </c:pt>
                <c:pt idx="31">
                  <c:v>01/06/2016</c:v>
                </c:pt>
                <c:pt idx="32">
                  <c:v>02/06/2016</c:v>
                </c:pt>
                <c:pt idx="33">
                  <c:v>03/06/2016</c:v>
                </c:pt>
                <c:pt idx="34">
                  <c:v>04/06/2016</c:v>
                </c:pt>
                <c:pt idx="35">
                  <c:v>05/06/2016</c:v>
                </c:pt>
                <c:pt idx="36">
                  <c:v>06/06/2016</c:v>
                </c:pt>
                <c:pt idx="37">
                  <c:v>07/06/2016</c:v>
                </c:pt>
                <c:pt idx="38">
                  <c:v>08/06/2016</c:v>
                </c:pt>
                <c:pt idx="39">
                  <c:v>09/06/2016</c:v>
                </c:pt>
                <c:pt idx="40">
                  <c:v>10/06/2016</c:v>
                </c:pt>
                <c:pt idx="41">
                  <c:v>11/06/2016</c:v>
                </c:pt>
                <c:pt idx="42">
                  <c:v>12/06/2016</c:v>
                </c:pt>
                <c:pt idx="43">
                  <c:v>13/06/2016</c:v>
                </c:pt>
                <c:pt idx="44">
                  <c:v>14/06/2016</c:v>
                </c:pt>
                <c:pt idx="45">
                  <c:v>15/06/2016</c:v>
                </c:pt>
                <c:pt idx="46">
                  <c:v>16/06/2016</c:v>
                </c:pt>
                <c:pt idx="47">
                  <c:v>17/06/2016</c:v>
                </c:pt>
                <c:pt idx="48">
                  <c:v>18/06/2016</c:v>
                </c:pt>
                <c:pt idx="49">
                  <c:v>19/06/2016</c:v>
                </c:pt>
                <c:pt idx="50">
                  <c:v>20/06/2016</c:v>
                </c:pt>
                <c:pt idx="51">
                  <c:v>21/06/2016</c:v>
                </c:pt>
                <c:pt idx="52">
                  <c:v>22/06/2016</c:v>
                </c:pt>
                <c:pt idx="53">
                  <c:v>23/06/2016</c:v>
                </c:pt>
                <c:pt idx="54">
                  <c:v>24/06/2016</c:v>
                </c:pt>
                <c:pt idx="55">
                  <c:v>25/06/2016</c:v>
                </c:pt>
                <c:pt idx="56">
                  <c:v>26/06/2016</c:v>
                </c:pt>
              </c:strCache>
            </c:strRef>
          </c:cat>
          <c:val>
            <c:numRef>
              <c:f>'BE summer 5- 6-2016'!$C$2:$C$58</c:f>
              <c:numCache>
                <c:formatCode>General</c:formatCode>
                <c:ptCount val="57"/>
                <c:pt idx="0">
                  <c:v>34.5</c:v>
                </c:pt>
                <c:pt idx="1">
                  <c:v>28.5</c:v>
                </c:pt>
                <c:pt idx="2">
                  <c:v>32.4</c:v>
                </c:pt>
                <c:pt idx="3">
                  <c:v>26.4</c:v>
                </c:pt>
                <c:pt idx="4">
                  <c:v>28.1</c:v>
                </c:pt>
                <c:pt idx="5">
                  <c:v>25.8</c:v>
                </c:pt>
                <c:pt idx="6">
                  <c:v>25.9</c:v>
                </c:pt>
                <c:pt idx="7">
                  <c:v>25.3</c:v>
                </c:pt>
                <c:pt idx="8">
                  <c:v>27.4</c:v>
                </c:pt>
                <c:pt idx="9">
                  <c:v>26</c:v>
                </c:pt>
                <c:pt idx="10">
                  <c:v>27.4</c:v>
                </c:pt>
                <c:pt idx="11">
                  <c:v>27.5</c:v>
                </c:pt>
                <c:pt idx="12">
                  <c:v>31.4</c:v>
                </c:pt>
                <c:pt idx="13">
                  <c:v>38</c:v>
                </c:pt>
                <c:pt idx="14">
                  <c:v>40.200000000000003</c:v>
                </c:pt>
                <c:pt idx="15">
                  <c:v>37.5</c:v>
                </c:pt>
                <c:pt idx="16">
                  <c:v>29.6</c:v>
                </c:pt>
                <c:pt idx="17">
                  <c:v>26.7</c:v>
                </c:pt>
                <c:pt idx="18">
                  <c:v>27.2</c:v>
                </c:pt>
                <c:pt idx="19">
                  <c:v>26.8</c:v>
                </c:pt>
                <c:pt idx="20">
                  <c:v>27.4</c:v>
                </c:pt>
                <c:pt idx="21">
                  <c:v>37.4</c:v>
                </c:pt>
                <c:pt idx="22">
                  <c:v>26.4</c:v>
                </c:pt>
                <c:pt idx="23">
                  <c:v>27</c:v>
                </c:pt>
                <c:pt idx="24">
                  <c:v>27.6</c:v>
                </c:pt>
                <c:pt idx="25">
                  <c:v>36.200000000000003</c:v>
                </c:pt>
                <c:pt idx="26">
                  <c:v>26.7</c:v>
                </c:pt>
                <c:pt idx="27">
                  <c:v>26.5</c:v>
                </c:pt>
                <c:pt idx="28">
                  <c:v>27.6</c:v>
                </c:pt>
                <c:pt idx="29">
                  <c:v>28.9</c:v>
                </c:pt>
                <c:pt idx="30">
                  <c:v>30.5</c:v>
                </c:pt>
                <c:pt idx="31">
                  <c:v>33</c:v>
                </c:pt>
                <c:pt idx="32">
                  <c:v>32.200000000000003</c:v>
                </c:pt>
                <c:pt idx="33">
                  <c:v>36.9</c:v>
                </c:pt>
                <c:pt idx="34">
                  <c:v>40.6</c:v>
                </c:pt>
                <c:pt idx="35">
                  <c:v>32.299999999999997</c:v>
                </c:pt>
                <c:pt idx="36">
                  <c:v>30.8</c:v>
                </c:pt>
                <c:pt idx="37">
                  <c:v>34.1</c:v>
                </c:pt>
                <c:pt idx="38">
                  <c:v>32.299999999999997</c:v>
                </c:pt>
                <c:pt idx="39">
                  <c:v>29.5</c:v>
                </c:pt>
                <c:pt idx="40">
                  <c:v>29</c:v>
                </c:pt>
                <c:pt idx="41">
                  <c:v>29.2</c:v>
                </c:pt>
                <c:pt idx="42">
                  <c:v>29.3</c:v>
                </c:pt>
                <c:pt idx="43">
                  <c:v>33.799999999999997</c:v>
                </c:pt>
                <c:pt idx="44">
                  <c:v>34.700000000000003</c:v>
                </c:pt>
                <c:pt idx="45">
                  <c:v>34.9</c:v>
                </c:pt>
                <c:pt idx="46">
                  <c:v>30</c:v>
                </c:pt>
                <c:pt idx="47">
                  <c:v>30.6</c:v>
                </c:pt>
                <c:pt idx="48">
                  <c:v>31.6</c:v>
                </c:pt>
                <c:pt idx="49">
                  <c:v>32.9</c:v>
                </c:pt>
                <c:pt idx="50">
                  <c:v>34.1</c:v>
                </c:pt>
                <c:pt idx="53">
                  <c:v>32.200000000000003</c:v>
                </c:pt>
                <c:pt idx="54">
                  <c:v>31.8</c:v>
                </c:pt>
                <c:pt idx="55">
                  <c:v>33</c:v>
                </c:pt>
                <c:pt idx="56">
                  <c:v>32.700000000000003</c:v>
                </c:pt>
              </c:numCache>
            </c:numRef>
          </c:val>
          <c:smooth val="0"/>
        </c:ser>
        <c:ser>
          <c:idx val="1"/>
          <c:order val="1"/>
          <c:tx>
            <c:strRef>
              <c:f>'BE summer 5- 6-2016'!$B$1</c:f>
              <c:strCache>
                <c:ptCount val="1"/>
                <c:pt idx="0">
                  <c:v>Day min</c:v>
                </c:pt>
              </c:strCache>
            </c:strRef>
          </c:tx>
          <c:spPr>
            <a:ln w="15875">
              <a:solidFill>
                <a:srgbClr val="0070C0"/>
              </a:solidFill>
            </a:ln>
          </c:spPr>
          <c:marker>
            <c:symbol val="square"/>
            <c:size val="3"/>
            <c:spPr>
              <a:solidFill>
                <a:schemeClr val="tx2">
                  <a:lumMod val="60000"/>
                  <a:lumOff val="40000"/>
                </a:schemeClr>
              </a:solidFill>
              <a:ln>
                <a:solidFill>
                  <a:srgbClr val="00B0F0"/>
                </a:solidFill>
              </a:ln>
            </c:spPr>
          </c:marker>
          <c:cat>
            <c:strRef>
              <c:f>'BE summer 5- 6-2016'!$A$2:$A$58</c:f>
              <c:strCache>
                <c:ptCount val="57"/>
                <c:pt idx="0">
                  <c:v>01/05/2016</c:v>
                </c:pt>
                <c:pt idx="1">
                  <c:v>02/05/2016</c:v>
                </c:pt>
                <c:pt idx="2">
                  <c:v>03/05/2016</c:v>
                </c:pt>
                <c:pt idx="3">
                  <c:v>04/05/2016</c:v>
                </c:pt>
                <c:pt idx="4">
                  <c:v>05/05/2016</c:v>
                </c:pt>
                <c:pt idx="5">
                  <c:v>06/05/2016</c:v>
                </c:pt>
                <c:pt idx="6">
                  <c:v>07/05/2016</c:v>
                </c:pt>
                <c:pt idx="7">
                  <c:v>08/05/2016</c:v>
                </c:pt>
                <c:pt idx="8">
                  <c:v>09/05/2016</c:v>
                </c:pt>
                <c:pt idx="9">
                  <c:v>10/05/2016</c:v>
                </c:pt>
                <c:pt idx="10">
                  <c:v>11/05/2016</c:v>
                </c:pt>
                <c:pt idx="11">
                  <c:v>12/05/2016</c:v>
                </c:pt>
                <c:pt idx="12">
                  <c:v>13/05/2016</c:v>
                </c:pt>
                <c:pt idx="13">
                  <c:v>14/05/2016</c:v>
                </c:pt>
                <c:pt idx="14">
                  <c:v>15/05/2016</c:v>
                </c:pt>
                <c:pt idx="15">
                  <c:v>16/05/2016</c:v>
                </c:pt>
                <c:pt idx="16">
                  <c:v>17/05/2016</c:v>
                </c:pt>
                <c:pt idx="17">
                  <c:v>18/05/2016</c:v>
                </c:pt>
                <c:pt idx="18">
                  <c:v>19/05/2016</c:v>
                </c:pt>
                <c:pt idx="19">
                  <c:v>20/05/2016</c:v>
                </c:pt>
                <c:pt idx="20">
                  <c:v>21/05/2016</c:v>
                </c:pt>
                <c:pt idx="21">
                  <c:v>22/05/2016</c:v>
                </c:pt>
                <c:pt idx="22">
                  <c:v>23/05/2016</c:v>
                </c:pt>
                <c:pt idx="23">
                  <c:v>24/05/2016</c:v>
                </c:pt>
                <c:pt idx="24">
                  <c:v>25/05/2016</c:v>
                </c:pt>
                <c:pt idx="25">
                  <c:v>26/05/2016</c:v>
                </c:pt>
                <c:pt idx="26">
                  <c:v>27/05/2016</c:v>
                </c:pt>
                <c:pt idx="27">
                  <c:v>28/05/2016</c:v>
                </c:pt>
                <c:pt idx="28">
                  <c:v>29/05/2016</c:v>
                </c:pt>
                <c:pt idx="29">
                  <c:v>30/05/2016</c:v>
                </c:pt>
                <c:pt idx="30">
                  <c:v>31/05/2016</c:v>
                </c:pt>
                <c:pt idx="31">
                  <c:v>01/06/2016</c:v>
                </c:pt>
                <c:pt idx="32">
                  <c:v>02/06/2016</c:v>
                </c:pt>
                <c:pt idx="33">
                  <c:v>03/06/2016</c:v>
                </c:pt>
                <c:pt idx="34">
                  <c:v>04/06/2016</c:v>
                </c:pt>
                <c:pt idx="35">
                  <c:v>05/06/2016</c:v>
                </c:pt>
                <c:pt idx="36">
                  <c:v>06/06/2016</c:v>
                </c:pt>
                <c:pt idx="37">
                  <c:v>07/06/2016</c:v>
                </c:pt>
                <c:pt idx="38">
                  <c:v>08/06/2016</c:v>
                </c:pt>
                <c:pt idx="39">
                  <c:v>09/06/2016</c:v>
                </c:pt>
                <c:pt idx="40">
                  <c:v>10/06/2016</c:v>
                </c:pt>
                <c:pt idx="41">
                  <c:v>11/06/2016</c:v>
                </c:pt>
                <c:pt idx="42">
                  <c:v>12/06/2016</c:v>
                </c:pt>
                <c:pt idx="43">
                  <c:v>13/06/2016</c:v>
                </c:pt>
                <c:pt idx="44">
                  <c:v>14/06/2016</c:v>
                </c:pt>
                <c:pt idx="45">
                  <c:v>15/06/2016</c:v>
                </c:pt>
                <c:pt idx="46">
                  <c:v>16/06/2016</c:v>
                </c:pt>
                <c:pt idx="47">
                  <c:v>17/06/2016</c:v>
                </c:pt>
                <c:pt idx="48">
                  <c:v>18/06/2016</c:v>
                </c:pt>
                <c:pt idx="49">
                  <c:v>19/06/2016</c:v>
                </c:pt>
                <c:pt idx="50">
                  <c:v>20/06/2016</c:v>
                </c:pt>
                <c:pt idx="51">
                  <c:v>21/06/2016</c:v>
                </c:pt>
                <c:pt idx="52">
                  <c:v>22/06/2016</c:v>
                </c:pt>
                <c:pt idx="53">
                  <c:v>23/06/2016</c:v>
                </c:pt>
                <c:pt idx="54">
                  <c:v>24/06/2016</c:v>
                </c:pt>
                <c:pt idx="55">
                  <c:v>25/06/2016</c:v>
                </c:pt>
                <c:pt idx="56">
                  <c:v>26/06/2016</c:v>
                </c:pt>
              </c:strCache>
            </c:strRef>
          </c:cat>
          <c:val>
            <c:numRef>
              <c:f>'BE summer 5- 6-2016'!$B$2:$B$58</c:f>
              <c:numCache>
                <c:formatCode>General</c:formatCode>
                <c:ptCount val="57"/>
                <c:pt idx="0">
                  <c:v>14.5</c:v>
                </c:pt>
                <c:pt idx="1">
                  <c:v>17.2</c:v>
                </c:pt>
                <c:pt idx="2">
                  <c:v>16</c:v>
                </c:pt>
                <c:pt idx="3">
                  <c:v>16.2</c:v>
                </c:pt>
                <c:pt idx="4">
                  <c:v>13.6</c:v>
                </c:pt>
                <c:pt idx="5">
                  <c:v>14.9</c:v>
                </c:pt>
                <c:pt idx="6">
                  <c:v>15.9</c:v>
                </c:pt>
                <c:pt idx="7">
                  <c:v>11.9</c:v>
                </c:pt>
                <c:pt idx="8">
                  <c:v>12.3</c:v>
                </c:pt>
                <c:pt idx="9">
                  <c:v>12.5</c:v>
                </c:pt>
                <c:pt idx="10">
                  <c:v>12.8</c:v>
                </c:pt>
                <c:pt idx="11">
                  <c:v>12.3</c:v>
                </c:pt>
                <c:pt idx="12">
                  <c:v>12.5</c:v>
                </c:pt>
                <c:pt idx="13">
                  <c:v>18</c:v>
                </c:pt>
                <c:pt idx="14">
                  <c:v>19.899999999999999</c:v>
                </c:pt>
                <c:pt idx="15">
                  <c:v>20.399999999999999</c:v>
                </c:pt>
                <c:pt idx="16">
                  <c:v>19</c:v>
                </c:pt>
                <c:pt idx="17">
                  <c:v>17.3</c:v>
                </c:pt>
                <c:pt idx="18">
                  <c:v>15.3</c:v>
                </c:pt>
                <c:pt idx="19">
                  <c:v>12.9</c:v>
                </c:pt>
                <c:pt idx="20">
                  <c:v>14.1</c:v>
                </c:pt>
                <c:pt idx="21">
                  <c:v>14.6</c:v>
                </c:pt>
                <c:pt idx="22">
                  <c:v>19.399999999999999</c:v>
                </c:pt>
                <c:pt idx="23">
                  <c:v>19.600000000000001</c:v>
                </c:pt>
                <c:pt idx="24">
                  <c:v>15.8</c:v>
                </c:pt>
                <c:pt idx="25">
                  <c:v>15.4</c:v>
                </c:pt>
                <c:pt idx="26">
                  <c:v>16.600000000000001</c:v>
                </c:pt>
                <c:pt idx="27">
                  <c:v>18.399999999999999</c:v>
                </c:pt>
                <c:pt idx="28">
                  <c:v>15.8</c:v>
                </c:pt>
                <c:pt idx="29">
                  <c:v>14.4</c:v>
                </c:pt>
                <c:pt idx="30">
                  <c:v>13.8</c:v>
                </c:pt>
                <c:pt idx="31">
                  <c:v>15.9</c:v>
                </c:pt>
                <c:pt idx="32">
                  <c:v>14</c:v>
                </c:pt>
                <c:pt idx="33">
                  <c:v>15.7</c:v>
                </c:pt>
                <c:pt idx="34">
                  <c:v>18.600000000000001</c:v>
                </c:pt>
                <c:pt idx="35">
                  <c:v>19</c:v>
                </c:pt>
                <c:pt idx="36">
                  <c:v>16.399999999999999</c:v>
                </c:pt>
                <c:pt idx="37">
                  <c:v>16.600000000000001</c:v>
                </c:pt>
                <c:pt idx="38">
                  <c:v>17.8</c:v>
                </c:pt>
                <c:pt idx="39">
                  <c:v>19.100000000000001</c:v>
                </c:pt>
                <c:pt idx="40">
                  <c:v>17.600000000000001</c:v>
                </c:pt>
                <c:pt idx="41">
                  <c:v>15.9</c:v>
                </c:pt>
                <c:pt idx="42">
                  <c:v>16.399999999999999</c:v>
                </c:pt>
                <c:pt idx="43">
                  <c:v>15.8</c:v>
                </c:pt>
                <c:pt idx="44">
                  <c:v>19.100000000000001</c:v>
                </c:pt>
                <c:pt idx="45">
                  <c:v>18.8</c:v>
                </c:pt>
                <c:pt idx="46">
                  <c:v>19.399999999999999</c:v>
                </c:pt>
                <c:pt idx="47">
                  <c:v>19.600000000000001</c:v>
                </c:pt>
                <c:pt idx="48">
                  <c:v>19.100000000000001</c:v>
                </c:pt>
                <c:pt idx="49">
                  <c:v>19.7</c:v>
                </c:pt>
                <c:pt idx="50">
                  <c:v>18.600000000000001</c:v>
                </c:pt>
                <c:pt idx="53">
                  <c:v>22.4</c:v>
                </c:pt>
                <c:pt idx="54">
                  <c:v>20.2</c:v>
                </c:pt>
                <c:pt idx="55">
                  <c:v>21.2</c:v>
                </c:pt>
                <c:pt idx="56">
                  <c:v>21.2</c:v>
                </c:pt>
              </c:numCache>
            </c:numRef>
          </c:val>
          <c:smooth val="0"/>
        </c:ser>
        <c:dLbls>
          <c:showLegendKey val="0"/>
          <c:showVal val="0"/>
          <c:showCatName val="0"/>
          <c:showSerName val="0"/>
          <c:showPercent val="0"/>
          <c:showBubbleSize val="0"/>
        </c:dLbls>
        <c:marker val="1"/>
        <c:smooth val="0"/>
        <c:axId val="198665344"/>
        <c:axId val="198667648"/>
      </c:lineChart>
      <c:catAx>
        <c:axId val="198665344"/>
        <c:scaling>
          <c:orientation val="minMax"/>
        </c:scaling>
        <c:delete val="0"/>
        <c:axPos val="b"/>
        <c:title>
          <c:tx>
            <c:rich>
              <a:bodyPr/>
              <a:lstStyle/>
              <a:p>
                <a:pPr>
                  <a:defRPr b="0" i="0" baseline="0">
                    <a:latin typeface="Calibri" panose="020F0502020204030204" pitchFamily="34" charset="0"/>
                  </a:defRPr>
                </a:pPr>
                <a:r>
                  <a:rPr lang="en-US" b="0" i="0" baseline="0">
                    <a:latin typeface="Calibri" panose="020F0502020204030204" pitchFamily="34" charset="0"/>
                  </a:rPr>
                  <a:t>Date</a:t>
                </a:r>
              </a:p>
            </c:rich>
          </c:tx>
          <c:layout/>
          <c:overlay val="0"/>
        </c:title>
        <c:numFmt formatCode="General" sourceLinked="1"/>
        <c:majorTickMark val="out"/>
        <c:minorTickMark val="none"/>
        <c:tickLblPos val="nextTo"/>
        <c:txPr>
          <a:bodyPr/>
          <a:lstStyle/>
          <a:p>
            <a:pPr>
              <a:defRPr sz="900" b="0" baseline="0">
                <a:latin typeface="Calibri" panose="020F0502020204030204" pitchFamily="34" charset="0"/>
              </a:defRPr>
            </a:pPr>
            <a:endParaRPr lang="he-IL"/>
          </a:p>
        </c:txPr>
        <c:crossAx val="198667648"/>
        <c:crosses val="autoZero"/>
        <c:auto val="1"/>
        <c:lblAlgn val="ctr"/>
        <c:lblOffset val="100"/>
        <c:noMultiLvlLbl val="0"/>
      </c:catAx>
      <c:valAx>
        <c:axId val="198667648"/>
        <c:scaling>
          <c:orientation val="minMax"/>
        </c:scaling>
        <c:delete val="0"/>
        <c:axPos val="l"/>
        <c:majorGridlines/>
        <c:title>
          <c:tx>
            <c:rich>
              <a:bodyPr rot="-5400000" vert="horz"/>
              <a:lstStyle/>
              <a:p>
                <a:pPr>
                  <a:defRPr b="0" i="0" baseline="0">
                    <a:latin typeface="Calibri" panose="020F0502020204030204" pitchFamily="34" charset="0"/>
                  </a:defRPr>
                </a:pPr>
                <a:r>
                  <a:rPr lang="en-US" b="0" i="0" baseline="0">
                    <a:latin typeface="Calibri" panose="020F0502020204030204" pitchFamily="34" charset="0"/>
                  </a:rPr>
                  <a:t>Temperature (</a:t>
                </a:r>
                <a:r>
                  <a:rPr lang="en-US" b="0" i="0" baseline="30000">
                    <a:latin typeface="Calibri" panose="020F0502020204030204" pitchFamily="34" charset="0"/>
                  </a:rPr>
                  <a:t>o</a:t>
                </a:r>
                <a:r>
                  <a:rPr lang="en-US" b="0" i="0" baseline="0">
                    <a:latin typeface="Calibri" panose="020F0502020204030204" pitchFamily="34" charset="0"/>
                  </a:rPr>
                  <a:t>C)</a:t>
                </a:r>
              </a:p>
            </c:rich>
          </c:tx>
          <c:layout>
            <c:manualLayout>
              <c:xMode val="edge"/>
              <c:yMode val="edge"/>
              <c:x val="0.14499607488780267"/>
              <c:y val="0.16043733235989649"/>
            </c:manualLayout>
          </c:layout>
          <c:overlay val="0"/>
        </c:title>
        <c:numFmt formatCode="General" sourceLinked="1"/>
        <c:majorTickMark val="out"/>
        <c:minorTickMark val="none"/>
        <c:tickLblPos val="nextTo"/>
        <c:txPr>
          <a:bodyPr/>
          <a:lstStyle/>
          <a:p>
            <a:pPr>
              <a:defRPr b="1"/>
            </a:pPr>
            <a:endParaRPr lang="he-IL"/>
          </a:p>
        </c:txPr>
        <c:crossAx val="198665344"/>
        <c:crosses val="autoZero"/>
        <c:crossBetween val="between"/>
      </c:valAx>
    </c:plotArea>
    <c:legend>
      <c:legendPos val="l"/>
      <c:layout>
        <c:manualLayout>
          <c:xMode val="edge"/>
          <c:yMode val="edge"/>
          <c:x val="0.81287963321668766"/>
          <c:y val="0.41728581083583305"/>
          <c:w val="0.16158265263571026"/>
          <c:h val="0.16020299788107883"/>
        </c:manualLayout>
      </c:layout>
      <c:overlay val="0"/>
      <c:spPr>
        <a:solidFill>
          <a:schemeClr val="bg1"/>
        </a:solidFill>
      </c:spPr>
    </c:legend>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he-IL"/>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he-IL"/>
          </a:p>
        </p:txBody>
      </p:sp>
      <p:sp>
        <p:nvSpPr>
          <p:cNvPr id="4" name="Date Placeholder 3"/>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13035061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he-IL"/>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Date Placeholder 3"/>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25383698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he-IL"/>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Date Placeholder 3"/>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2636532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he-IL"/>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Date Placeholder 3"/>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28027169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r">
              <a:defRPr sz="4000" b="1" cap="all"/>
            </a:lvl1pPr>
          </a:lstStyle>
          <a:p>
            <a:r>
              <a:rPr lang="en-US" smtClean="0"/>
              <a:t>Click to edit Master title style</a:t>
            </a:r>
            <a:endParaRPr lang="he-IL"/>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21613723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he-IL"/>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5" name="Date Placeholder 4"/>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11562070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he-IL"/>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7" name="Date Placeholder 6"/>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8" name="Footer Placeholder 7"/>
          <p:cNvSpPr>
            <a:spLocks noGrp="1"/>
          </p:cNvSpPr>
          <p:nvPr>
            <p:ph type="ftr" sz="quarter" idx="11"/>
          </p:nvPr>
        </p:nvSpPr>
        <p:spPr/>
        <p:txBody>
          <a:bodyPr/>
          <a:lstStyle/>
          <a:p>
            <a:endParaRPr lang="he-IL"/>
          </a:p>
        </p:txBody>
      </p:sp>
      <p:sp>
        <p:nvSpPr>
          <p:cNvPr id="9" name="Slide Number Placeholder 8"/>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6621207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he-IL"/>
          </a:p>
        </p:txBody>
      </p:sp>
      <p:sp>
        <p:nvSpPr>
          <p:cNvPr id="3" name="Date Placeholder 2"/>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4" name="Footer Placeholder 3"/>
          <p:cNvSpPr>
            <a:spLocks noGrp="1"/>
          </p:cNvSpPr>
          <p:nvPr>
            <p:ph type="ftr" sz="quarter" idx="11"/>
          </p:nvPr>
        </p:nvSpPr>
        <p:spPr/>
        <p:txBody>
          <a:bodyPr/>
          <a:lstStyle/>
          <a:p>
            <a:endParaRPr lang="he-IL"/>
          </a:p>
        </p:txBody>
      </p:sp>
      <p:sp>
        <p:nvSpPr>
          <p:cNvPr id="5" name="Slide Number Placeholder 4"/>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17203155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3" name="Footer Placeholder 2"/>
          <p:cNvSpPr>
            <a:spLocks noGrp="1"/>
          </p:cNvSpPr>
          <p:nvPr>
            <p:ph type="ftr" sz="quarter" idx="11"/>
          </p:nvPr>
        </p:nvSpPr>
        <p:spPr/>
        <p:txBody>
          <a:bodyPr/>
          <a:lstStyle/>
          <a:p>
            <a:endParaRPr lang="he-IL"/>
          </a:p>
        </p:txBody>
      </p:sp>
      <p:sp>
        <p:nvSpPr>
          <p:cNvPr id="4" name="Slide Number Placeholder 3"/>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35537954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r">
              <a:defRPr sz="2000" b="1"/>
            </a:lvl1pPr>
          </a:lstStyle>
          <a:p>
            <a:r>
              <a:rPr lang="en-US" smtClean="0"/>
              <a:t>Click to edit Master title style</a:t>
            </a:r>
            <a:endParaRPr lang="he-IL"/>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1503996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r">
              <a:defRPr sz="2000" b="1"/>
            </a:lvl1pPr>
          </a:lstStyle>
          <a:p>
            <a:r>
              <a:rPr lang="en-US" smtClean="0"/>
              <a:t>Click to edit Master title style</a:t>
            </a:r>
            <a:endParaRPr lang="he-IL"/>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7C365F8-5265-4147-AD6E-3CFFD3A0EA97}" type="datetimeFigureOut">
              <a:rPr lang="he-IL" smtClean="0"/>
              <a:t>ט"ו/תשרי/תשע"ז</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EF4AD0D4-2E8B-4A36-9C38-B31C133410D2}" type="slidenum">
              <a:rPr lang="he-IL" smtClean="0"/>
              <a:t>‹#›</a:t>
            </a:fld>
            <a:endParaRPr lang="he-IL"/>
          </a:p>
        </p:txBody>
      </p:sp>
    </p:spTree>
    <p:extLst>
      <p:ext uri="{BB962C8B-B14F-4D97-AF65-F5344CB8AC3E}">
        <p14:creationId xmlns:p14="http://schemas.microsoft.com/office/powerpoint/2010/main" val="11879139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1" anchor="ctr">
            <a:normAutofit/>
          </a:bodyPr>
          <a:lstStyle/>
          <a:p>
            <a:r>
              <a:rPr lang="en-US" smtClean="0"/>
              <a:t>Click to edit Master title style</a:t>
            </a:r>
            <a:endParaRPr lang="he-IL"/>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1">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Date Placeholder 3"/>
          <p:cNvSpPr>
            <a:spLocks noGrp="1"/>
          </p:cNvSpPr>
          <p:nvPr>
            <p:ph type="dt" sz="half" idx="2"/>
          </p:nvPr>
        </p:nvSpPr>
        <p:spPr>
          <a:xfrm>
            <a:off x="4914900" y="8475134"/>
            <a:ext cx="1600200" cy="486833"/>
          </a:xfrm>
          <a:prstGeom prst="rect">
            <a:avLst/>
          </a:prstGeom>
        </p:spPr>
        <p:txBody>
          <a:bodyPr vert="horz" lIns="91440" tIns="45720" rIns="91440" bIns="45720" rtlCol="1" anchor="ctr"/>
          <a:lstStyle>
            <a:lvl1pPr algn="r">
              <a:defRPr sz="1200">
                <a:solidFill>
                  <a:schemeClr val="tx1">
                    <a:tint val="75000"/>
                  </a:schemeClr>
                </a:solidFill>
              </a:defRPr>
            </a:lvl1pPr>
          </a:lstStyle>
          <a:p>
            <a:fld id="{57C365F8-5265-4147-AD6E-3CFFD3A0EA97}" type="datetimeFigureOut">
              <a:rPr lang="he-IL" smtClean="0"/>
              <a:t>ט"ו/תשרי/תשע"ז</a:t>
            </a:fld>
            <a:endParaRPr lang="he-IL"/>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he-IL"/>
          </a:p>
        </p:txBody>
      </p:sp>
      <p:sp>
        <p:nvSpPr>
          <p:cNvPr id="6" name="Slide Number Placeholder 5"/>
          <p:cNvSpPr>
            <a:spLocks noGrp="1"/>
          </p:cNvSpPr>
          <p:nvPr>
            <p:ph type="sldNum" sz="quarter" idx="4"/>
          </p:nvPr>
        </p:nvSpPr>
        <p:spPr>
          <a:xfrm>
            <a:off x="342900" y="8475134"/>
            <a:ext cx="1600200" cy="486833"/>
          </a:xfrm>
          <a:prstGeom prst="rect">
            <a:avLst/>
          </a:prstGeom>
        </p:spPr>
        <p:txBody>
          <a:bodyPr vert="horz" lIns="91440" tIns="45720" rIns="91440" bIns="45720" rtlCol="1" anchor="ctr"/>
          <a:lstStyle>
            <a:lvl1pPr algn="l">
              <a:defRPr sz="1200">
                <a:solidFill>
                  <a:schemeClr val="tx1">
                    <a:tint val="75000"/>
                  </a:schemeClr>
                </a:solidFill>
              </a:defRPr>
            </a:lvl1pPr>
          </a:lstStyle>
          <a:p>
            <a:fld id="{EF4AD0D4-2E8B-4A36-9C38-B31C133410D2}" type="slidenum">
              <a:rPr lang="he-IL" smtClean="0"/>
              <a:t>‹#›</a:t>
            </a:fld>
            <a:endParaRPr lang="he-IL"/>
          </a:p>
        </p:txBody>
      </p:sp>
    </p:spTree>
    <p:extLst>
      <p:ext uri="{BB962C8B-B14F-4D97-AF65-F5344CB8AC3E}">
        <p14:creationId xmlns:p14="http://schemas.microsoft.com/office/powerpoint/2010/main" val="38758341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1" eaLnBrk="1" latinLnBrk="0" hangingPunct="1">
        <a:spcBef>
          <a:spcPct val="0"/>
        </a:spcBef>
        <a:buNone/>
        <a:defRPr sz="4400" kern="1200">
          <a:solidFill>
            <a:schemeClr val="tx1"/>
          </a:solidFill>
          <a:latin typeface="+mj-lt"/>
          <a:ea typeface="+mj-ea"/>
          <a:cs typeface="+mj-cs"/>
        </a:defRPr>
      </a:lvl1pPr>
    </p:titleStyle>
    <p:bodyStyle>
      <a:lvl1pPr marL="342900" indent="-342900" algn="r" defTabSz="914400" rtl="1"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r" defTabSz="914400" rtl="1"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r" defTabSz="914400" rtl="1"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r" defTabSz="914400" rtl="1"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chart" Target="../charts/chart8.xml"/><Relationship Id="rId2" Type="http://schemas.openxmlformats.org/officeDocument/2006/relationships/chart" Target="../charts/chart7.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620688" y="4283968"/>
            <a:ext cx="5972080" cy="1200329"/>
          </a:xfrm>
          <a:prstGeom prst="rect">
            <a:avLst/>
          </a:prstGeom>
          <a:noFill/>
        </p:spPr>
        <p:txBody>
          <a:bodyPr wrap="square" rtlCol="1">
            <a:spAutoFit/>
          </a:bodyPr>
          <a:lstStyle/>
          <a:p>
            <a:pPr algn="just" rtl="0">
              <a:lnSpc>
                <a:spcPct val="150000"/>
              </a:lnSpc>
            </a:pPr>
            <a:r>
              <a:rPr lang="en-US" sz="1200" b="1" dirty="0" smtClean="0"/>
              <a:t>a. </a:t>
            </a:r>
            <a:r>
              <a:rPr lang="en-US" sz="1200" dirty="0" smtClean="0"/>
              <a:t>Heat </a:t>
            </a:r>
            <a:r>
              <a:rPr lang="en-US" sz="1200" dirty="0" smtClean="0"/>
              <a:t>stress during the growth season of the EMS mutagenized  M82 M</a:t>
            </a:r>
            <a:r>
              <a:rPr lang="en-US" sz="1200" baseline="-25000" dirty="0" smtClean="0"/>
              <a:t>2</a:t>
            </a:r>
            <a:r>
              <a:rPr lang="en-US" sz="1200" dirty="0" smtClean="0"/>
              <a:t> population screened for fruit set under heat stress, </a:t>
            </a:r>
            <a:r>
              <a:rPr lang="en-US" sz="1200" dirty="0" smtClean="0"/>
              <a:t>(</a:t>
            </a:r>
            <a:r>
              <a:rPr lang="en-US" sz="1200" dirty="0" smtClean="0"/>
              <a:t>notice the especially high day and night temperatures </a:t>
            </a:r>
            <a:r>
              <a:rPr lang="en-US" sz="1200" dirty="0" smtClean="0"/>
              <a:t>all along </a:t>
            </a:r>
            <a:r>
              <a:rPr lang="en-US" sz="1200" dirty="0" smtClean="0"/>
              <a:t>the  growing season). Seedlings were planted in the field on the 4.7.2009 and screened for parthenocarpic fruit set until 16.9.2009. </a:t>
            </a:r>
            <a:endParaRPr lang="he-IL" sz="1200" dirty="0"/>
          </a:p>
        </p:txBody>
      </p:sp>
      <p:sp>
        <p:nvSpPr>
          <p:cNvPr id="2" name="TextBox 1"/>
          <p:cNvSpPr txBox="1"/>
          <p:nvPr/>
        </p:nvSpPr>
        <p:spPr>
          <a:xfrm>
            <a:off x="548680" y="542837"/>
            <a:ext cx="5972080" cy="1200329"/>
          </a:xfrm>
          <a:prstGeom prst="rect">
            <a:avLst/>
          </a:prstGeom>
          <a:noFill/>
        </p:spPr>
        <p:txBody>
          <a:bodyPr wrap="square" rtlCol="1">
            <a:spAutoFit/>
          </a:bodyPr>
          <a:lstStyle/>
          <a:p>
            <a:pPr algn="l" rtl="0">
              <a:lnSpc>
                <a:spcPct val="150000"/>
              </a:lnSpc>
            </a:pPr>
            <a:r>
              <a:rPr lang="en-US" sz="1200" b="1" dirty="0" smtClean="0"/>
              <a:t>Figure S3</a:t>
            </a:r>
            <a:r>
              <a:rPr lang="en-US" sz="1200" dirty="0" smtClean="0"/>
              <a:t>. </a:t>
            </a:r>
            <a:r>
              <a:rPr lang="en-US" sz="1200" b="1" dirty="0" smtClean="0"/>
              <a:t>Daily maximum and minimum temperatures  experienced by the plants in the various experiments</a:t>
            </a:r>
            <a:r>
              <a:rPr lang="en-US" sz="1200" dirty="0" smtClean="0"/>
              <a:t>. Temperatures were recorded (at </a:t>
            </a:r>
            <a:r>
              <a:rPr lang="en-US" sz="1200" dirty="0" smtClean="0"/>
              <a:t>10 min </a:t>
            </a:r>
            <a:r>
              <a:rPr lang="en-US" sz="1200" dirty="0" smtClean="0"/>
              <a:t>intervals) in meteorological stations  situated  in close proximity  (≤ 5 km) to the locations where the </a:t>
            </a:r>
            <a:r>
              <a:rPr lang="en-US" sz="1200" dirty="0" smtClean="0"/>
              <a:t>plants were </a:t>
            </a:r>
            <a:r>
              <a:rPr lang="en-US" sz="1200" dirty="0" smtClean="0"/>
              <a:t>grown in the  various experiments. </a:t>
            </a:r>
            <a:endParaRPr lang="he-IL" sz="1200" dirty="0"/>
          </a:p>
        </p:txBody>
      </p:sp>
      <p:sp>
        <p:nvSpPr>
          <p:cNvPr id="13" name="TextBox 12"/>
          <p:cNvSpPr txBox="1"/>
          <p:nvPr/>
        </p:nvSpPr>
        <p:spPr>
          <a:xfrm>
            <a:off x="692696" y="7596336"/>
            <a:ext cx="5828064" cy="923330"/>
          </a:xfrm>
          <a:prstGeom prst="rect">
            <a:avLst/>
          </a:prstGeom>
          <a:noFill/>
        </p:spPr>
        <p:txBody>
          <a:bodyPr wrap="square" rtlCol="1">
            <a:spAutoFit/>
          </a:bodyPr>
          <a:lstStyle/>
          <a:p>
            <a:pPr algn="just" rtl="0">
              <a:lnSpc>
                <a:spcPct val="150000"/>
              </a:lnSpc>
            </a:pPr>
            <a:r>
              <a:rPr lang="en-US" sz="1200" b="1" dirty="0" smtClean="0"/>
              <a:t>b. </a:t>
            </a:r>
            <a:r>
              <a:rPr lang="en-US" sz="1200" dirty="0" smtClean="0"/>
              <a:t>Heat stress </a:t>
            </a:r>
            <a:r>
              <a:rPr lang="en-US" sz="1200" dirty="0"/>
              <a:t>during  </a:t>
            </a:r>
            <a:r>
              <a:rPr lang="en-US" sz="1200" dirty="0" smtClean="0"/>
              <a:t>growing the 2012 BC</a:t>
            </a:r>
            <a:r>
              <a:rPr lang="en-US" sz="1200" baseline="-25000" dirty="0" smtClean="0"/>
              <a:t>1</a:t>
            </a:r>
            <a:r>
              <a:rPr lang="en-US" sz="1200" dirty="0" smtClean="0"/>
              <a:t>F</a:t>
            </a:r>
            <a:r>
              <a:rPr lang="en-US" sz="1200" baseline="-25000" dirty="0" smtClean="0"/>
              <a:t>2</a:t>
            </a:r>
            <a:r>
              <a:rPr lang="en-US" sz="1200" dirty="0" smtClean="0"/>
              <a:t> population for examining the segregation of the parthenocarpic trait under </a:t>
            </a:r>
            <a:r>
              <a:rPr lang="en-US" sz="1200" dirty="0" smtClean="0"/>
              <a:t>heat </a:t>
            </a:r>
            <a:r>
              <a:rPr lang="en-US" sz="1200" dirty="0" smtClean="0"/>
              <a:t>imposed </a:t>
            </a:r>
            <a:r>
              <a:rPr lang="en-US" sz="1200" dirty="0" smtClean="0"/>
              <a:t>fertilization-restrictive </a:t>
            </a:r>
            <a:r>
              <a:rPr lang="en-US" sz="1200" dirty="0" smtClean="0"/>
              <a:t>conditions. Seedlings were planted in a net house on 20.6.2010  and screened until 30.8.2010. </a:t>
            </a:r>
            <a:endParaRPr lang="he-IL" sz="1200" dirty="0"/>
          </a:p>
        </p:txBody>
      </p:sp>
      <p:graphicFrame>
        <p:nvGraphicFramePr>
          <p:cNvPr id="7" name="Chart 6"/>
          <p:cNvGraphicFramePr>
            <a:graphicFrameLocks/>
          </p:cNvGraphicFramePr>
          <p:nvPr>
            <p:extLst>
              <p:ext uri="{D42A27DB-BD31-4B8C-83A1-F6EECF244321}">
                <p14:modId xmlns:p14="http://schemas.microsoft.com/office/powerpoint/2010/main" val="3671869094"/>
              </p:ext>
            </p:extLst>
          </p:nvPr>
        </p:nvGraphicFramePr>
        <p:xfrm>
          <a:off x="-315416" y="5580112"/>
          <a:ext cx="6696744" cy="2245058"/>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a:off x="621332" y="1972890"/>
            <a:ext cx="75341" cy="184666"/>
          </a:xfrm>
          <a:prstGeom prst="rect">
            <a:avLst/>
          </a:prstGeom>
          <a:noFill/>
        </p:spPr>
        <p:txBody>
          <a:bodyPr wrap="none" lIns="0" tIns="0" rIns="0" bIns="0" rtlCol="1" anchor="ctr" anchorCtr="0">
            <a:spAutoFit/>
          </a:bodyPr>
          <a:lstStyle/>
          <a:p>
            <a:pPr algn="l" rtl="0"/>
            <a:r>
              <a:rPr lang="en-US" sz="1200" b="1" dirty="0" smtClean="0"/>
              <a:t>a</a:t>
            </a:r>
            <a:endParaRPr lang="he-IL" sz="1200" b="1" dirty="0"/>
          </a:p>
        </p:txBody>
      </p:sp>
      <p:sp>
        <p:nvSpPr>
          <p:cNvPr id="9" name="TextBox 8"/>
          <p:cNvSpPr txBox="1"/>
          <p:nvPr/>
        </p:nvSpPr>
        <p:spPr>
          <a:xfrm>
            <a:off x="617324" y="5654222"/>
            <a:ext cx="83356" cy="184666"/>
          </a:xfrm>
          <a:prstGeom prst="rect">
            <a:avLst/>
          </a:prstGeom>
          <a:noFill/>
        </p:spPr>
        <p:txBody>
          <a:bodyPr wrap="none" lIns="0" tIns="0" rIns="0" bIns="0" rtlCol="1" anchor="ctr" anchorCtr="0">
            <a:spAutoFit/>
          </a:bodyPr>
          <a:lstStyle/>
          <a:p>
            <a:pPr algn="l" rtl="0"/>
            <a:r>
              <a:rPr lang="en-US" sz="1200" b="1" dirty="0" smtClean="0"/>
              <a:t>b</a:t>
            </a:r>
            <a:endParaRPr lang="he-IL" sz="1200" b="1" dirty="0"/>
          </a:p>
        </p:txBody>
      </p:sp>
      <p:graphicFrame>
        <p:nvGraphicFramePr>
          <p:cNvPr id="11" name="Chart 10"/>
          <p:cNvGraphicFramePr>
            <a:graphicFrameLocks/>
          </p:cNvGraphicFramePr>
          <p:nvPr>
            <p:extLst>
              <p:ext uri="{D42A27DB-BD31-4B8C-83A1-F6EECF244321}">
                <p14:modId xmlns:p14="http://schemas.microsoft.com/office/powerpoint/2010/main" val="3661296878"/>
              </p:ext>
            </p:extLst>
          </p:nvPr>
        </p:nvGraphicFramePr>
        <p:xfrm>
          <a:off x="-307333" y="1897541"/>
          <a:ext cx="6840760" cy="2652142"/>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182475423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3085756951"/>
              </p:ext>
            </p:extLst>
          </p:nvPr>
        </p:nvGraphicFramePr>
        <p:xfrm>
          <a:off x="0" y="1030706"/>
          <a:ext cx="6597352" cy="2520280"/>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p:nvPr/>
        </p:nvSpPr>
        <p:spPr>
          <a:xfrm>
            <a:off x="537614" y="3502819"/>
            <a:ext cx="5904656" cy="923330"/>
          </a:xfrm>
          <a:prstGeom prst="rect">
            <a:avLst/>
          </a:prstGeom>
          <a:noFill/>
        </p:spPr>
        <p:txBody>
          <a:bodyPr wrap="square" rtlCol="1">
            <a:spAutoFit/>
          </a:bodyPr>
          <a:lstStyle/>
          <a:p>
            <a:pPr algn="l" rtl="0">
              <a:lnSpc>
                <a:spcPct val="150000"/>
              </a:lnSpc>
            </a:pPr>
            <a:r>
              <a:rPr lang="en-US" sz="1200" b="1" dirty="0" smtClean="0"/>
              <a:t>c</a:t>
            </a:r>
            <a:r>
              <a:rPr lang="en-US" sz="1200" dirty="0" smtClean="0"/>
              <a:t>. Cold stress conditions  when testing the 2012 BC</a:t>
            </a:r>
            <a:r>
              <a:rPr lang="en-US" sz="1200" baseline="-25000" dirty="0" smtClean="0"/>
              <a:t>1</a:t>
            </a:r>
            <a:r>
              <a:rPr lang="en-US" sz="1200" dirty="0" smtClean="0"/>
              <a:t>F</a:t>
            </a:r>
            <a:r>
              <a:rPr lang="en-US" sz="1200" baseline="-25000" dirty="0" smtClean="0"/>
              <a:t>2</a:t>
            </a:r>
            <a:r>
              <a:rPr lang="en-US" sz="1200" dirty="0" smtClean="0"/>
              <a:t> population for parthenocarpic manifestation under low temperatures. Seedling were transferred </a:t>
            </a:r>
            <a:r>
              <a:rPr lang="en-US" sz="1200" dirty="0"/>
              <a:t>on </a:t>
            </a:r>
            <a:r>
              <a:rPr lang="en-US" sz="1200" dirty="0" smtClean="0"/>
              <a:t>15.12.2010  to a non-heated glass house, which side windows were kept open, and </a:t>
            </a:r>
            <a:r>
              <a:rPr lang="en-US" sz="1200" dirty="0"/>
              <a:t>screened until </a:t>
            </a:r>
            <a:r>
              <a:rPr lang="en-US" sz="1200" dirty="0" smtClean="0"/>
              <a:t>28.2.2011</a:t>
            </a:r>
            <a:endParaRPr lang="he-IL" sz="1200" dirty="0"/>
          </a:p>
        </p:txBody>
      </p:sp>
      <p:sp>
        <p:nvSpPr>
          <p:cNvPr id="5" name="TextBox 4"/>
          <p:cNvSpPr txBox="1"/>
          <p:nvPr/>
        </p:nvSpPr>
        <p:spPr>
          <a:xfrm>
            <a:off x="780911" y="1116104"/>
            <a:ext cx="64120" cy="184666"/>
          </a:xfrm>
          <a:prstGeom prst="rect">
            <a:avLst/>
          </a:prstGeom>
          <a:noFill/>
        </p:spPr>
        <p:txBody>
          <a:bodyPr wrap="none" lIns="0" tIns="0" rIns="0" bIns="0" rtlCol="1" anchor="ctr" anchorCtr="0">
            <a:spAutoFit/>
          </a:bodyPr>
          <a:lstStyle/>
          <a:p>
            <a:pPr algn="l" rtl="0"/>
            <a:r>
              <a:rPr lang="en-US" sz="1200" b="1" dirty="0" smtClean="0"/>
              <a:t>c</a:t>
            </a:r>
            <a:endParaRPr lang="he-IL" sz="1200" b="1" dirty="0"/>
          </a:p>
        </p:txBody>
      </p:sp>
      <p:graphicFrame>
        <p:nvGraphicFramePr>
          <p:cNvPr id="6" name="Chart 5"/>
          <p:cNvGraphicFramePr>
            <a:graphicFrameLocks/>
          </p:cNvGraphicFramePr>
          <p:nvPr>
            <p:extLst>
              <p:ext uri="{D42A27DB-BD31-4B8C-83A1-F6EECF244321}">
                <p14:modId xmlns:p14="http://schemas.microsoft.com/office/powerpoint/2010/main" val="2777879318"/>
              </p:ext>
            </p:extLst>
          </p:nvPr>
        </p:nvGraphicFramePr>
        <p:xfrm>
          <a:off x="-348743" y="4771811"/>
          <a:ext cx="6744703" cy="2592288"/>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6"/>
          <p:cNvSpPr txBox="1"/>
          <p:nvPr/>
        </p:nvSpPr>
        <p:spPr>
          <a:xfrm>
            <a:off x="537614" y="7148075"/>
            <a:ext cx="6048672" cy="1200329"/>
          </a:xfrm>
          <a:prstGeom prst="rect">
            <a:avLst/>
          </a:prstGeom>
          <a:noFill/>
        </p:spPr>
        <p:txBody>
          <a:bodyPr wrap="square" rtlCol="1">
            <a:spAutoFit/>
          </a:bodyPr>
          <a:lstStyle/>
          <a:p>
            <a:pPr algn="l" rtl="0">
              <a:lnSpc>
                <a:spcPct val="150000"/>
              </a:lnSpc>
            </a:pPr>
            <a:r>
              <a:rPr lang="en-US" sz="1200" b="1" dirty="0" smtClean="0"/>
              <a:t>d</a:t>
            </a:r>
            <a:r>
              <a:rPr lang="en-US" sz="1200" dirty="0" smtClean="0"/>
              <a:t>. Heat stress during  the growth season of the 2012 BC</a:t>
            </a:r>
            <a:r>
              <a:rPr lang="en-US" sz="1200" baseline="-25000" dirty="0" smtClean="0"/>
              <a:t>1</a:t>
            </a:r>
            <a:r>
              <a:rPr lang="en-US" sz="1200" dirty="0" smtClean="0"/>
              <a:t>F</a:t>
            </a:r>
            <a:r>
              <a:rPr lang="en-US" sz="1200" baseline="-25000" dirty="0" smtClean="0"/>
              <a:t>2</a:t>
            </a:r>
            <a:r>
              <a:rPr lang="en-US" sz="1200" dirty="0" smtClean="0"/>
              <a:t> mapping population (Table 1). Seedlings were  planted in the net house on the 21-23.6.2011 and screened for fruit set until 27.9.2011. Notice the chronic high night temperatures experienced, besides the daytime mild chronic heat stress.</a:t>
            </a:r>
            <a:endParaRPr lang="he-IL" sz="1200" dirty="0"/>
          </a:p>
        </p:txBody>
      </p:sp>
      <p:sp>
        <p:nvSpPr>
          <p:cNvPr id="8" name="TextBox 7"/>
          <p:cNvSpPr txBox="1"/>
          <p:nvPr/>
        </p:nvSpPr>
        <p:spPr>
          <a:xfrm>
            <a:off x="711918" y="4843819"/>
            <a:ext cx="83356" cy="184666"/>
          </a:xfrm>
          <a:prstGeom prst="rect">
            <a:avLst/>
          </a:prstGeom>
          <a:noFill/>
        </p:spPr>
        <p:txBody>
          <a:bodyPr wrap="none" lIns="0" tIns="0" rIns="0" bIns="0" rtlCol="1" anchor="ctr" anchorCtr="0">
            <a:spAutoFit/>
          </a:bodyPr>
          <a:lstStyle/>
          <a:p>
            <a:pPr algn="l" rtl="0"/>
            <a:r>
              <a:rPr lang="en-US" sz="1200" b="1" dirty="0" smtClean="0"/>
              <a:t>d</a:t>
            </a:r>
            <a:endParaRPr lang="he-IL" sz="1200" b="1" dirty="0"/>
          </a:p>
        </p:txBody>
      </p:sp>
    </p:spTree>
    <p:extLst>
      <p:ext uri="{BB962C8B-B14F-4D97-AF65-F5344CB8AC3E}">
        <p14:creationId xmlns:p14="http://schemas.microsoft.com/office/powerpoint/2010/main" val="217189682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1254034455"/>
              </p:ext>
            </p:extLst>
          </p:nvPr>
        </p:nvGraphicFramePr>
        <p:xfrm>
          <a:off x="-243408" y="891858"/>
          <a:ext cx="6470635" cy="2376264"/>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a:off x="537614" y="3264310"/>
            <a:ext cx="6048672" cy="923330"/>
          </a:xfrm>
          <a:prstGeom prst="rect">
            <a:avLst/>
          </a:prstGeom>
          <a:noFill/>
        </p:spPr>
        <p:txBody>
          <a:bodyPr wrap="square" rtlCol="1">
            <a:spAutoFit/>
          </a:bodyPr>
          <a:lstStyle/>
          <a:p>
            <a:pPr algn="l" rtl="0">
              <a:lnSpc>
                <a:spcPct val="150000"/>
              </a:lnSpc>
            </a:pPr>
            <a:r>
              <a:rPr lang="en-US" sz="1200" b="1" dirty="0" smtClean="0"/>
              <a:t>e. </a:t>
            </a:r>
            <a:r>
              <a:rPr lang="en-US" sz="1200" dirty="0" smtClean="0"/>
              <a:t>Heat stress during  the growth season of the Test Cross population for marker assisted mapping of the 2012 mutation (Table 2a). Seedlings were planted in the net house   on 15.6.2013 and screened 30.8-2.9.2013. </a:t>
            </a:r>
            <a:endParaRPr lang="he-IL" sz="1200" dirty="0"/>
          </a:p>
        </p:txBody>
      </p:sp>
      <p:sp>
        <p:nvSpPr>
          <p:cNvPr id="7" name="TextBox 6"/>
          <p:cNvSpPr txBox="1"/>
          <p:nvPr/>
        </p:nvSpPr>
        <p:spPr>
          <a:xfrm>
            <a:off x="632750" y="942924"/>
            <a:ext cx="76944" cy="184666"/>
          </a:xfrm>
          <a:prstGeom prst="rect">
            <a:avLst/>
          </a:prstGeom>
          <a:noFill/>
        </p:spPr>
        <p:txBody>
          <a:bodyPr wrap="none" lIns="0" tIns="0" rIns="0" bIns="0" rtlCol="1" anchor="ctr" anchorCtr="0">
            <a:spAutoFit/>
          </a:bodyPr>
          <a:lstStyle/>
          <a:p>
            <a:pPr algn="l" rtl="0"/>
            <a:r>
              <a:rPr lang="en-US" sz="1200" b="1" dirty="0" smtClean="0"/>
              <a:t>e</a:t>
            </a:r>
            <a:endParaRPr lang="he-IL" sz="1200" b="1" dirty="0"/>
          </a:p>
        </p:txBody>
      </p:sp>
      <p:sp>
        <p:nvSpPr>
          <p:cNvPr id="8" name="TextBox 7"/>
          <p:cNvSpPr txBox="1"/>
          <p:nvPr/>
        </p:nvSpPr>
        <p:spPr>
          <a:xfrm>
            <a:off x="593857" y="7227692"/>
            <a:ext cx="5715464" cy="923330"/>
          </a:xfrm>
          <a:prstGeom prst="rect">
            <a:avLst/>
          </a:prstGeom>
          <a:noFill/>
        </p:spPr>
        <p:txBody>
          <a:bodyPr wrap="square" rtlCol="1">
            <a:spAutoFit/>
          </a:bodyPr>
          <a:lstStyle/>
          <a:p>
            <a:pPr algn="just" rtl="0">
              <a:lnSpc>
                <a:spcPct val="150000"/>
              </a:lnSpc>
            </a:pPr>
            <a:r>
              <a:rPr lang="en-US" sz="1200" b="1" dirty="0" smtClean="0"/>
              <a:t>f</a:t>
            </a:r>
            <a:r>
              <a:rPr lang="en-US" sz="1200" dirty="0" smtClean="0"/>
              <a:t>. Near ambient temperatures during the growth season of the 2012 BC</a:t>
            </a:r>
            <a:r>
              <a:rPr lang="en-US" sz="1200" baseline="-25000" dirty="0" smtClean="0"/>
              <a:t>2</a:t>
            </a:r>
            <a:r>
              <a:rPr lang="en-US" sz="1200" dirty="0" smtClean="0"/>
              <a:t>F</a:t>
            </a:r>
            <a:r>
              <a:rPr lang="en-US" sz="1200" baseline="-25000" dirty="0" smtClean="0"/>
              <a:t>2</a:t>
            </a:r>
            <a:r>
              <a:rPr lang="en-US" sz="1200" dirty="0" smtClean="0"/>
              <a:t> population for marker assisted mapping (Table 2b) and yield parameters analysis (Figure  4). Seedlings were planted in the net house  24.2.2014 and analyzed for yielding  on 10-11.6.2014. </a:t>
            </a:r>
            <a:endParaRPr lang="he-IL" sz="1200" dirty="0"/>
          </a:p>
        </p:txBody>
      </p:sp>
      <p:graphicFrame>
        <p:nvGraphicFramePr>
          <p:cNvPr id="9" name="Chart 8"/>
          <p:cNvGraphicFramePr>
            <a:graphicFrameLocks/>
          </p:cNvGraphicFramePr>
          <p:nvPr>
            <p:extLst>
              <p:ext uri="{D42A27DB-BD31-4B8C-83A1-F6EECF244321}">
                <p14:modId xmlns:p14="http://schemas.microsoft.com/office/powerpoint/2010/main" val="4048340700"/>
              </p:ext>
            </p:extLst>
          </p:nvPr>
        </p:nvGraphicFramePr>
        <p:xfrm>
          <a:off x="-373824" y="4684318"/>
          <a:ext cx="6788666" cy="2570068"/>
        </p:xfrm>
        <a:graphic>
          <a:graphicData uri="http://schemas.openxmlformats.org/drawingml/2006/chart">
            <c:chart xmlns:c="http://schemas.openxmlformats.org/drawingml/2006/chart" xmlns:r="http://schemas.openxmlformats.org/officeDocument/2006/relationships" r:id="rId3"/>
          </a:graphicData>
        </a:graphic>
      </p:graphicFrame>
      <p:sp>
        <p:nvSpPr>
          <p:cNvPr id="10" name="TextBox 9"/>
          <p:cNvSpPr txBox="1"/>
          <p:nvPr/>
        </p:nvSpPr>
        <p:spPr>
          <a:xfrm>
            <a:off x="583555" y="4732122"/>
            <a:ext cx="48090" cy="184666"/>
          </a:xfrm>
          <a:prstGeom prst="rect">
            <a:avLst/>
          </a:prstGeom>
          <a:noFill/>
        </p:spPr>
        <p:txBody>
          <a:bodyPr wrap="none" lIns="0" tIns="0" rIns="0" bIns="0" rtlCol="1" anchor="ctr" anchorCtr="0">
            <a:spAutoFit/>
          </a:bodyPr>
          <a:lstStyle/>
          <a:p>
            <a:pPr algn="l" rtl="0"/>
            <a:r>
              <a:rPr lang="en-US" sz="1200" b="1" dirty="0" smtClean="0"/>
              <a:t>f</a:t>
            </a:r>
            <a:endParaRPr lang="he-IL" sz="1200" b="1" dirty="0"/>
          </a:p>
        </p:txBody>
      </p:sp>
    </p:spTree>
    <p:extLst>
      <p:ext uri="{BB962C8B-B14F-4D97-AF65-F5344CB8AC3E}">
        <p14:creationId xmlns:p14="http://schemas.microsoft.com/office/powerpoint/2010/main" val="190090679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p:cNvGraphicFramePr>
          <p:nvPr>
            <p:extLst>
              <p:ext uri="{D42A27DB-BD31-4B8C-83A1-F6EECF244321}">
                <p14:modId xmlns:p14="http://schemas.microsoft.com/office/powerpoint/2010/main" val="2605822288"/>
              </p:ext>
            </p:extLst>
          </p:nvPr>
        </p:nvGraphicFramePr>
        <p:xfrm>
          <a:off x="-376912" y="753666"/>
          <a:ext cx="6936164" cy="2825389"/>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p:nvPr/>
        </p:nvSpPr>
        <p:spPr>
          <a:xfrm>
            <a:off x="593857" y="3417784"/>
            <a:ext cx="6003495" cy="1200329"/>
          </a:xfrm>
          <a:prstGeom prst="rect">
            <a:avLst/>
          </a:prstGeom>
          <a:noFill/>
        </p:spPr>
        <p:txBody>
          <a:bodyPr wrap="square" rtlCol="1">
            <a:spAutoFit/>
          </a:bodyPr>
          <a:lstStyle/>
          <a:p>
            <a:pPr algn="l" rtl="0">
              <a:lnSpc>
                <a:spcPct val="150000"/>
              </a:lnSpc>
            </a:pPr>
            <a:r>
              <a:rPr lang="en-US" sz="1200" b="1" dirty="0" smtClean="0"/>
              <a:t>g</a:t>
            </a:r>
            <a:r>
              <a:rPr lang="en-US" sz="1200" dirty="0" smtClean="0"/>
              <a:t>. Cold stress conditions  during the winter 2014-2015 when testing for parthenocarpic fruit set of several suspected 2012 BC</a:t>
            </a:r>
            <a:r>
              <a:rPr lang="en-US" sz="1200" baseline="-25000" dirty="0" smtClean="0"/>
              <a:t>2</a:t>
            </a:r>
            <a:r>
              <a:rPr lang="en-US" sz="1200" dirty="0" smtClean="0"/>
              <a:t>F</a:t>
            </a:r>
            <a:r>
              <a:rPr lang="en-US" sz="1200" baseline="-25000" dirty="0" smtClean="0"/>
              <a:t>3</a:t>
            </a:r>
            <a:r>
              <a:rPr lang="en-US" sz="1200" dirty="0" smtClean="0"/>
              <a:t> families . Seedlings  were  planted in  the net house on 24.10.2014 and monitored for fruit set until 18.4.2015. Notice the </a:t>
            </a:r>
            <a:r>
              <a:rPr lang="en-US" sz="1200" dirty="0" smtClean="0"/>
              <a:t>several sequences </a:t>
            </a:r>
            <a:r>
              <a:rPr lang="en-US" sz="1200" dirty="0" smtClean="0"/>
              <a:t>of low night temperatures </a:t>
            </a:r>
            <a:r>
              <a:rPr lang="en-US" sz="1200" dirty="0" smtClean="0"/>
              <a:t>(&lt; </a:t>
            </a:r>
            <a:r>
              <a:rPr lang="en-US" sz="1200" dirty="0" smtClean="0"/>
              <a:t>10</a:t>
            </a:r>
            <a:r>
              <a:rPr lang="en-US" sz="1200" baseline="30000" dirty="0" smtClean="0"/>
              <a:t>o</a:t>
            </a:r>
            <a:r>
              <a:rPr lang="en-US" sz="1200" dirty="0" smtClean="0"/>
              <a:t>C) between 24.12.2014-6.3.2015</a:t>
            </a:r>
            <a:endParaRPr lang="he-IL" sz="1200" dirty="0"/>
          </a:p>
        </p:txBody>
      </p:sp>
      <p:sp>
        <p:nvSpPr>
          <p:cNvPr id="4" name="TextBox 3"/>
          <p:cNvSpPr txBox="1"/>
          <p:nvPr/>
        </p:nvSpPr>
        <p:spPr>
          <a:xfrm>
            <a:off x="593857" y="7308303"/>
            <a:ext cx="5715464" cy="1200329"/>
          </a:xfrm>
          <a:prstGeom prst="rect">
            <a:avLst/>
          </a:prstGeom>
          <a:noFill/>
        </p:spPr>
        <p:txBody>
          <a:bodyPr wrap="square" rtlCol="1">
            <a:spAutoFit/>
          </a:bodyPr>
          <a:lstStyle/>
          <a:p>
            <a:pPr algn="l" rtl="0">
              <a:lnSpc>
                <a:spcPct val="150000"/>
              </a:lnSpc>
            </a:pPr>
            <a:r>
              <a:rPr lang="en-US" sz="1200" b="1" dirty="0" smtClean="0"/>
              <a:t>h</a:t>
            </a:r>
            <a:r>
              <a:rPr lang="en-US" sz="1200" dirty="0" smtClean="0"/>
              <a:t>. Heat stress conditions during  the  summer of 2016, when comparing the yield of MP-1 and the Sl</a:t>
            </a:r>
            <a:r>
              <a:rPr lang="en-US" sz="1200" i="1" dirty="0" smtClean="0"/>
              <a:t>agl6</a:t>
            </a:r>
            <a:r>
              <a:rPr lang="en-US" sz="1200" dirty="0" smtClean="0"/>
              <a:t> line sg1.  Seedlings were planted in the net house  20.4.2016, and first harvested  </a:t>
            </a:r>
            <a:r>
              <a:rPr lang="en-US" sz="1200" dirty="0"/>
              <a:t>26.6.2016 (Figure  5). </a:t>
            </a:r>
            <a:r>
              <a:rPr lang="en-US" sz="1200" dirty="0" smtClean="0"/>
              <a:t>Notice the exceptionally high day and night temperatures between 14-16.5.2016.</a:t>
            </a:r>
            <a:endParaRPr lang="he-IL" sz="1200" dirty="0"/>
          </a:p>
        </p:txBody>
      </p:sp>
      <p:graphicFrame>
        <p:nvGraphicFramePr>
          <p:cNvPr id="5" name="Chart 4"/>
          <p:cNvGraphicFramePr>
            <a:graphicFrameLocks/>
          </p:cNvGraphicFramePr>
          <p:nvPr>
            <p:extLst>
              <p:ext uri="{D42A27DB-BD31-4B8C-83A1-F6EECF244321}">
                <p14:modId xmlns:p14="http://schemas.microsoft.com/office/powerpoint/2010/main" val="822667567"/>
              </p:ext>
            </p:extLst>
          </p:nvPr>
        </p:nvGraphicFramePr>
        <p:xfrm>
          <a:off x="-315416" y="4724559"/>
          <a:ext cx="6820689" cy="2795919"/>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p:cNvSpPr txBox="1"/>
          <p:nvPr/>
        </p:nvSpPr>
        <p:spPr>
          <a:xfrm>
            <a:off x="603856" y="752113"/>
            <a:ext cx="73738" cy="184666"/>
          </a:xfrm>
          <a:prstGeom prst="rect">
            <a:avLst/>
          </a:prstGeom>
          <a:noFill/>
        </p:spPr>
        <p:txBody>
          <a:bodyPr wrap="none" lIns="0" tIns="0" rIns="0" bIns="0" rtlCol="1" anchor="ctr" anchorCtr="0">
            <a:spAutoFit/>
          </a:bodyPr>
          <a:lstStyle/>
          <a:p>
            <a:pPr algn="l" rtl="0"/>
            <a:r>
              <a:rPr lang="en-US" sz="1200" b="1" dirty="0" smtClean="0"/>
              <a:t>g</a:t>
            </a:r>
            <a:endParaRPr lang="he-IL" sz="1200" b="1" dirty="0"/>
          </a:p>
        </p:txBody>
      </p:sp>
      <p:sp>
        <p:nvSpPr>
          <p:cNvPr id="7" name="TextBox 6"/>
          <p:cNvSpPr txBox="1"/>
          <p:nvPr/>
        </p:nvSpPr>
        <p:spPr>
          <a:xfrm>
            <a:off x="599047" y="4773449"/>
            <a:ext cx="83356" cy="184666"/>
          </a:xfrm>
          <a:prstGeom prst="rect">
            <a:avLst/>
          </a:prstGeom>
          <a:noFill/>
        </p:spPr>
        <p:txBody>
          <a:bodyPr wrap="none" lIns="0" tIns="0" rIns="0" bIns="0" rtlCol="1" anchor="ctr" anchorCtr="0">
            <a:spAutoFit/>
          </a:bodyPr>
          <a:lstStyle/>
          <a:p>
            <a:pPr algn="l" rtl="0"/>
            <a:r>
              <a:rPr lang="en-US" sz="1200" b="1" dirty="0" smtClean="0"/>
              <a:t>h</a:t>
            </a:r>
            <a:endParaRPr lang="he-IL" sz="1200" b="1" dirty="0"/>
          </a:p>
        </p:txBody>
      </p:sp>
    </p:spTree>
    <p:extLst>
      <p:ext uri="{BB962C8B-B14F-4D97-AF65-F5344CB8AC3E}">
        <p14:creationId xmlns:p14="http://schemas.microsoft.com/office/powerpoint/2010/main" val="75800564"/>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19</TotalTime>
  <Words>471</Words>
  <Application>Microsoft Office PowerPoint</Application>
  <PresentationFormat>On-screen Show (4:3)</PresentationFormat>
  <Paragraphs>33</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ivka Barg</dc:creator>
  <cp:lastModifiedBy>Rivka Barg</cp:lastModifiedBy>
  <cp:revision>46</cp:revision>
  <dcterms:created xsi:type="dcterms:W3CDTF">2016-10-10T19:43:54Z</dcterms:created>
  <dcterms:modified xsi:type="dcterms:W3CDTF">2016-10-17T11:33:38Z</dcterms:modified>
</cp:coreProperties>
</file>